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67" r:id="rId2"/>
    <p:sldId id="268" r:id="rId3"/>
    <p:sldId id="270" r:id="rId4"/>
    <p:sldId id="271" r:id="rId5"/>
    <p:sldId id="276" r:id="rId6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8411" autoAdjust="0"/>
  </p:normalViewPr>
  <p:slideViewPr>
    <p:cSldViewPr snapToGrid="0">
      <p:cViewPr varScale="1">
        <p:scale>
          <a:sx n="58" d="100"/>
          <a:sy n="58" d="100"/>
        </p:scale>
        <p:origin x="96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義章 谷口" userId="1aec43038f16d83c" providerId="LiveId" clId="{F9419B5B-E985-4A2F-8F99-BCFE6C0CAAB4}"/>
    <pc:docChg chg="undo custSel addSld delSld modSld">
      <pc:chgData name="義章 谷口" userId="1aec43038f16d83c" providerId="LiveId" clId="{F9419B5B-E985-4A2F-8F99-BCFE6C0CAAB4}" dt="2024-07-17T13:09:39.279" v="2058" actId="47"/>
      <pc:docMkLst>
        <pc:docMk/>
      </pc:docMkLst>
      <pc:sldChg chg="del">
        <pc:chgData name="義章 谷口" userId="1aec43038f16d83c" providerId="LiveId" clId="{F9419B5B-E985-4A2F-8F99-BCFE6C0CAAB4}" dt="2024-06-04T06:50:52.461" v="1301" actId="47"/>
        <pc:sldMkLst>
          <pc:docMk/>
          <pc:sldMk cId="2842446160" sldId="262"/>
        </pc:sldMkLst>
      </pc:sldChg>
      <pc:sldChg chg="del">
        <pc:chgData name="義章 谷口" userId="1aec43038f16d83c" providerId="LiveId" clId="{F9419B5B-E985-4A2F-8F99-BCFE6C0CAAB4}" dt="2024-06-12T05:05:07.118" v="1810" actId="47"/>
        <pc:sldMkLst>
          <pc:docMk/>
          <pc:sldMk cId="3232284875" sldId="263"/>
        </pc:sldMkLst>
      </pc:sldChg>
      <pc:sldChg chg="addSp delSp modSp del mod">
        <pc:chgData name="義章 谷口" userId="1aec43038f16d83c" providerId="LiveId" clId="{F9419B5B-E985-4A2F-8F99-BCFE6C0CAAB4}" dt="2024-06-03T09:03:16.667" v="289" actId="47"/>
        <pc:sldMkLst>
          <pc:docMk/>
          <pc:sldMk cId="1955827665" sldId="264"/>
        </pc:sldMkLst>
        <pc:picChg chg="add del mod modCrop">
          <ac:chgData name="義章 谷口" userId="1aec43038f16d83c" providerId="LiveId" clId="{F9419B5B-E985-4A2F-8F99-BCFE6C0CAAB4}" dt="2024-06-03T08:54:58.952" v="68" actId="21"/>
          <ac:picMkLst>
            <pc:docMk/>
            <pc:sldMk cId="1955827665" sldId="264"/>
            <ac:picMk id="3" creationId="{75973A64-A4BC-A614-6975-6BF24E9CAF9A}"/>
          </ac:picMkLst>
        </pc:picChg>
      </pc:sldChg>
      <pc:sldChg chg="del">
        <pc:chgData name="義章 谷口" userId="1aec43038f16d83c" providerId="LiveId" clId="{F9419B5B-E985-4A2F-8F99-BCFE6C0CAAB4}" dt="2024-06-03T09:17:38.510" v="762" actId="47"/>
        <pc:sldMkLst>
          <pc:docMk/>
          <pc:sldMk cId="1899141844" sldId="265"/>
        </pc:sldMkLst>
      </pc:sldChg>
      <pc:sldChg chg="addSp delSp modSp new del mod">
        <pc:chgData name="義章 谷口" userId="1aec43038f16d83c" providerId="LiveId" clId="{F9419B5B-E985-4A2F-8F99-BCFE6C0CAAB4}" dt="2024-06-12T05:05:07.497" v="1811" actId="47"/>
        <pc:sldMkLst>
          <pc:docMk/>
          <pc:sldMk cId="2554042717" sldId="266"/>
        </pc:sldMkLst>
        <pc:spChg chg="mod">
          <ac:chgData name="義章 谷口" userId="1aec43038f16d83c" providerId="LiveId" clId="{F9419B5B-E985-4A2F-8F99-BCFE6C0CAAB4}" dt="2024-06-03T04:34:10.442" v="54" actId="1076"/>
          <ac:spMkLst>
            <pc:docMk/>
            <pc:sldMk cId="2554042717" sldId="266"/>
            <ac:spMk id="2" creationId="{ED80E7CA-E65F-7BEF-E742-B95F201628FB}"/>
          </ac:spMkLst>
        </pc:spChg>
        <pc:spChg chg="del">
          <ac:chgData name="義章 谷口" userId="1aec43038f16d83c" providerId="LiveId" clId="{F9419B5B-E985-4A2F-8F99-BCFE6C0CAAB4}" dt="2024-06-03T04:33:32.293" v="1" actId="478"/>
          <ac:spMkLst>
            <pc:docMk/>
            <pc:sldMk cId="2554042717" sldId="266"/>
            <ac:spMk id="3" creationId="{FA4D9420-6D7C-8913-BF83-8C9AB2CF7E9C}"/>
          </ac:spMkLst>
        </pc:spChg>
        <pc:picChg chg="add del mod modCrop">
          <ac:chgData name="義章 谷口" userId="1aec43038f16d83c" providerId="LiveId" clId="{F9419B5B-E985-4A2F-8F99-BCFE6C0CAAB4}" dt="2024-06-04T06:47:17.416" v="1234" actId="478"/>
          <ac:picMkLst>
            <pc:docMk/>
            <pc:sldMk cId="2554042717" sldId="266"/>
            <ac:picMk id="3" creationId="{BF925E46-D0DF-80B9-7D0A-67D957069943}"/>
          </ac:picMkLst>
        </pc:picChg>
        <pc:picChg chg="add del mod modCrop">
          <ac:chgData name="義章 谷口" userId="1aec43038f16d83c" providerId="LiveId" clId="{F9419B5B-E985-4A2F-8F99-BCFE6C0CAAB4}" dt="2024-06-04T06:47:17.416" v="1234" actId="478"/>
          <ac:picMkLst>
            <pc:docMk/>
            <pc:sldMk cId="2554042717" sldId="266"/>
            <ac:picMk id="4" creationId="{0CBD6A2F-DBCC-6762-EA50-8D9F34994223}"/>
          </ac:picMkLst>
        </pc:picChg>
        <pc:picChg chg="add del mod">
          <ac:chgData name="義章 谷口" userId="1aec43038f16d83c" providerId="LiveId" clId="{F9419B5B-E985-4A2F-8F99-BCFE6C0CAAB4}" dt="2024-06-04T06:47:19.704" v="1235" actId="21"/>
          <ac:picMkLst>
            <pc:docMk/>
            <pc:sldMk cId="2554042717" sldId="266"/>
            <ac:picMk id="6" creationId="{AFD23225-4FD4-63B0-78DC-727347F9A2AE}"/>
          </ac:picMkLst>
        </pc:picChg>
        <pc:picChg chg="add del mod modCrop">
          <ac:chgData name="義章 谷口" userId="1aec43038f16d83c" providerId="LiveId" clId="{F9419B5B-E985-4A2F-8F99-BCFE6C0CAAB4}" dt="2024-06-04T06:48:54.872" v="1247" actId="21"/>
          <ac:picMkLst>
            <pc:docMk/>
            <pc:sldMk cId="2554042717" sldId="266"/>
            <ac:picMk id="7" creationId="{259C3F99-F88D-BC80-084A-671E882B7837}"/>
          </ac:picMkLst>
        </pc:picChg>
        <pc:picChg chg="add del mod">
          <ac:chgData name="義章 谷口" userId="1aec43038f16d83c" providerId="LiveId" clId="{F9419B5B-E985-4A2F-8F99-BCFE6C0CAAB4}" dt="2024-06-04T06:47:17.416" v="1234" actId="478"/>
          <ac:picMkLst>
            <pc:docMk/>
            <pc:sldMk cId="2554042717" sldId="266"/>
            <ac:picMk id="41" creationId="{957C96D4-BF9E-4EF9-639B-9C11FDB7E56D}"/>
          </ac:picMkLst>
        </pc:picChg>
      </pc:sldChg>
      <pc:sldChg chg="addSp delSp modSp new mod modNotesTx">
        <pc:chgData name="義章 谷口" userId="1aec43038f16d83c" providerId="LiveId" clId="{F9419B5B-E985-4A2F-8F99-BCFE6C0CAAB4}" dt="2024-07-17T13:02:59.661" v="1955" actId="1037"/>
        <pc:sldMkLst>
          <pc:docMk/>
          <pc:sldMk cId="1536307505" sldId="267"/>
        </pc:sldMkLst>
        <pc:spChg chg="del">
          <ac:chgData name="義章 谷口" userId="1aec43038f16d83c" providerId="LiveId" clId="{F9419B5B-E985-4A2F-8F99-BCFE6C0CAAB4}" dt="2024-06-03T08:54:56.076" v="67" actId="478"/>
          <ac:spMkLst>
            <pc:docMk/>
            <pc:sldMk cId="1536307505" sldId="267"/>
            <ac:spMk id="2" creationId="{705F8B46-8F45-AF9A-62EB-B70E32B97215}"/>
          </ac:spMkLst>
        </pc:spChg>
        <pc:spChg chg="add mod">
          <ac:chgData name="義章 谷口" userId="1aec43038f16d83c" providerId="LiveId" clId="{F9419B5B-E985-4A2F-8F99-BCFE6C0CAAB4}" dt="2024-07-17T13:02:53.631" v="1941" actId="1076"/>
          <ac:spMkLst>
            <pc:docMk/>
            <pc:sldMk cId="1536307505" sldId="267"/>
            <ac:spMk id="2" creationId="{BD5D6C10-B013-993B-F6DC-15D3AB55D936}"/>
          </ac:spMkLst>
        </pc:spChg>
        <pc:spChg chg="del">
          <ac:chgData name="義章 谷口" userId="1aec43038f16d83c" providerId="LiveId" clId="{F9419B5B-E985-4A2F-8F99-BCFE6C0CAAB4}" dt="2024-06-03T08:54:56.076" v="67" actId="478"/>
          <ac:spMkLst>
            <pc:docMk/>
            <pc:sldMk cId="1536307505" sldId="267"/>
            <ac:spMk id="3" creationId="{A429B295-F8D9-9FCA-3000-CA38B3EF1098}"/>
          </ac:spMkLst>
        </pc:spChg>
        <pc:spChg chg="add del mod">
          <ac:chgData name="義章 谷口" userId="1aec43038f16d83c" providerId="LiveId" clId="{F9419B5B-E985-4A2F-8F99-BCFE6C0CAAB4}" dt="2024-06-03T08:55:51.244" v="102" actId="478"/>
          <ac:spMkLst>
            <pc:docMk/>
            <pc:sldMk cId="1536307505" sldId="267"/>
            <ac:spMk id="5" creationId="{DD899D6B-870F-C0CE-DC0E-BEF7F5F639B9}"/>
          </ac:spMkLst>
        </pc:spChg>
        <pc:spChg chg="add mod">
          <ac:chgData name="義章 谷口" userId="1aec43038f16d83c" providerId="LiveId" clId="{F9419B5B-E985-4A2F-8F99-BCFE6C0CAAB4}" dt="2024-07-17T13:02:59.661" v="1955" actId="1037"/>
          <ac:spMkLst>
            <pc:docMk/>
            <pc:sldMk cId="1536307505" sldId="267"/>
            <ac:spMk id="6" creationId="{7176863B-AC9D-8C8B-F355-E85A4B8CF2AB}"/>
          </ac:spMkLst>
        </pc:spChg>
        <pc:spChg chg="add mod">
          <ac:chgData name="義章 谷口" userId="1aec43038f16d83c" providerId="LiveId" clId="{F9419B5B-E985-4A2F-8F99-BCFE6C0CAAB4}" dt="2024-07-17T13:02:59.661" v="1955" actId="1037"/>
          <ac:spMkLst>
            <pc:docMk/>
            <pc:sldMk cId="1536307505" sldId="267"/>
            <ac:spMk id="7" creationId="{73521C6C-792D-3F43-7E55-66833697CDDA}"/>
          </ac:spMkLst>
        </pc:spChg>
        <pc:spChg chg="add mod">
          <ac:chgData name="義章 谷口" userId="1aec43038f16d83c" providerId="LiveId" clId="{F9419B5B-E985-4A2F-8F99-BCFE6C0CAAB4}" dt="2024-07-17T13:02:59.661" v="1955" actId="1037"/>
          <ac:spMkLst>
            <pc:docMk/>
            <pc:sldMk cId="1536307505" sldId="267"/>
            <ac:spMk id="8" creationId="{1B213F52-94D3-08ED-CAFB-90259E733946}"/>
          </ac:spMkLst>
        </pc:spChg>
        <pc:spChg chg="add mod">
          <ac:chgData name="義章 谷口" userId="1aec43038f16d83c" providerId="LiveId" clId="{F9419B5B-E985-4A2F-8F99-BCFE6C0CAAB4}" dt="2024-07-17T13:02:59.661" v="1955" actId="1037"/>
          <ac:spMkLst>
            <pc:docMk/>
            <pc:sldMk cId="1536307505" sldId="267"/>
            <ac:spMk id="9" creationId="{D58950D6-D6BE-49A1-262D-95A066901B27}"/>
          </ac:spMkLst>
        </pc:spChg>
        <pc:spChg chg="add mod">
          <ac:chgData name="義章 谷口" userId="1aec43038f16d83c" providerId="LiveId" clId="{F9419B5B-E985-4A2F-8F99-BCFE6C0CAAB4}" dt="2024-07-17T13:02:59.661" v="1955" actId="1037"/>
          <ac:spMkLst>
            <pc:docMk/>
            <pc:sldMk cId="1536307505" sldId="267"/>
            <ac:spMk id="10" creationId="{8C6B6879-478D-4D90-E7EC-16DAC409FD1D}"/>
          </ac:spMkLst>
        </pc:spChg>
        <pc:spChg chg="add mod">
          <ac:chgData name="義章 谷口" userId="1aec43038f16d83c" providerId="LiveId" clId="{F9419B5B-E985-4A2F-8F99-BCFE6C0CAAB4}" dt="2024-07-17T13:02:59.661" v="1955" actId="1037"/>
          <ac:spMkLst>
            <pc:docMk/>
            <pc:sldMk cId="1536307505" sldId="267"/>
            <ac:spMk id="11" creationId="{7FE27219-2862-8AC8-576B-4972C01535F5}"/>
          </ac:spMkLst>
        </pc:spChg>
        <pc:spChg chg="add mod">
          <ac:chgData name="義章 谷口" userId="1aec43038f16d83c" providerId="LiveId" clId="{F9419B5B-E985-4A2F-8F99-BCFE6C0CAAB4}" dt="2024-07-17T13:02:59.661" v="1955" actId="1037"/>
          <ac:spMkLst>
            <pc:docMk/>
            <pc:sldMk cId="1536307505" sldId="267"/>
            <ac:spMk id="14" creationId="{4C4F0A78-20E1-E611-27AD-1C7B9D247398}"/>
          </ac:spMkLst>
        </pc:spChg>
        <pc:spChg chg="add mod">
          <ac:chgData name="義章 谷口" userId="1aec43038f16d83c" providerId="LiveId" clId="{F9419B5B-E985-4A2F-8F99-BCFE6C0CAAB4}" dt="2024-07-17T13:02:59.661" v="1955" actId="1037"/>
          <ac:spMkLst>
            <pc:docMk/>
            <pc:sldMk cId="1536307505" sldId="267"/>
            <ac:spMk id="15" creationId="{517EDCE7-DA4E-1E96-02AB-10D12283B6E0}"/>
          </ac:spMkLst>
        </pc:spChg>
        <pc:spChg chg="add mod">
          <ac:chgData name="義章 谷口" userId="1aec43038f16d83c" providerId="LiveId" clId="{F9419B5B-E985-4A2F-8F99-BCFE6C0CAAB4}" dt="2024-07-17T13:02:59.661" v="1955" actId="1037"/>
          <ac:spMkLst>
            <pc:docMk/>
            <pc:sldMk cId="1536307505" sldId="267"/>
            <ac:spMk id="16" creationId="{A8951612-A8DA-45C5-7574-544E3626C707}"/>
          </ac:spMkLst>
        </pc:spChg>
        <pc:spChg chg="add mod">
          <ac:chgData name="義章 谷口" userId="1aec43038f16d83c" providerId="LiveId" clId="{F9419B5B-E985-4A2F-8F99-BCFE6C0CAAB4}" dt="2024-07-17T13:02:59.661" v="1955" actId="1037"/>
          <ac:spMkLst>
            <pc:docMk/>
            <pc:sldMk cId="1536307505" sldId="267"/>
            <ac:spMk id="17" creationId="{0E87DBDF-D460-19AB-4008-2AFBF4CBC2B4}"/>
          </ac:spMkLst>
        </pc:spChg>
        <pc:spChg chg="add mod">
          <ac:chgData name="義章 谷口" userId="1aec43038f16d83c" providerId="LiveId" clId="{F9419B5B-E985-4A2F-8F99-BCFE6C0CAAB4}" dt="2024-07-17T13:02:59.661" v="1955" actId="1037"/>
          <ac:spMkLst>
            <pc:docMk/>
            <pc:sldMk cId="1536307505" sldId="267"/>
            <ac:spMk id="18" creationId="{9E15E36C-A6E9-00EC-5D66-867DFDD80B77}"/>
          </ac:spMkLst>
        </pc:spChg>
        <pc:spChg chg="add mod">
          <ac:chgData name="義章 谷口" userId="1aec43038f16d83c" providerId="LiveId" clId="{F9419B5B-E985-4A2F-8F99-BCFE6C0CAAB4}" dt="2024-06-03T09:17:05.182" v="710"/>
          <ac:spMkLst>
            <pc:docMk/>
            <pc:sldMk cId="1536307505" sldId="267"/>
            <ac:spMk id="20" creationId="{227171B0-29ED-783A-A7C4-D3E281F1D438}"/>
          </ac:spMkLst>
        </pc:spChg>
        <pc:spChg chg="add mod">
          <ac:chgData name="義章 谷口" userId="1aec43038f16d83c" providerId="LiveId" clId="{F9419B5B-E985-4A2F-8F99-BCFE6C0CAAB4}" dt="2024-07-17T13:02:59.661" v="1955" actId="1037"/>
          <ac:spMkLst>
            <pc:docMk/>
            <pc:sldMk cId="1536307505" sldId="267"/>
            <ac:spMk id="21" creationId="{DFB904F4-4901-56B2-BCD0-CD7F602C0823}"/>
          </ac:spMkLst>
        </pc:spChg>
        <pc:picChg chg="add mod">
          <ac:chgData name="義章 谷口" userId="1aec43038f16d83c" providerId="LiveId" clId="{F9419B5B-E985-4A2F-8F99-BCFE6C0CAAB4}" dt="2024-07-17T13:02:59.661" v="1955" actId="1037"/>
          <ac:picMkLst>
            <pc:docMk/>
            <pc:sldMk cId="1536307505" sldId="267"/>
            <ac:picMk id="4" creationId="{75973A64-A4BC-A614-6975-6BF24E9CAF9A}"/>
          </ac:picMkLst>
        </pc:picChg>
        <pc:picChg chg="add mod modCrop">
          <ac:chgData name="義章 谷口" userId="1aec43038f16d83c" providerId="LiveId" clId="{F9419B5B-E985-4A2F-8F99-BCFE6C0CAAB4}" dt="2024-07-17T13:02:59.661" v="1955" actId="1037"/>
          <ac:picMkLst>
            <pc:docMk/>
            <pc:sldMk cId="1536307505" sldId="267"/>
            <ac:picMk id="13" creationId="{8D822204-E180-80C4-3A0C-EA052EC2FE50}"/>
          </ac:picMkLst>
        </pc:picChg>
        <pc:picChg chg="add del mod">
          <ac:chgData name="義章 谷口" userId="1aec43038f16d83c" providerId="LiveId" clId="{F9419B5B-E985-4A2F-8F99-BCFE6C0CAAB4}" dt="2024-06-03T09:09:13.782" v="305" actId="21"/>
          <ac:picMkLst>
            <pc:docMk/>
            <pc:sldMk cId="1536307505" sldId="267"/>
            <ac:picMk id="19" creationId="{8068250C-05ED-F243-D0AA-EA2EE94A0ECE}"/>
          </ac:picMkLst>
        </pc:picChg>
      </pc:sldChg>
      <pc:sldChg chg="addSp delSp modSp add mod modNotesTx">
        <pc:chgData name="義章 谷口" userId="1aec43038f16d83c" providerId="LiveId" clId="{F9419B5B-E985-4A2F-8F99-BCFE6C0CAAB4}" dt="2024-07-17T13:03:34.853" v="1986" actId="1037"/>
        <pc:sldMkLst>
          <pc:docMk/>
          <pc:sldMk cId="3636881930" sldId="268"/>
        </pc:sldMkLst>
        <pc:spChg chg="add mod">
          <ac:chgData name="義章 谷口" userId="1aec43038f16d83c" providerId="LiveId" clId="{F9419B5B-E985-4A2F-8F99-BCFE6C0CAAB4}" dt="2024-07-17T13:03:14.896" v="1958" actId="20577"/>
          <ac:spMkLst>
            <pc:docMk/>
            <pc:sldMk cId="3636881930" sldId="268"/>
            <ac:spMk id="2" creationId="{2203063E-32AC-C1CA-52CD-B7B86DCD0F64}"/>
          </ac:spMkLst>
        </pc:spChg>
        <pc:spChg chg="add del mod">
          <ac:chgData name="義章 谷口" userId="1aec43038f16d83c" providerId="LiveId" clId="{F9419B5B-E985-4A2F-8F99-BCFE6C0CAAB4}" dt="2024-07-17T13:03:34.853" v="1986" actId="1037"/>
          <ac:spMkLst>
            <pc:docMk/>
            <pc:sldMk cId="3636881930" sldId="268"/>
            <ac:spMk id="5" creationId="{4407F1E2-D438-DE61-3686-154A0B2DC115}"/>
          </ac:spMkLst>
        </pc:spChg>
        <pc:spChg chg="add del mod">
          <ac:chgData name="義章 谷口" userId="1aec43038f16d83c" providerId="LiveId" clId="{F9419B5B-E985-4A2F-8F99-BCFE6C0CAAB4}" dt="2024-07-17T13:03:34.853" v="1986" actId="1037"/>
          <ac:spMkLst>
            <pc:docMk/>
            <pc:sldMk cId="3636881930" sldId="268"/>
            <ac:spMk id="6" creationId="{461E3E1E-BDA3-7AAE-2D37-5194017B2505}"/>
          </ac:spMkLst>
        </pc:spChg>
        <pc:spChg chg="add del mod">
          <ac:chgData name="義章 谷口" userId="1aec43038f16d83c" providerId="LiveId" clId="{F9419B5B-E985-4A2F-8F99-BCFE6C0CAAB4}" dt="2024-07-17T13:03:34.853" v="1986" actId="1037"/>
          <ac:spMkLst>
            <pc:docMk/>
            <pc:sldMk cId="3636881930" sldId="268"/>
            <ac:spMk id="7" creationId="{D97E9A28-B482-AEB2-92B7-D6774239B034}"/>
          </ac:spMkLst>
        </pc:spChg>
        <pc:spChg chg="del">
          <ac:chgData name="義章 谷口" userId="1aec43038f16d83c" providerId="LiveId" clId="{F9419B5B-E985-4A2F-8F99-BCFE6C0CAAB4}" dt="2024-06-03T09:07:47.816" v="291" actId="478"/>
          <ac:spMkLst>
            <pc:docMk/>
            <pc:sldMk cId="3636881930" sldId="268"/>
            <ac:spMk id="8" creationId="{A7345696-C1AC-C4A8-DF97-6880A83D2814}"/>
          </ac:spMkLst>
        </pc:spChg>
        <pc:spChg chg="add del mod">
          <ac:chgData name="義章 谷口" userId="1aec43038f16d83c" providerId="LiveId" clId="{F9419B5B-E985-4A2F-8F99-BCFE6C0CAAB4}" dt="2024-07-17T13:03:34.853" v="1986" actId="1037"/>
          <ac:spMkLst>
            <pc:docMk/>
            <pc:sldMk cId="3636881930" sldId="268"/>
            <ac:spMk id="10" creationId="{937706DF-EF0D-D8A5-6FDB-21F162142B6D}"/>
          </ac:spMkLst>
        </pc:spChg>
        <pc:spChg chg="add del mod">
          <ac:chgData name="義章 谷口" userId="1aec43038f16d83c" providerId="LiveId" clId="{F9419B5B-E985-4A2F-8F99-BCFE6C0CAAB4}" dt="2024-07-17T13:03:34.853" v="1986" actId="1037"/>
          <ac:spMkLst>
            <pc:docMk/>
            <pc:sldMk cId="3636881930" sldId="268"/>
            <ac:spMk id="11" creationId="{CAF5EBA7-B9B2-AE08-7D4D-AACA6FDCD616}"/>
          </ac:spMkLst>
        </pc:spChg>
        <pc:spChg chg="add del mod">
          <ac:chgData name="義章 谷口" userId="1aec43038f16d83c" providerId="LiveId" clId="{F9419B5B-E985-4A2F-8F99-BCFE6C0CAAB4}" dt="2024-07-17T13:03:34.853" v="1986" actId="1037"/>
          <ac:spMkLst>
            <pc:docMk/>
            <pc:sldMk cId="3636881930" sldId="268"/>
            <ac:spMk id="12" creationId="{3134F92C-4A3F-F93E-0599-2051EBA350EC}"/>
          </ac:spMkLst>
        </pc:spChg>
        <pc:spChg chg="del">
          <ac:chgData name="義章 谷口" userId="1aec43038f16d83c" providerId="LiveId" clId="{F9419B5B-E985-4A2F-8F99-BCFE6C0CAAB4}" dt="2024-06-03T09:07:47.816" v="291" actId="478"/>
          <ac:spMkLst>
            <pc:docMk/>
            <pc:sldMk cId="3636881930" sldId="268"/>
            <ac:spMk id="16" creationId="{E978E512-49B0-A3D1-E0C5-E1EB027AFC84}"/>
          </ac:spMkLst>
        </pc:spChg>
        <pc:spChg chg="add del mod">
          <ac:chgData name="義章 谷口" userId="1aec43038f16d83c" providerId="LiveId" clId="{F9419B5B-E985-4A2F-8F99-BCFE6C0CAAB4}" dt="2024-06-03T09:15:28.223" v="545" actId="478"/>
          <ac:spMkLst>
            <pc:docMk/>
            <pc:sldMk cId="3636881930" sldId="268"/>
            <ac:spMk id="18" creationId="{557CEDF6-1C68-FBA1-E9E0-C2BEDB39219C}"/>
          </ac:spMkLst>
        </pc:spChg>
        <pc:spChg chg="add mod">
          <ac:chgData name="義章 谷口" userId="1aec43038f16d83c" providerId="LiveId" clId="{F9419B5B-E985-4A2F-8F99-BCFE6C0CAAB4}" dt="2024-07-17T13:03:34.853" v="1986" actId="1037"/>
          <ac:spMkLst>
            <pc:docMk/>
            <pc:sldMk cId="3636881930" sldId="268"/>
            <ac:spMk id="20" creationId="{98045E09-6699-2804-DA2B-7A24431AA917}"/>
          </ac:spMkLst>
        </pc:spChg>
        <pc:spChg chg="add del mod">
          <ac:chgData name="義章 谷口" userId="1aec43038f16d83c" providerId="LiveId" clId="{F9419B5B-E985-4A2F-8F99-BCFE6C0CAAB4}" dt="2024-06-03T09:18:00.194" v="763" actId="478"/>
          <ac:spMkLst>
            <pc:docMk/>
            <pc:sldMk cId="3636881930" sldId="268"/>
            <ac:spMk id="21" creationId="{C63D8BCE-0728-AAFB-40E1-4CC2910855CB}"/>
          </ac:spMkLst>
        </pc:spChg>
        <pc:spChg chg="add mod">
          <ac:chgData name="義章 谷口" userId="1aec43038f16d83c" providerId="LiveId" clId="{F9419B5B-E985-4A2F-8F99-BCFE6C0CAAB4}" dt="2024-07-17T13:03:34.853" v="1986" actId="1037"/>
          <ac:spMkLst>
            <pc:docMk/>
            <pc:sldMk cId="3636881930" sldId="268"/>
            <ac:spMk id="22" creationId="{8EE5EFA4-2E68-9EBB-A55B-0ECF26FF3D1B}"/>
          </ac:spMkLst>
        </pc:spChg>
        <pc:spChg chg="add mod">
          <ac:chgData name="義章 谷口" userId="1aec43038f16d83c" providerId="LiveId" clId="{F9419B5B-E985-4A2F-8F99-BCFE6C0CAAB4}" dt="2024-07-17T13:03:34.853" v="1986" actId="1037"/>
          <ac:spMkLst>
            <pc:docMk/>
            <pc:sldMk cId="3636881930" sldId="268"/>
            <ac:spMk id="23" creationId="{6215D990-4FE5-407A-71D2-99AB29486582}"/>
          </ac:spMkLst>
        </pc:spChg>
        <pc:spChg chg="add mod">
          <ac:chgData name="義章 谷口" userId="1aec43038f16d83c" providerId="LiveId" clId="{F9419B5B-E985-4A2F-8F99-BCFE6C0CAAB4}" dt="2024-07-17T13:03:34.853" v="1986" actId="1037"/>
          <ac:spMkLst>
            <pc:docMk/>
            <pc:sldMk cId="3636881930" sldId="268"/>
            <ac:spMk id="24" creationId="{658D2D9A-63D4-B822-7C6F-A20E36D47FD6}"/>
          </ac:spMkLst>
        </pc:spChg>
        <pc:spChg chg="add mod">
          <ac:chgData name="義章 谷口" userId="1aec43038f16d83c" providerId="LiveId" clId="{F9419B5B-E985-4A2F-8F99-BCFE6C0CAAB4}" dt="2024-07-17T13:03:34.853" v="1986" actId="1037"/>
          <ac:spMkLst>
            <pc:docMk/>
            <pc:sldMk cId="3636881930" sldId="268"/>
            <ac:spMk id="25" creationId="{3E2AC77E-63BC-4253-A074-F19C4F58708C}"/>
          </ac:spMkLst>
        </pc:spChg>
        <pc:spChg chg="add mod">
          <ac:chgData name="義章 谷口" userId="1aec43038f16d83c" providerId="LiveId" clId="{F9419B5B-E985-4A2F-8F99-BCFE6C0CAAB4}" dt="2024-07-17T13:03:34.853" v="1986" actId="1037"/>
          <ac:spMkLst>
            <pc:docMk/>
            <pc:sldMk cId="3636881930" sldId="268"/>
            <ac:spMk id="26" creationId="{62FF3F85-6450-EC63-7717-4B565FBDA0DF}"/>
          </ac:spMkLst>
        </pc:spChg>
        <pc:picChg chg="add del mod modCrop">
          <ac:chgData name="義章 谷口" userId="1aec43038f16d83c" providerId="LiveId" clId="{F9419B5B-E985-4A2F-8F99-BCFE6C0CAAB4}" dt="2024-06-03T09:09:15.989" v="306" actId="478"/>
          <ac:picMkLst>
            <pc:docMk/>
            <pc:sldMk cId="3636881930" sldId="268"/>
            <ac:picMk id="3" creationId="{8BFF0556-879F-8AE7-DC17-B5826337E68E}"/>
          </ac:picMkLst>
        </pc:picChg>
        <pc:picChg chg="del">
          <ac:chgData name="義章 谷口" userId="1aec43038f16d83c" providerId="LiveId" clId="{F9419B5B-E985-4A2F-8F99-BCFE6C0CAAB4}" dt="2024-06-03T09:07:47.816" v="291" actId="478"/>
          <ac:picMkLst>
            <pc:docMk/>
            <pc:sldMk cId="3636881930" sldId="268"/>
            <ac:picMk id="4" creationId="{F163C655-8A29-7290-3608-FABA38851DE9}"/>
          </ac:picMkLst>
        </pc:picChg>
        <pc:picChg chg="del">
          <ac:chgData name="義章 谷口" userId="1aec43038f16d83c" providerId="LiveId" clId="{F9419B5B-E985-4A2F-8F99-BCFE6C0CAAB4}" dt="2024-06-03T09:07:47.816" v="291" actId="478"/>
          <ac:picMkLst>
            <pc:docMk/>
            <pc:sldMk cId="3636881930" sldId="268"/>
            <ac:picMk id="9" creationId="{A52A6F3E-B53F-E32E-DABB-914113044652}"/>
          </ac:picMkLst>
        </pc:picChg>
        <pc:picChg chg="add del mod modCrop">
          <ac:chgData name="義章 谷口" userId="1aec43038f16d83c" providerId="LiveId" clId="{F9419B5B-E985-4A2F-8F99-BCFE6C0CAAB4}" dt="2024-06-03T09:12:39.392" v="381" actId="22"/>
          <ac:picMkLst>
            <pc:docMk/>
            <pc:sldMk cId="3636881930" sldId="268"/>
            <ac:picMk id="14" creationId="{4CDA54CF-99F0-D5C9-4F50-D5E0072681B1}"/>
          </ac:picMkLst>
        </pc:picChg>
        <pc:picChg chg="add mod modCrop">
          <ac:chgData name="義章 谷口" userId="1aec43038f16d83c" providerId="LiveId" clId="{F9419B5B-E985-4A2F-8F99-BCFE6C0CAAB4}" dt="2024-07-17T13:03:34.853" v="1986" actId="1037"/>
          <ac:picMkLst>
            <pc:docMk/>
            <pc:sldMk cId="3636881930" sldId="268"/>
            <ac:picMk id="17" creationId="{DE958411-6F0F-B9FF-DF04-D484AC0DA13F}"/>
          </ac:picMkLst>
        </pc:picChg>
        <pc:picChg chg="add del mod">
          <ac:chgData name="義章 谷口" userId="1aec43038f16d83c" providerId="LiveId" clId="{F9419B5B-E985-4A2F-8F99-BCFE6C0CAAB4}" dt="2024-07-17T13:03:34.853" v="1986" actId="1037"/>
          <ac:picMkLst>
            <pc:docMk/>
            <pc:sldMk cId="3636881930" sldId="268"/>
            <ac:picMk id="19" creationId="{8068250C-05ED-F243-D0AA-EA2EE94A0ECE}"/>
          </ac:picMkLst>
        </pc:picChg>
      </pc:sldChg>
      <pc:sldChg chg="addSp delSp modSp add del mod modNotesTx">
        <pc:chgData name="義章 谷口" userId="1aec43038f16d83c" providerId="LiveId" clId="{F9419B5B-E985-4A2F-8F99-BCFE6C0CAAB4}" dt="2024-07-17T13:09:39.279" v="2058" actId="47"/>
        <pc:sldMkLst>
          <pc:docMk/>
          <pc:sldMk cId="1165001852" sldId="269"/>
        </pc:sldMkLst>
        <pc:spChg chg="add mod">
          <ac:chgData name="義章 谷口" userId="1aec43038f16d83c" providerId="LiveId" clId="{F9419B5B-E985-4A2F-8F99-BCFE6C0CAAB4}" dt="2024-06-21T08:09:48.005" v="1874" actId="1076"/>
          <ac:spMkLst>
            <pc:docMk/>
            <pc:sldMk cId="1165001852" sldId="269"/>
            <ac:spMk id="2" creationId="{4EA5E164-D2B8-965D-C3EE-354F9F335AF0}"/>
          </ac:spMkLst>
        </pc:spChg>
        <pc:spChg chg="add mod ord">
          <ac:chgData name="義章 谷口" userId="1aec43038f16d83c" providerId="LiveId" clId="{F9419B5B-E985-4A2F-8F99-BCFE6C0CAAB4}" dt="2024-07-17T13:08:10.729" v="2048" actId="14100"/>
          <ac:spMkLst>
            <pc:docMk/>
            <pc:sldMk cId="1165001852" sldId="269"/>
            <ac:spMk id="5" creationId="{A446A0D0-9DA7-D3BE-5B97-2D507AAA4C90}"/>
          </ac:spMkLst>
        </pc:spChg>
        <pc:spChg chg="add mod">
          <ac:chgData name="義章 谷口" userId="1aec43038f16d83c" providerId="LiveId" clId="{F9419B5B-E985-4A2F-8F99-BCFE6C0CAAB4}" dt="2024-06-21T08:07:29.313" v="1847" actId="20577"/>
          <ac:spMkLst>
            <pc:docMk/>
            <pc:sldMk cId="1165001852" sldId="269"/>
            <ac:spMk id="9" creationId="{E6D8BE1E-A050-5C34-0744-09C7CA6224A6}"/>
          </ac:spMkLst>
        </pc:spChg>
        <pc:spChg chg="add mod">
          <ac:chgData name="義章 谷口" userId="1aec43038f16d83c" providerId="LiveId" clId="{F9419B5B-E985-4A2F-8F99-BCFE6C0CAAB4}" dt="2024-06-11T08:30:44.349" v="1781" actId="14100"/>
          <ac:spMkLst>
            <pc:docMk/>
            <pc:sldMk cId="1165001852" sldId="269"/>
            <ac:spMk id="10" creationId="{EDAD5F7E-6EE5-A40F-A076-051EBB2238BC}"/>
          </ac:spMkLst>
        </pc:spChg>
        <pc:spChg chg="add mod">
          <ac:chgData name="義章 谷口" userId="1aec43038f16d83c" providerId="LiveId" clId="{F9419B5B-E985-4A2F-8F99-BCFE6C0CAAB4}" dt="2024-06-11T08:30:38.135" v="1774" actId="14100"/>
          <ac:spMkLst>
            <pc:docMk/>
            <pc:sldMk cId="1165001852" sldId="269"/>
            <ac:spMk id="11" creationId="{783123B9-37F0-B5A2-D523-FB57B59C903A}"/>
          </ac:spMkLst>
        </pc:spChg>
        <pc:spChg chg="add mod">
          <ac:chgData name="義章 谷口" userId="1aec43038f16d83c" providerId="LiveId" clId="{F9419B5B-E985-4A2F-8F99-BCFE6C0CAAB4}" dt="2024-06-04T06:25:58.073" v="833"/>
          <ac:spMkLst>
            <pc:docMk/>
            <pc:sldMk cId="1165001852" sldId="269"/>
            <ac:spMk id="12" creationId="{DFFB6758-1FB8-63E3-42D4-810848FAC39E}"/>
          </ac:spMkLst>
        </pc:spChg>
        <pc:spChg chg="add mod">
          <ac:chgData name="義章 谷口" userId="1aec43038f16d83c" providerId="LiveId" clId="{F9419B5B-E985-4A2F-8F99-BCFE6C0CAAB4}" dt="2024-06-04T06:26:05.294" v="834"/>
          <ac:spMkLst>
            <pc:docMk/>
            <pc:sldMk cId="1165001852" sldId="269"/>
            <ac:spMk id="13" creationId="{0FB8F851-076B-7A9D-1A14-F5263F8D6B1D}"/>
          </ac:spMkLst>
        </pc:spChg>
        <pc:spChg chg="add mod">
          <ac:chgData name="義章 谷口" userId="1aec43038f16d83c" providerId="LiveId" clId="{F9419B5B-E985-4A2F-8F99-BCFE6C0CAAB4}" dt="2024-06-04T06:26:20.833" v="835"/>
          <ac:spMkLst>
            <pc:docMk/>
            <pc:sldMk cId="1165001852" sldId="269"/>
            <ac:spMk id="14" creationId="{5F4DAAEC-1164-D360-2167-329D572D8E41}"/>
          </ac:spMkLst>
        </pc:spChg>
        <pc:spChg chg="add mod">
          <ac:chgData name="義章 谷口" userId="1aec43038f16d83c" providerId="LiveId" clId="{F9419B5B-E985-4A2F-8F99-BCFE6C0CAAB4}" dt="2024-06-04T06:26:26.755" v="836"/>
          <ac:spMkLst>
            <pc:docMk/>
            <pc:sldMk cId="1165001852" sldId="269"/>
            <ac:spMk id="15" creationId="{5EB35E8E-EA86-D9C2-C152-34ED01C1CB41}"/>
          </ac:spMkLst>
        </pc:spChg>
        <pc:spChg chg="add mod">
          <ac:chgData name="義章 谷口" userId="1aec43038f16d83c" providerId="LiveId" clId="{F9419B5B-E985-4A2F-8F99-BCFE6C0CAAB4}" dt="2024-06-04T06:26:32.869" v="837"/>
          <ac:spMkLst>
            <pc:docMk/>
            <pc:sldMk cId="1165001852" sldId="269"/>
            <ac:spMk id="16" creationId="{D58FCC68-A715-D584-CDD0-E2376B6A8F92}"/>
          </ac:spMkLst>
        </pc:spChg>
        <pc:spChg chg="add mod">
          <ac:chgData name="義章 谷口" userId="1aec43038f16d83c" providerId="LiveId" clId="{F9419B5B-E985-4A2F-8F99-BCFE6C0CAAB4}" dt="2024-06-04T06:26:39.994" v="838"/>
          <ac:spMkLst>
            <pc:docMk/>
            <pc:sldMk cId="1165001852" sldId="269"/>
            <ac:spMk id="17" creationId="{8C24B128-8BA1-177C-A342-A5F8C422BCA9}"/>
          </ac:spMkLst>
        </pc:spChg>
        <pc:spChg chg="del">
          <ac:chgData name="義章 谷口" userId="1aec43038f16d83c" providerId="LiveId" clId="{F9419B5B-E985-4A2F-8F99-BCFE6C0CAAB4}" dt="2024-06-04T06:14:50.991" v="775" actId="478"/>
          <ac:spMkLst>
            <pc:docMk/>
            <pc:sldMk cId="1165001852" sldId="269"/>
            <ac:spMk id="23" creationId="{57E6EE92-62BA-B75C-B079-F7D7BB941FBB}"/>
          </ac:spMkLst>
        </pc:spChg>
        <pc:spChg chg="add mod">
          <ac:chgData name="義章 谷口" userId="1aec43038f16d83c" providerId="LiveId" clId="{F9419B5B-E985-4A2F-8F99-BCFE6C0CAAB4}" dt="2024-06-21T08:07:35.934" v="1848" actId="20577"/>
          <ac:spMkLst>
            <pc:docMk/>
            <pc:sldMk cId="1165001852" sldId="269"/>
            <ac:spMk id="25" creationId="{0CDCB2F2-C63F-19AF-E370-539C8B3B5CF6}"/>
          </ac:spMkLst>
        </pc:spChg>
        <pc:spChg chg="del">
          <ac:chgData name="義章 谷口" userId="1aec43038f16d83c" providerId="LiveId" clId="{F9419B5B-E985-4A2F-8F99-BCFE6C0CAAB4}" dt="2024-06-04T06:14:50.991" v="775" actId="478"/>
          <ac:spMkLst>
            <pc:docMk/>
            <pc:sldMk cId="1165001852" sldId="269"/>
            <ac:spMk id="26" creationId="{6E2C7D79-A425-E780-6BA5-BE2B5E30959E}"/>
          </ac:spMkLst>
        </pc:spChg>
        <pc:spChg chg="del">
          <ac:chgData name="義章 谷口" userId="1aec43038f16d83c" providerId="LiveId" clId="{F9419B5B-E985-4A2F-8F99-BCFE6C0CAAB4}" dt="2024-06-04T06:14:50.991" v="775" actId="478"/>
          <ac:spMkLst>
            <pc:docMk/>
            <pc:sldMk cId="1165001852" sldId="269"/>
            <ac:spMk id="27" creationId="{9D786531-DD72-746A-3A95-97B38B4F97E2}"/>
          </ac:spMkLst>
        </pc:spChg>
        <pc:spChg chg="del">
          <ac:chgData name="義章 谷口" userId="1aec43038f16d83c" providerId="LiveId" clId="{F9419B5B-E985-4A2F-8F99-BCFE6C0CAAB4}" dt="2024-06-04T06:14:50.991" v="775" actId="478"/>
          <ac:spMkLst>
            <pc:docMk/>
            <pc:sldMk cId="1165001852" sldId="269"/>
            <ac:spMk id="28" creationId="{55423702-8442-6043-F030-C53F3DC94135}"/>
          </ac:spMkLst>
        </pc:spChg>
        <pc:spChg chg="add mod">
          <ac:chgData name="義章 谷口" userId="1aec43038f16d83c" providerId="LiveId" clId="{F9419B5B-E985-4A2F-8F99-BCFE6C0CAAB4}" dt="2024-06-04T06:33:11.964" v="956" actId="1076"/>
          <ac:spMkLst>
            <pc:docMk/>
            <pc:sldMk cId="1165001852" sldId="269"/>
            <ac:spMk id="29" creationId="{0925D584-38D4-9D32-9951-A77E07A17502}"/>
          </ac:spMkLst>
        </pc:spChg>
        <pc:spChg chg="add mod">
          <ac:chgData name="義章 谷口" userId="1aec43038f16d83c" providerId="LiveId" clId="{F9419B5B-E985-4A2F-8F99-BCFE6C0CAAB4}" dt="2024-06-04T06:33:39.112" v="964" actId="1035"/>
          <ac:spMkLst>
            <pc:docMk/>
            <pc:sldMk cId="1165001852" sldId="269"/>
            <ac:spMk id="30" creationId="{DC7575AA-B56E-5565-9091-628D53858DCC}"/>
          </ac:spMkLst>
        </pc:spChg>
        <pc:spChg chg="add mod">
          <ac:chgData name="義章 谷口" userId="1aec43038f16d83c" providerId="LiveId" clId="{F9419B5B-E985-4A2F-8F99-BCFE6C0CAAB4}" dt="2024-06-11T08:30:52.861" v="1788" actId="14100"/>
          <ac:spMkLst>
            <pc:docMk/>
            <pc:sldMk cId="1165001852" sldId="269"/>
            <ac:spMk id="31" creationId="{7D19843B-7406-640F-45CF-DA788D62B9ED}"/>
          </ac:spMkLst>
        </pc:spChg>
        <pc:spChg chg="add mod">
          <ac:chgData name="義章 谷口" userId="1aec43038f16d83c" providerId="LiveId" clId="{F9419B5B-E985-4A2F-8F99-BCFE6C0CAAB4}" dt="2024-06-11T08:30:59.081" v="1795" actId="14100"/>
          <ac:spMkLst>
            <pc:docMk/>
            <pc:sldMk cId="1165001852" sldId="269"/>
            <ac:spMk id="32" creationId="{7EE76769-A5DA-5E44-FEF5-854A94209AF4}"/>
          </ac:spMkLst>
        </pc:spChg>
        <pc:spChg chg="add mod">
          <ac:chgData name="義章 谷口" userId="1aec43038f16d83c" providerId="LiveId" clId="{F9419B5B-E985-4A2F-8F99-BCFE6C0CAAB4}" dt="2024-06-21T08:07:40.794" v="1849" actId="20577"/>
          <ac:spMkLst>
            <pc:docMk/>
            <pc:sldMk cId="1165001852" sldId="269"/>
            <ac:spMk id="35" creationId="{91C08EA3-0A4B-2988-879D-C77E7785FC4F}"/>
          </ac:spMkLst>
        </pc:spChg>
        <pc:spChg chg="add mod">
          <ac:chgData name="義章 谷口" userId="1aec43038f16d83c" providerId="LiveId" clId="{F9419B5B-E985-4A2F-8F99-BCFE6C0CAAB4}" dt="2024-06-11T08:31:15.195" v="1802" actId="14100"/>
          <ac:spMkLst>
            <pc:docMk/>
            <pc:sldMk cId="1165001852" sldId="269"/>
            <ac:spMk id="36" creationId="{97077257-791F-0F10-5714-0F9D0D7A9699}"/>
          </ac:spMkLst>
        </pc:spChg>
        <pc:spChg chg="add mod">
          <ac:chgData name="義章 谷口" userId="1aec43038f16d83c" providerId="LiveId" clId="{F9419B5B-E985-4A2F-8F99-BCFE6C0CAAB4}" dt="2024-06-21T08:07:52.376" v="1851" actId="20577"/>
          <ac:spMkLst>
            <pc:docMk/>
            <pc:sldMk cId="1165001852" sldId="269"/>
            <ac:spMk id="37" creationId="{5990EA01-1889-C9BE-A527-A36132DD9E48}"/>
          </ac:spMkLst>
        </pc:spChg>
        <pc:spChg chg="add mod">
          <ac:chgData name="義章 谷口" userId="1aec43038f16d83c" providerId="LiveId" clId="{F9419B5B-E985-4A2F-8F99-BCFE6C0CAAB4}" dt="2024-06-04T06:38:50.383" v="1061" actId="1076"/>
          <ac:spMkLst>
            <pc:docMk/>
            <pc:sldMk cId="1165001852" sldId="269"/>
            <ac:spMk id="38" creationId="{E2811ABD-949C-701A-82C6-6778B726ED97}"/>
          </ac:spMkLst>
        </pc:spChg>
        <pc:spChg chg="add mod">
          <ac:chgData name="義章 谷口" userId="1aec43038f16d83c" providerId="LiveId" clId="{F9419B5B-E985-4A2F-8F99-BCFE6C0CAAB4}" dt="2024-06-04T06:39:16.146" v="1135" actId="1076"/>
          <ac:spMkLst>
            <pc:docMk/>
            <pc:sldMk cId="1165001852" sldId="269"/>
            <ac:spMk id="39" creationId="{E4C47950-683D-A7EA-FD13-F020F134EA10}"/>
          </ac:spMkLst>
        </pc:spChg>
        <pc:spChg chg="add mod">
          <ac:chgData name="義章 谷口" userId="1aec43038f16d83c" providerId="LiveId" clId="{F9419B5B-E985-4A2F-8F99-BCFE6C0CAAB4}" dt="2024-06-21T08:09:57.986" v="1875" actId="20577"/>
          <ac:spMkLst>
            <pc:docMk/>
            <pc:sldMk cId="1165001852" sldId="269"/>
            <ac:spMk id="45" creationId="{9BFF4591-1C89-B054-E696-80CDEA9BEA60}"/>
          </ac:spMkLst>
        </pc:spChg>
        <pc:spChg chg="add mod">
          <ac:chgData name="義章 谷口" userId="1aec43038f16d83c" providerId="LiveId" clId="{F9419B5B-E985-4A2F-8F99-BCFE6C0CAAB4}" dt="2024-06-04T06:50:16.783" v="1288" actId="1036"/>
          <ac:spMkLst>
            <pc:docMk/>
            <pc:sldMk cId="1165001852" sldId="269"/>
            <ac:spMk id="46" creationId="{C116F99E-2D22-A473-5DBD-5D6B53BEC1F4}"/>
          </ac:spMkLst>
        </pc:spChg>
        <pc:spChg chg="add mod">
          <ac:chgData name="義章 谷口" userId="1aec43038f16d83c" providerId="LiveId" clId="{F9419B5B-E985-4A2F-8F99-BCFE6C0CAAB4}" dt="2024-06-04T06:50:20.644" v="1291" actId="1036"/>
          <ac:spMkLst>
            <pc:docMk/>
            <pc:sldMk cId="1165001852" sldId="269"/>
            <ac:spMk id="47" creationId="{68B6293C-E643-4D8A-2620-3397D8B133F3}"/>
          </ac:spMkLst>
        </pc:spChg>
        <pc:spChg chg="add mod">
          <ac:chgData name="義章 谷口" userId="1aec43038f16d83c" providerId="LiveId" clId="{F9419B5B-E985-4A2F-8F99-BCFE6C0CAAB4}" dt="2024-06-04T06:50:29.064" v="1300" actId="1038"/>
          <ac:spMkLst>
            <pc:docMk/>
            <pc:sldMk cId="1165001852" sldId="269"/>
            <ac:spMk id="48" creationId="{DEFC129B-D6B4-B649-AAE3-57F3C374ED94}"/>
          </ac:spMkLst>
        </pc:spChg>
        <pc:picChg chg="add del mod modCrop">
          <ac:chgData name="義章 谷口" userId="1aec43038f16d83c" providerId="LiveId" clId="{F9419B5B-E985-4A2F-8F99-BCFE6C0CAAB4}" dt="2024-06-04T06:24:30.002" v="790" actId="478"/>
          <ac:picMkLst>
            <pc:docMk/>
            <pc:sldMk cId="1165001852" sldId="269"/>
            <ac:picMk id="3" creationId="{38B57AA5-7894-ACF2-AD0D-F9DCB53DCC91}"/>
          </ac:picMkLst>
        </pc:picChg>
        <pc:picChg chg="del">
          <ac:chgData name="義章 谷口" userId="1aec43038f16d83c" providerId="LiveId" clId="{F9419B5B-E985-4A2F-8F99-BCFE6C0CAAB4}" dt="2024-06-04T06:14:50.991" v="775" actId="478"/>
          <ac:picMkLst>
            <pc:docMk/>
            <pc:sldMk cId="1165001852" sldId="269"/>
            <ac:picMk id="4" creationId="{DE590EA8-E0EB-F4D7-F960-39403F135AAF}"/>
          </ac:picMkLst>
        </pc:picChg>
        <pc:picChg chg="add mod">
          <ac:chgData name="義章 谷口" userId="1aec43038f16d83c" providerId="LiveId" clId="{F9419B5B-E985-4A2F-8F99-BCFE6C0CAAB4}" dt="2024-07-17T13:06:37.792" v="2031"/>
          <ac:picMkLst>
            <pc:docMk/>
            <pc:sldMk cId="1165001852" sldId="269"/>
            <ac:picMk id="4" creationId="{E7F0D753-3CE8-4AFC-B2C5-5C033FF60DD1}"/>
          </ac:picMkLst>
        </pc:picChg>
        <pc:picChg chg="del">
          <ac:chgData name="義章 谷口" userId="1aec43038f16d83c" providerId="LiveId" clId="{F9419B5B-E985-4A2F-8F99-BCFE6C0CAAB4}" dt="2024-06-04T06:14:50.991" v="775" actId="478"/>
          <ac:picMkLst>
            <pc:docMk/>
            <pc:sldMk cId="1165001852" sldId="269"/>
            <ac:picMk id="5" creationId="{1D2CF956-7462-D0C6-D011-723708AFCA72}"/>
          </ac:picMkLst>
        </pc:picChg>
        <pc:picChg chg="del">
          <ac:chgData name="義章 谷口" userId="1aec43038f16d83c" providerId="LiveId" clId="{F9419B5B-E985-4A2F-8F99-BCFE6C0CAAB4}" dt="2024-06-04T06:14:50.991" v="775" actId="478"/>
          <ac:picMkLst>
            <pc:docMk/>
            <pc:sldMk cId="1165001852" sldId="269"/>
            <ac:picMk id="6" creationId="{8CE904EC-AA62-602B-AAFA-85201550FF21}"/>
          </ac:picMkLst>
        </pc:picChg>
        <pc:picChg chg="del">
          <ac:chgData name="義章 谷口" userId="1aec43038f16d83c" providerId="LiveId" clId="{F9419B5B-E985-4A2F-8F99-BCFE6C0CAAB4}" dt="2024-06-04T06:14:50.991" v="775" actId="478"/>
          <ac:picMkLst>
            <pc:docMk/>
            <pc:sldMk cId="1165001852" sldId="269"/>
            <ac:picMk id="7" creationId="{45951C39-A25A-A5D2-7018-0FD72B3C7385}"/>
          </ac:picMkLst>
        </pc:picChg>
        <pc:picChg chg="add mod">
          <ac:chgData name="義章 谷口" userId="1aec43038f16d83c" providerId="LiveId" clId="{F9419B5B-E985-4A2F-8F99-BCFE6C0CAAB4}" dt="2024-06-04T06:24:20.584" v="789"/>
          <ac:picMkLst>
            <pc:docMk/>
            <pc:sldMk cId="1165001852" sldId="269"/>
            <ac:picMk id="8" creationId="{17351414-3C44-9DBA-4487-037DC5DCBA17}"/>
          </ac:picMkLst>
        </pc:picChg>
        <pc:picChg chg="add del mod modCrop">
          <ac:chgData name="義章 谷口" userId="1aec43038f16d83c" providerId="LiveId" clId="{F9419B5B-E985-4A2F-8F99-BCFE6C0CAAB4}" dt="2024-06-04T06:28:58.175" v="847" actId="478"/>
          <ac:picMkLst>
            <pc:docMk/>
            <pc:sldMk cId="1165001852" sldId="269"/>
            <ac:picMk id="19" creationId="{7B9060F3-CBE4-5276-B440-358C07E84C57}"/>
          </ac:picMkLst>
        </pc:picChg>
        <pc:picChg chg="add del mod modCrop">
          <ac:chgData name="義章 谷口" userId="1aec43038f16d83c" providerId="LiveId" clId="{F9419B5B-E985-4A2F-8F99-BCFE6C0CAAB4}" dt="2024-06-04T06:30:25.335" v="862" actId="21"/>
          <ac:picMkLst>
            <pc:docMk/>
            <pc:sldMk cId="1165001852" sldId="269"/>
            <ac:picMk id="21" creationId="{F6D5604D-1774-89A7-7268-96FBC39930F2}"/>
          </ac:picMkLst>
        </pc:picChg>
        <pc:picChg chg="add">
          <ac:chgData name="義章 谷口" userId="1aec43038f16d83c" providerId="LiveId" clId="{F9419B5B-E985-4A2F-8F99-BCFE6C0CAAB4}" dt="2024-06-04T06:31:19.941" v="863"/>
          <ac:picMkLst>
            <pc:docMk/>
            <pc:sldMk cId="1165001852" sldId="269"/>
            <ac:picMk id="22" creationId="{5B46CCDB-0FFF-E3F8-897F-F149B6C22AA5}"/>
          </ac:picMkLst>
        </pc:picChg>
        <pc:picChg chg="add mod">
          <ac:chgData name="義章 谷口" userId="1aec43038f16d83c" providerId="LiveId" clId="{F9419B5B-E985-4A2F-8F99-BCFE6C0CAAB4}" dt="2024-06-04T06:32:48.655" v="954" actId="1076"/>
          <ac:picMkLst>
            <pc:docMk/>
            <pc:sldMk cId="1165001852" sldId="269"/>
            <ac:picMk id="24" creationId="{F6D5604D-1774-89A7-7268-96FBC39930F2}"/>
          </ac:picMkLst>
        </pc:picChg>
        <pc:picChg chg="add mod modCrop">
          <ac:chgData name="義章 谷口" userId="1aec43038f16d83c" providerId="LiveId" clId="{F9419B5B-E985-4A2F-8F99-BCFE6C0CAAB4}" dt="2024-06-04T06:37:25.940" v="993" actId="1076"/>
          <ac:picMkLst>
            <pc:docMk/>
            <pc:sldMk cId="1165001852" sldId="269"/>
            <ac:picMk id="34" creationId="{D3CB5B33-405F-B062-8643-85342A1D3939}"/>
          </ac:picMkLst>
        </pc:picChg>
        <pc:picChg chg="add del mod modCrop">
          <ac:chgData name="義章 谷口" userId="1aec43038f16d83c" providerId="LiveId" clId="{F9419B5B-E985-4A2F-8F99-BCFE6C0CAAB4}" dt="2024-06-04T06:44:09.387" v="1150" actId="21"/>
          <ac:picMkLst>
            <pc:docMk/>
            <pc:sldMk cId="1165001852" sldId="269"/>
            <ac:picMk id="41" creationId="{957C96D4-BF9E-4EF9-639B-9C11FDB7E56D}"/>
          </ac:picMkLst>
        </pc:picChg>
        <pc:picChg chg="add del mod">
          <ac:chgData name="義章 谷口" userId="1aec43038f16d83c" providerId="LiveId" clId="{F9419B5B-E985-4A2F-8F99-BCFE6C0CAAB4}" dt="2024-06-04T06:47:47.145" v="1242" actId="21"/>
          <ac:picMkLst>
            <pc:docMk/>
            <pc:sldMk cId="1165001852" sldId="269"/>
            <ac:picMk id="42" creationId="{AFD23225-4FD4-63B0-78DC-727347F9A2AE}"/>
          </ac:picMkLst>
        </pc:picChg>
        <pc:picChg chg="add mod">
          <ac:chgData name="義章 谷口" userId="1aec43038f16d83c" providerId="LiveId" clId="{F9419B5B-E985-4A2F-8F99-BCFE6C0CAAB4}" dt="2024-07-17T13:06:42.093" v="2033" actId="1076"/>
          <ac:picMkLst>
            <pc:docMk/>
            <pc:sldMk cId="1165001852" sldId="269"/>
            <ac:picMk id="43" creationId="{AFD23225-4FD4-63B0-78DC-727347F9A2AE}"/>
          </ac:picMkLst>
        </pc:picChg>
        <pc:picChg chg="add mod">
          <ac:chgData name="義章 谷口" userId="1aec43038f16d83c" providerId="LiveId" clId="{F9419B5B-E985-4A2F-8F99-BCFE6C0CAAB4}" dt="2024-06-04T06:48:59.972" v="1249" actId="1076"/>
          <ac:picMkLst>
            <pc:docMk/>
            <pc:sldMk cId="1165001852" sldId="269"/>
            <ac:picMk id="44" creationId="{259C3F99-F88D-BC80-084A-671E882B7837}"/>
          </ac:picMkLst>
        </pc:picChg>
      </pc:sldChg>
      <pc:sldChg chg="addSp delSp modSp add mod modNotesTx">
        <pc:chgData name="義章 谷口" userId="1aec43038f16d83c" providerId="LiveId" clId="{F9419B5B-E985-4A2F-8F99-BCFE6C0CAAB4}" dt="2024-07-17T13:04:23.527" v="2030" actId="1037"/>
        <pc:sldMkLst>
          <pc:docMk/>
          <pc:sldMk cId="2143561547" sldId="270"/>
        </pc:sldMkLst>
        <pc:spChg chg="add mod">
          <ac:chgData name="義章 谷口" userId="1aec43038f16d83c" providerId="LiveId" clId="{F9419B5B-E985-4A2F-8F99-BCFE6C0CAAB4}" dt="2024-07-17T13:04:23.527" v="2030" actId="1037"/>
          <ac:spMkLst>
            <pc:docMk/>
            <pc:sldMk cId="2143561547" sldId="270"/>
            <ac:spMk id="2" creationId="{FF5F6A21-B450-CFB4-E9E1-F5980A6A5D4F}"/>
          </ac:spMkLst>
        </pc:spChg>
        <pc:spChg chg="mod">
          <ac:chgData name="義章 谷口" userId="1aec43038f16d83c" providerId="LiveId" clId="{F9419B5B-E985-4A2F-8F99-BCFE6C0CAAB4}" dt="2024-07-17T13:04:23.527" v="2030" actId="1037"/>
          <ac:spMkLst>
            <pc:docMk/>
            <pc:sldMk cId="2143561547" sldId="270"/>
            <ac:spMk id="5" creationId="{4407F1E2-D438-DE61-3686-154A0B2DC115}"/>
          </ac:spMkLst>
        </pc:spChg>
        <pc:spChg chg="mod">
          <ac:chgData name="義章 谷口" userId="1aec43038f16d83c" providerId="LiveId" clId="{F9419B5B-E985-4A2F-8F99-BCFE6C0CAAB4}" dt="2024-07-17T13:04:23.527" v="2030" actId="1037"/>
          <ac:spMkLst>
            <pc:docMk/>
            <pc:sldMk cId="2143561547" sldId="270"/>
            <ac:spMk id="6" creationId="{461E3E1E-BDA3-7AAE-2D37-5194017B2505}"/>
          </ac:spMkLst>
        </pc:spChg>
        <pc:spChg chg="mod ord">
          <ac:chgData name="義章 谷口" userId="1aec43038f16d83c" providerId="LiveId" clId="{F9419B5B-E985-4A2F-8F99-BCFE6C0CAAB4}" dt="2024-07-17T13:04:23.527" v="2030" actId="1037"/>
          <ac:spMkLst>
            <pc:docMk/>
            <pc:sldMk cId="2143561547" sldId="270"/>
            <ac:spMk id="7" creationId="{D97E9A28-B482-AEB2-92B7-D6774239B034}"/>
          </ac:spMkLst>
        </pc:spChg>
        <pc:spChg chg="mod">
          <ac:chgData name="義章 谷口" userId="1aec43038f16d83c" providerId="LiveId" clId="{F9419B5B-E985-4A2F-8F99-BCFE6C0CAAB4}" dt="2024-07-17T13:04:23.527" v="2030" actId="1037"/>
          <ac:spMkLst>
            <pc:docMk/>
            <pc:sldMk cId="2143561547" sldId="270"/>
            <ac:spMk id="8" creationId="{430A4E4D-2A47-D028-6DCB-9CDD24A6C69B}"/>
          </ac:spMkLst>
        </pc:spChg>
        <pc:spChg chg="mod">
          <ac:chgData name="義章 谷口" userId="1aec43038f16d83c" providerId="LiveId" clId="{F9419B5B-E985-4A2F-8F99-BCFE6C0CAAB4}" dt="2024-07-17T13:04:23.527" v="2030" actId="1037"/>
          <ac:spMkLst>
            <pc:docMk/>
            <pc:sldMk cId="2143561547" sldId="270"/>
            <ac:spMk id="9" creationId="{9319F6C4-5B69-4578-5469-6731EE2B64DC}"/>
          </ac:spMkLst>
        </pc:spChg>
        <pc:spChg chg="mod">
          <ac:chgData name="義章 谷口" userId="1aec43038f16d83c" providerId="LiveId" clId="{F9419B5B-E985-4A2F-8F99-BCFE6C0CAAB4}" dt="2024-07-17T13:04:23.527" v="2030" actId="1037"/>
          <ac:spMkLst>
            <pc:docMk/>
            <pc:sldMk cId="2143561547" sldId="270"/>
            <ac:spMk id="10" creationId="{2C274409-BD68-9EF1-0490-375C58C601D2}"/>
          </ac:spMkLst>
        </pc:spChg>
        <pc:spChg chg="del">
          <ac:chgData name="義章 谷口" userId="1aec43038f16d83c" providerId="LiveId" clId="{F9419B5B-E985-4A2F-8F99-BCFE6C0CAAB4}" dt="2024-06-06T08:16:42.592" v="1356" actId="478"/>
          <ac:spMkLst>
            <pc:docMk/>
            <pc:sldMk cId="2143561547" sldId="270"/>
            <ac:spMk id="10" creationId="{937706DF-EF0D-D8A5-6FDB-21F162142B6D}"/>
          </ac:spMkLst>
        </pc:spChg>
        <pc:spChg chg="mod">
          <ac:chgData name="義章 谷口" userId="1aec43038f16d83c" providerId="LiveId" clId="{F9419B5B-E985-4A2F-8F99-BCFE6C0CAAB4}" dt="2024-07-17T13:04:23.527" v="2030" actId="1037"/>
          <ac:spMkLst>
            <pc:docMk/>
            <pc:sldMk cId="2143561547" sldId="270"/>
            <ac:spMk id="11" creationId="{6BB842DC-006C-28A0-97BA-73EFAC2A6DFA}"/>
          </ac:spMkLst>
        </pc:spChg>
        <pc:spChg chg="del">
          <ac:chgData name="義章 谷口" userId="1aec43038f16d83c" providerId="LiveId" clId="{F9419B5B-E985-4A2F-8F99-BCFE6C0CAAB4}" dt="2024-06-06T08:16:38.591" v="1354" actId="478"/>
          <ac:spMkLst>
            <pc:docMk/>
            <pc:sldMk cId="2143561547" sldId="270"/>
            <ac:spMk id="11" creationId="{CAF5EBA7-B9B2-AE08-7D4D-AACA6FDCD616}"/>
          </ac:spMkLst>
        </pc:spChg>
        <pc:spChg chg="del">
          <ac:chgData name="義章 谷口" userId="1aec43038f16d83c" providerId="LiveId" clId="{F9419B5B-E985-4A2F-8F99-BCFE6C0CAAB4}" dt="2024-06-06T08:16:40.006" v="1355" actId="478"/>
          <ac:spMkLst>
            <pc:docMk/>
            <pc:sldMk cId="2143561547" sldId="270"/>
            <ac:spMk id="12" creationId="{3134F92C-4A3F-F93E-0599-2051EBA350EC}"/>
          </ac:spMkLst>
        </pc:spChg>
        <pc:spChg chg="add mod">
          <ac:chgData name="義章 谷口" userId="1aec43038f16d83c" providerId="LiveId" clId="{F9419B5B-E985-4A2F-8F99-BCFE6C0CAAB4}" dt="2024-07-17T13:03:51.167" v="1989" actId="20577"/>
          <ac:spMkLst>
            <pc:docMk/>
            <pc:sldMk cId="2143561547" sldId="270"/>
            <ac:spMk id="12" creationId="{D3ABB375-9D96-19FF-D582-8A27CC27F326}"/>
          </ac:spMkLst>
        </pc:spChg>
        <pc:spChg chg="mod ord">
          <ac:chgData name="義章 谷口" userId="1aec43038f16d83c" providerId="LiveId" clId="{F9419B5B-E985-4A2F-8F99-BCFE6C0CAAB4}" dt="2024-07-17T13:04:23.527" v="2030" actId="1037"/>
          <ac:spMkLst>
            <pc:docMk/>
            <pc:sldMk cId="2143561547" sldId="270"/>
            <ac:spMk id="20" creationId="{98045E09-6699-2804-DA2B-7A24431AA917}"/>
          </ac:spMkLst>
        </pc:spChg>
        <pc:spChg chg="del">
          <ac:chgData name="義章 谷口" userId="1aec43038f16d83c" providerId="LiveId" clId="{F9419B5B-E985-4A2F-8F99-BCFE6C0CAAB4}" dt="2024-06-06T08:20:32.132" v="1498" actId="478"/>
          <ac:spMkLst>
            <pc:docMk/>
            <pc:sldMk cId="2143561547" sldId="270"/>
            <ac:spMk id="22" creationId="{8EE5EFA4-2E68-9EBB-A55B-0ECF26FF3D1B}"/>
          </ac:spMkLst>
        </pc:spChg>
        <pc:spChg chg="del">
          <ac:chgData name="義章 谷口" userId="1aec43038f16d83c" providerId="LiveId" clId="{F9419B5B-E985-4A2F-8F99-BCFE6C0CAAB4}" dt="2024-06-06T08:20:33.477" v="1499" actId="478"/>
          <ac:spMkLst>
            <pc:docMk/>
            <pc:sldMk cId="2143561547" sldId="270"/>
            <ac:spMk id="23" creationId="{6215D990-4FE5-407A-71D2-99AB29486582}"/>
          </ac:spMkLst>
        </pc:spChg>
        <pc:spChg chg="mod">
          <ac:chgData name="義章 谷口" userId="1aec43038f16d83c" providerId="LiveId" clId="{F9419B5B-E985-4A2F-8F99-BCFE6C0CAAB4}" dt="2024-07-17T13:04:23.527" v="2030" actId="1037"/>
          <ac:spMkLst>
            <pc:docMk/>
            <pc:sldMk cId="2143561547" sldId="270"/>
            <ac:spMk id="24" creationId="{658D2D9A-63D4-B822-7C6F-A20E36D47FD6}"/>
          </ac:spMkLst>
        </pc:spChg>
        <pc:spChg chg="del">
          <ac:chgData name="義章 谷口" userId="1aec43038f16d83c" providerId="LiveId" clId="{F9419B5B-E985-4A2F-8F99-BCFE6C0CAAB4}" dt="2024-06-06T08:20:30.549" v="1497" actId="478"/>
          <ac:spMkLst>
            <pc:docMk/>
            <pc:sldMk cId="2143561547" sldId="270"/>
            <ac:spMk id="25" creationId="{3E2AC77E-63BC-4253-A074-F19C4F58708C}"/>
          </ac:spMkLst>
        </pc:spChg>
        <pc:spChg chg="del">
          <ac:chgData name="義章 谷口" userId="1aec43038f16d83c" providerId="LiveId" clId="{F9419B5B-E985-4A2F-8F99-BCFE6C0CAAB4}" dt="2024-06-06T08:20:00.629" v="1492" actId="478"/>
          <ac:spMkLst>
            <pc:docMk/>
            <pc:sldMk cId="2143561547" sldId="270"/>
            <ac:spMk id="26" creationId="{62FF3F85-6450-EC63-7717-4B565FBDA0DF}"/>
          </ac:spMkLst>
        </pc:spChg>
        <pc:picChg chg="add mod modCrop">
          <ac:chgData name="義章 谷口" userId="1aec43038f16d83c" providerId="LiveId" clId="{F9419B5B-E985-4A2F-8F99-BCFE6C0CAAB4}" dt="2024-07-17T13:04:23.527" v="2030" actId="1037"/>
          <ac:picMkLst>
            <pc:docMk/>
            <pc:sldMk cId="2143561547" sldId="270"/>
            <ac:picMk id="3" creationId="{C531D652-50CB-1339-1B90-F2B07AE495B7}"/>
          </ac:picMkLst>
        </pc:picChg>
        <pc:picChg chg="add mod modCrop">
          <ac:chgData name="義章 谷口" userId="1aec43038f16d83c" providerId="LiveId" clId="{F9419B5B-E985-4A2F-8F99-BCFE6C0CAAB4}" dt="2024-07-17T13:04:23.527" v="2030" actId="1037"/>
          <ac:picMkLst>
            <pc:docMk/>
            <pc:sldMk cId="2143561547" sldId="270"/>
            <ac:picMk id="4" creationId="{5C84B219-43FC-DDC7-B154-72B8EF0D7C37}"/>
          </ac:picMkLst>
        </pc:picChg>
        <pc:picChg chg="del">
          <ac:chgData name="義章 谷口" userId="1aec43038f16d83c" providerId="LiveId" clId="{F9419B5B-E985-4A2F-8F99-BCFE6C0CAAB4}" dt="2024-06-06T08:22:51.020" v="1605" actId="478"/>
          <ac:picMkLst>
            <pc:docMk/>
            <pc:sldMk cId="2143561547" sldId="270"/>
            <ac:picMk id="17" creationId="{DE958411-6F0F-B9FF-DF04-D484AC0DA13F}"/>
          </ac:picMkLst>
        </pc:picChg>
        <pc:picChg chg="del">
          <ac:chgData name="義章 谷口" userId="1aec43038f16d83c" providerId="LiveId" clId="{F9419B5B-E985-4A2F-8F99-BCFE6C0CAAB4}" dt="2024-06-06T08:22:50.067" v="1604" actId="478"/>
          <ac:picMkLst>
            <pc:docMk/>
            <pc:sldMk cId="2143561547" sldId="270"/>
            <ac:picMk id="19" creationId="{8068250C-05ED-F243-D0AA-EA2EE94A0ECE}"/>
          </ac:picMkLst>
        </pc:picChg>
      </pc:sldChg>
      <pc:sldChg chg="addSp delSp modSp new mod modNotesTx">
        <pc:chgData name="義章 谷口" userId="1aec43038f16d83c" providerId="LiveId" clId="{F9419B5B-E985-4A2F-8F99-BCFE6C0CAAB4}" dt="2024-07-17T13:09:27.722" v="2057" actId="1076"/>
        <pc:sldMkLst>
          <pc:docMk/>
          <pc:sldMk cId="3694551460" sldId="271"/>
        </pc:sldMkLst>
        <pc:spChg chg="del">
          <ac:chgData name="義章 谷口" userId="1aec43038f16d83c" providerId="LiveId" clId="{F9419B5B-E985-4A2F-8F99-BCFE6C0CAAB4}" dt="2024-07-17T13:06:49.096" v="2035" actId="478"/>
          <ac:spMkLst>
            <pc:docMk/>
            <pc:sldMk cId="3694551460" sldId="271"/>
            <ac:spMk id="2" creationId="{BD2E62C9-FF41-8ACD-DF14-8802670B8F5F}"/>
          </ac:spMkLst>
        </pc:spChg>
        <pc:spChg chg="del">
          <ac:chgData name="義章 谷口" userId="1aec43038f16d83c" providerId="LiveId" clId="{F9419B5B-E985-4A2F-8F99-BCFE6C0CAAB4}" dt="2024-07-17T13:06:49.096" v="2035" actId="478"/>
          <ac:spMkLst>
            <pc:docMk/>
            <pc:sldMk cId="3694551460" sldId="271"/>
            <ac:spMk id="3" creationId="{7095DDEC-39B4-C9A6-1C06-39F2470EC10E}"/>
          </ac:spMkLst>
        </pc:spChg>
        <pc:spChg chg="add mod">
          <ac:chgData name="義章 谷口" userId="1aec43038f16d83c" providerId="LiveId" clId="{F9419B5B-E985-4A2F-8F99-BCFE6C0CAAB4}" dt="2024-07-17T13:09:16.663" v="2054" actId="20577"/>
          <ac:spMkLst>
            <pc:docMk/>
            <pc:sldMk cId="3694551460" sldId="271"/>
            <ac:spMk id="8" creationId="{381393C5-459E-11E8-34C0-CD8318914C11}"/>
          </ac:spMkLst>
        </pc:spChg>
        <pc:picChg chg="add del mod">
          <ac:chgData name="義章 谷口" userId="1aec43038f16d83c" providerId="LiveId" clId="{F9419B5B-E985-4A2F-8F99-BCFE6C0CAAB4}" dt="2024-07-17T13:07:17.340" v="2040" actId="478"/>
          <ac:picMkLst>
            <pc:docMk/>
            <pc:sldMk cId="3694551460" sldId="271"/>
            <ac:picMk id="5" creationId="{9B448A45-85E0-4F17-75E0-0D1D86987E9E}"/>
          </ac:picMkLst>
        </pc:picChg>
        <pc:picChg chg="add mod">
          <ac:chgData name="義章 谷口" userId="1aec43038f16d83c" providerId="LiveId" clId="{F9419B5B-E985-4A2F-8F99-BCFE6C0CAAB4}" dt="2024-07-17T13:09:27.722" v="2057" actId="1076"/>
          <ac:picMkLst>
            <pc:docMk/>
            <pc:sldMk cId="3694551460" sldId="271"/>
            <ac:picMk id="7" creationId="{EB4B961B-EC1C-F0C1-F8C8-F617718B9748}"/>
          </ac:picMkLst>
        </pc:picChg>
      </pc:sldChg>
    </pc:docChg>
  </pc:docChgLst>
  <pc:docChgLst>
    <pc:chgData name="義章 谷口" userId="1aec43038f16d83c" providerId="LiveId" clId="{12088F07-8FE9-4FAA-9725-AFA2589A1C4F}"/>
    <pc:docChg chg="undo custSel addSld delSld modSld sldOrd modMainMaster modNotesMaster">
      <pc:chgData name="義章 谷口" userId="1aec43038f16d83c" providerId="LiveId" clId="{12088F07-8FE9-4FAA-9725-AFA2589A1C4F}" dt="2024-10-09T13:01:44.652" v="962" actId="47"/>
      <pc:docMkLst>
        <pc:docMk/>
      </pc:docMkLst>
      <pc:sldChg chg="modSp modNotes">
        <pc:chgData name="義章 谷口" userId="1aec43038f16d83c" providerId="LiveId" clId="{12088F07-8FE9-4FAA-9725-AFA2589A1C4F}" dt="2024-09-30T02:26:23.826" v="11"/>
        <pc:sldMkLst>
          <pc:docMk/>
          <pc:sldMk cId="1536307505" sldId="267"/>
        </pc:sldMkLst>
        <pc:spChg chg="mod">
          <ac:chgData name="義章 谷口" userId="1aec43038f16d83c" providerId="LiveId" clId="{12088F07-8FE9-4FAA-9725-AFA2589A1C4F}" dt="2024-09-30T02:26:23.826" v="11"/>
          <ac:spMkLst>
            <pc:docMk/>
            <pc:sldMk cId="1536307505" sldId="267"/>
            <ac:spMk id="2" creationId="{BD5D6C10-B013-993B-F6DC-15D3AB55D936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1536307505" sldId="267"/>
            <ac:spMk id="6" creationId="{7176863B-AC9D-8C8B-F355-E85A4B8CF2AB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1536307505" sldId="267"/>
            <ac:spMk id="7" creationId="{73521C6C-792D-3F43-7E55-66833697CDDA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1536307505" sldId="267"/>
            <ac:spMk id="8" creationId="{1B213F52-94D3-08ED-CAFB-90259E733946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1536307505" sldId="267"/>
            <ac:spMk id="9" creationId="{D58950D6-D6BE-49A1-262D-95A066901B27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1536307505" sldId="267"/>
            <ac:spMk id="10" creationId="{8C6B6879-478D-4D90-E7EC-16DAC409FD1D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1536307505" sldId="267"/>
            <ac:spMk id="11" creationId="{7FE27219-2862-8AC8-576B-4972C01535F5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1536307505" sldId="267"/>
            <ac:spMk id="14" creationId="{4C4F0A78-20E1-E611-27AD-1C7B9D247398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1536307505" sldId="267"/>
            <ac:spMk id="15" creationId="{517EDCE7-DA4E-1E96-02AB-10D12283B6E0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1536307505" sldId="267"/>
            <ac:spMk id="16" creationId="{A8951612-A8DA-45C5-7574-544E3626C707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1536307505" sldId="267"/>
            <ac:spMk id="17" creationId="{0E87DBDF-D460-19AB-4008-2AFBF4CBC2B4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1536307505" sldId="267"/>
            <ac:spMk id="18" creationId="{9E15E36C-A6E9-00EC-5D66-867DFDD80B77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1536307505" sldId="267"/>
            <ac:spMk id="21" creationId="{DFB904F4-4901-56B2-BCD0-CD7F602C0823}"/>
          </ac:spMkLst>
        </pc:spChg>
        <pc:picChg chg="mod">
          <ac:chgData name="義章 谷口" userId="1aec43038f16d83c" providerId="LiveId" clId="{12088F07-8FE9-4FAA-9725-AFA2589A1C4F}" dt="2024-09-30T02:26:23.826" v="11"/>
          <ac:picMkLst>
            <pc:docMk/>
            <pc:sldMk cId="1536307505" sldId="267"/>
            <ac:picMk id="4" creationId="{75973A64-A4BC-A614-6975-6BF24E9CAF9A}"/>
          </ac:picMkLst>
        </pc:picChg>
        <pc:picChg chg="mod">
          <ac:chgData name="義章 谷口" userId="1aec43038f16d83c" providerId="LiveId" clId="{12088F07-8FE9-4FAA-9725-AFA2589A1C4F}" dt="2024-09-30T02:26:23.826" v="11"/>
          <ac:picMkLst>
            <pc:docMk/>
            <pc:sldMk cId="1536307505" sldId="267"/>
            <ac:picMk id="13" creationId="{8D822204-E180-80C4-3A0C-EA052EC2FE50}"/>
          </ac:picMkLst>
        </pc:picChg>
      </pc:sldChg>
      <pc:sldChg chg="modSp modNotes">
        <pc:chgData name="義章 谷口" userId="1aec43038f16d83c" providerId="LiveId" clId="{12088F07-8FE9-4FAA-9725-AFA2589A1C4F}" dt="2024-09-30T02:26:23.826" v="11"/>
        <pc:sldMkLst>
          <pc:docMk/>
          <pc:sldMk cId="3636881930" sldId="268"/>
        </pc:sldMkLst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36881930" sldId="268"/>
            <ac:spMk id="2" creationId="{2203063E-32AC-C1CA-52CD-B7B86DCD0F64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36881930" sldId="268"/>
            <ac:spMk id="5" creationId="{4407F1E2-D438-DE61-3686-154A0B2DC115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36881930" sldId="268"/>
            <ac:spMk id="6" creationId="{461E3E1E-BDA3-7AAE-2D37-5194017B2505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36881930" sldId="268"/>
            <ac:spMk id="7" creationId="{D97E9A28-B482-AEB2-92B7-D6774239B034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36881930" sldId="268"/>
            <ac:spMk id="10" creationId="{937706DF-EF0D-D8A5-6FDB-21F162142B6D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36881930" sldId="268"/>
            <ac:spMk id="11" creationId="{CAF5EBA7-B9B2-AE08-7D4D-AACA6FDCD616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36881930" sldId="268"/>
            <ac:spMk id="12" creationId="{3134F92C-4A3F-F93E-0599-2051EBA350EC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36881930" sldId="268"/>
            <ac:spMk id="20" creationId="{98045E09-6699-2804-DA2B-7A24431AA917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36881930" sldId="268"/>
            <ac:spMk id="22" creationId="{8EE5EFA4-2E68-9EBB-A55B-0ECF26FF3D1B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36881930" sldId="268"/>
            <ac:spMk id="23" creationId="{6215D990-4FE5-407A-71D2-99AB29486582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36881930" sldId="268"/>
            <ac:spMk id="24" creationId="{658D2D9A-63D4-B822-7C6F-A20E36D47FD6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36881930" sldId="268"/>
            <ac:spMk id="25" creationId="{3E2AC77E-63BC-4253-A074-F19C4F58708C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36881930" sldId="268"/>
            <ac:spMk id="26" creationId="{62FF3F85-6450-EC63-7717-4B565FBDA0DF}"/>
          </ac:spMkLst>
        </pc:spChg>
        <pc:picChg chg="mod">
          <ac:chgData name="義章 谷口" userId="1aec43038f16d83c" providerId="LiveId" clId="{12088F07-8FE9-4FAA-9725-AFA2589A1C4F}" dt="2024-09-30T02:26:23.826" v="11"/>
          <ac:picMkLst>
            <pc:docMk/>
            <pc:sldMk cId="3636881930" sldId="268"/>
            <ac:picMk id="17" creationId="{DE958411-6F0F-B9FF-DF04-D484AC0DA13F}"/>
          </ac:picMkLst>
        </pc:picChg>
        <pc:picChg chg="mod">
          <ac:chgData name="義章 谷口" userId="1aec43038f16d83c" providerId="LiveId" clId="{12088F07-8FE9-4FAA-9725-AFA2589A1C4F}" dt="2024-09-30T02:26:23.826" v="11"/>
          <ac:picMkLst>
            <pc:docMk/>
            <pc:sldMk cId="3636881930" sldId="268"/>
            <ac:picMk id="19" creationId="{8068250C-05ED-F243-D0AA-EA2EE94A0ECE}"/>
          </ac:picMkLst>
        </pc:picChg>
      </pc:sldChg>
      <pc:sldChg chg="modSp modNotes">
        <pc:chgData name="義章 谷口" userId="1aec43038f16d83c" providerId="LiveId" clId="{12088F07-8FE9-4FAA-9725-AFA2589A1C4F}" dt="2024-09-30T02:26:23.826" v="11"/>
        <pc:sldMkLst>
          <pc:docMk/>
          <pc:sldMk cId="2143561547" sldId="270"/>
        </pc:sldMkLst>
        <pc:spChg chg="mod">
          <ac:chgData name="義章 谷口" userId="1aec43038f16d83c" providerId="LiveId" clId="{12088F07-8FE9-4FAA-9725-AFA2589A1C4F}" dt="2024-09-30T02:26:23.826" v="11"/>
          <ac:spMkLst>
            <pc:docMk/>
            <pc:sldMk cId="2143561547" sldId="270"/>
            <ac:spMk id="2" creationId="{FF5F6A21-B450-CFB4-E9E1-F5980A6A5D4F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2143561547" sldId="270"/>
            <ac:spMk id="5" creationId="{4407F1E2-D438-DE61-3686-154A0B2DC115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2143561547" sldId="270"/>
            <ac:spMk id="6" creationId="{461E3E1E-BDA3-7AAE-2D37-5194017B2505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2143561547" sldId="270"/>
            <ac:spMk id="7" creationId="{D97E9A28-B482-AEB2-92B7-D6774239B034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2143561547" sldId="270"/>
            <ac:spMk id="8" creationId="{430A4E4D-2A47-D028-6DCB-9CDD24A6C69B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2143561547" sldId="270"/>
            <ac:spMk id="9" creationId="{9319F6C4-5B69-4578-5469-6731EE2B64DC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2143561547" sldId="270"/>
            <ac:spMk id="10" creationId="{2C274409-BD68-9EF1-0490-375C58C601D2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2143561547" sldId="270"/>
            <ac:spMk id="11" creationId="{6BB842DC-006C-28A0-97BA-73EFAC2A6DFA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2143561547" sldId="270"/>
            <ac:spMk id="12" creationId="{D3ABB375-9D96-19FF-D582-8A27CC27F326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2143561547" sldId="270"/>
            <ac:spMk id="20" creationId="{98045E09-6699-2804-DA2B-7A24431AA917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k cId="2143561547" sldId="270"/>
            <ac:spMk id="24" creationId="{658D2D9A-63D4-B822-7C6F-A20E36D47FD6}"/>
          </ac:spMkLst>
        </pc:spChg>
        <pc:picChg chg="mod">
          <ac:chgData name="義章 谷口" userId="1aec43038f16d83c" providerId="LiveId" clId="{12088F07-8FE9-4FAA-9725-AFA2589A1C4F}" dt="2024-09-30T02:26:23.826" v="11"/>
          <ac:picMkLst>
            <pc:docMk/>
            <pc:sldMk cId="2143561547" sldId="270"/>
            <ac:picMk id="3" creationId="{C531D652-50CB-1339-1B90-F2B07AE495B7}"/>
          </ac:picMkLst>
        </pc:picChg>
        <pc:picChg chg="mod">
          <ac:chgData name="義章 谷口" userId="1aec43038f16d83c" providerId="LiveId" clId="{12088F07-8FE9-4FAA-9725-AFA2589A1C4F}" dt="2024-09-30T02:26:23.826" v="11"/>
          <ac:picMkLst>
            <pc:docMk/>
            <pc:sldMk cId="2143561547" sldId="270"/>
            <ac:picMk id="4" creationId="{5C84B219-43FC-DDC7-B154-72B8EF0D7C37}"/>
          </ac:picMkLst>
        </pc:picChg>
      </pc:sldChg>
      <pc:sldChg chg="modSp modNotes">
        <pc:chgData name="義章 谷口" userId="1aec43038f16d83c" providerId="LiveId" clId="{12088F07-8FE9-4FAA-9725-AFA2589A1C4F}" dt="2024-09-30T02:26:23.826" v="11"/>
        <pc:sldMkLst>
          <pc:docMk/>
          <pc:sldMk cId="3694551460" sldId="271"/>
        </pc:sldMkLst>
        <pc:spChg chg="mod">
          <ac:chgData name="義章 谷口" userId="1aec43038f16d83c" providerId="LiveId" clId="{12088F07-8FE9-4FAA-9725-AFA2589A1C4F}" dt="2024-09-30T02:26:23.826" v="11"/>
          <ac:spMkLst>
            <pc:docMk/>
            <pc:sldMk cId="3694551460" sldId="271"/>
            <ac:spMk id="8" creationId="{381393C5-459E-11E8-34C0-CD8318914C11}"/>
          </ac:spMkLst>
        </pc:spChg>
        <pc:picChg chg="mod">
          <ac:chgData name="義章 谷口" userId="1aec43038f16d83c" providerId="LiveId" clId="{12088F07-8FE9-4FAA-9725-AFA2589A1C4F}" dt="2024-09-30T02:26:23.826" v="11"/>
          <ac:picMkLst>
            <pc:docMk/>
            <pc:sldMk cId="3694551460" sldId="271"/>
            <ac:picMk id="7" creationId="{EB4B961B-EC1C-F0C1-F8C8-F617718B9748}"/>
          </ac:picMkLst>
        </pc:picChg>
      </pc:sldChg>
      <pc:sldChg chg="addSp delSp modSp new add del mod ord">
        <pc:chgData name="義章 谷口" userId="1aec43038f16d83c" providerId="LiveId" clId="{12088F07-8FE9-4FAA-9725-AFA2589A1C4F}" dt="2024-10-09T13:01:44.114" v="961" actId="47"/>
        <pc:sldMkLst>
          <pc:docMk/>
          <pc:sldMk cId="2604343971" sldId="272"/>
        </pc:sldMkLst>
        <pc:spChg chg="del">
          <ac:chgData name="義章 谷口" userId="1aec43038f16d83c" providerId="LiveId" clId="{12088F07-8FE9-4FAA-9725-AFA2589A1C4F}" dt="2024-09-30T02:24:00.517" v="1" actId="478"/>
          <ac:spMkLst>
            <pc:docMk/>
            <pc:sldMk cId="2604343971" sldId="272"/>
            <ac:spMk id="2" creationId="{7DD0BEA8-8C9B-F80A-4851-7DD60187B641}"/>
          </ac:spMkLst>
        </pc:spChg>
        <pc:spChg chg="add mod">
          <ac:chgData name="義章 谷口" userId="1aec43038f16d83c" providerId="LiveId" clId="{12088F07-8FE9-4FAA-9725-AFA2589A1C4F}" dt="2024-10-04T03:02:14.166" v="888" actId="1076"/>
          <ac:spMkLst>
            <pc:docMk/>
            <pc:sldMk cId="2604343971" sldId="272"/>
            <ac:spMk id="2" creationId="{988F8025-61C3-46E8-9A37-8B74EDAC787F}"/>
          </ac:spMkLst>
        </pc:spChg>
        <pc:spChg chg="del">
          <ac:chgData name="義章 谷口" userId="1aec43038f16d83c" providerId="LiveId" clId="{12088F07-8FE9-4FAA-9725-AFA2589A1C4F}" dt="2024-09-30T02:24:00.517" v="1" actId="478"/>
          <ac:spMkLst>
            <pc:docMk/>
            <pc:sldMk cId="2604343971" sldId="272"/>
            <ac:spMk id="3" creationId="{F105F8EE-1CCC-198F-2CF1-891BEECE1E7F}"/>
          </ac:spMkLst>
        </pc:spChg>
        <pc:spChg chg="add del mod">
          <ac:chgData name="義章 谷口" userId="1aec43038f16d83c" providerId="LiveId" clId="{12088F07-8FE9-4FAA-9725-AFA2589A1C4F}" dt="2024-10-02T06:35:43.363" v="879" actId="478"/>
          <ac:spMkLst>
            <pc:docMk/>
            <pc:sldMk cId="2604343971" sldId="272"/>
            <ac:spMk id="6" creationId="{DD66483B-8578-6F93-8348-A9905BB11989}"/>
          </ac:spMkLst>
        </pc:spChg>
        <pc:spChg chg="add mod">
          <ac:chgData name="義章 谷口" userId="1aec43038f16d83c" providerId="LiveId" clId="{12088F07-8FE9-4FAA-9725-AFA2589A1C4F}" dt="2024-09-30T02:27:25.261" v="18"/>
          <ac:spMkLst>
            <pc:docMk/>
            <pc:sldMk cId="2604343971" sldId="272"/>
            <ac:spMk id="7" creationId="{A0882C26-B928-3493-E48C-00D0FA8FA6E6}"/>
          </ac:spMkLst>
        </pc:spChg>
        <pc:spChg chg="add mod">
          <ac:chgData name="義章 谷口" userId="1aec43038f16d83c" providerId="LiveId" clId="{12088F07-8FE9-4FAA-9725-AFA2589A1C4F}" dt="2024-09-30T02:27:30.948" v="19"/>
          <ac:spMkLst>
            <pc:docMk/>
            <pc:sldMk cId="2604343971" sldId="272"/>
            <ac:spMk id="8" creationId="{674A7F0F-0A17-F325-CFF3-A87B42430FE8}"/>
          </ac:spMkLst>
        </pc:spChg>
        <pc:spChg chg="add mod">
          <ac:chgData name="義章 谷口" userId="1aec43038f16d83c" providerId="LiveId" clId="{12088F07-8FE9-4FAA-9725-AFA2589A1C4F}" dt="2024-09-30T02:40:28.683" v="76" actId="20577"/>
          <ac:spMkLst>
            <pc:docMk/>
            <pc:sldMk cId="2604343971" sldId="272"/>
            <ac:spMk id="9" creationId="{C3E33CAD-00AE-145B-ECD8-38DD05E6A66F}"/>
          </ac:spMkLst>
        </pc:spChg>
        <pc:spChg chg="add mod">
          <ac:chgData name="義章 谷口" userId="1aec43038f16d83c" providerId="LiveId" clId="{12088F07-8FE9-4FAA-9725-AFA2589A1C4F}" dt="2024-09-30T02:40:24.802" v="74" actId="20577"/>
          <ac:spMkLst>
            <pc:docMk/>
            <pc:sldMk cId="2604343971" sldId="272"/>
            <ac:spMk id="10" creationId="{4503164E-8250-4717-3CC5-904154002B49}"/>
          </ac:spMkLst>
        </pc:spChg>
        <pc:spChg chg="add mod">
          <ac:chgData name="義章 谷口" userId="1aec43038f16d83c" providerId="LiveId" clId="{12088F07-8FE9-4FAA-9725-AFA2589A1C4F}" dt="2024-10-02T05:36:50.951" v="350" actId="20577"/>
          <ac:spMkLst>
            <pc:docMk/>
            <pc:sldMk cId="2604343971" sldId="272"/>
            <ac:spMk id="11" creationId="{A933878E-80BF-5760-9140-E1A1C884C9C7}"/>
          </ac:spMkLst>
        </pc:spChg>
        <pc:picChg chg="add del mod modCrop">
          <ac:chgData name="義章 谷口" userId="1aec43038f16d83c" providerId="LiveId" clId="{12088F07-8FE9-4FAA-9725-AFA2589A1C4F}" dt="2024-09-30T02:26:59.468" v="13" actId="478"/>
          <ac:picMkLst>
            <pc:docMk/>
            <pc:sldMk cId="2604343971" sldId="272"/>
            <ac:picMk id="5" creationId="{1513A9D8-A1B4-CF5B-2942-24F0E7A5C08E}"/>
          </ac:picMkLst>
        </pc:picChg>
        <pc:picChg chg="add mod">
          <ac:chgData name="義章 谷口" userId="1aec43038f16d83c" providerId="LiveId" clId="{12088F07-8FE9-4FAA-9725-AFA2589A1C4F}" dt="2024-09-30T02:27:01.694" v="14"/>
          <ac:picMkLst>
            <pc:docMk/>
            <pc:sldMk cId="2604343971" sldId="272"/>
            <ac:picMk id="20" creationId="{86E0AE4B-7D7C-49E6-B560-AAE2C5179530}"/>
          </ac:picMkLst>
        </pc:picChg>
      </pc:sldChg>
      <pc:sldChg chg="addSp delSp modSp new add del mod">
        <pc:chgData name="義章 谷口" userId="1aec43038f16d83c" providerId="LiveId" clId="{12088F07-8FE9-4FAA-9725-AFA2589A1C4F}" dt="2024-10-09T13:01:43.517" v="960" actId="47"/>
        <pc:sldMkLst>
          <pc:docMk/>
          <pc:sldMk cId="3997223119" sldId="273"/>
        </pc:sldMkLst>
        <pc:spChg chg="add mod">
          <ac:chgData name="義章 谷口" userId="1aec43038f16d83c" providerId="LiveId" clId="{12088F07-8FE9-4FAA-9725-AFA2589A1C4F}" dt="2024-10-04T02:59:35.316" v="884" actId="20577"/>
          <ac:spMkLst>
            <pc:docMk/>
            <pc:sldMk cId="3997223119" sldId="273"/>
            <ac:spMk id="2" creationId="{5C4E2F1F-C79A-316E-B008-6299373A832D}"/>
          </ac:spMkLst>
        </pc:spChg>
        <pc:spChg chg="del">
          <ac:chgData name="義章 谷口" userId="1aec43038f16d83c" providerId="LiveId" clId="{12088F07-8FE9-4FAA-9725-AFA2589A1C4F}" dt="2024-09-30T02:41:13.988" v="78" actId="478"/>
          <ac:spMkLst>
            <pc:docMk/>
            <pc:sldMk cId="3997223119" sldId="273"/>
            <ac:spMk id="2" creationId="{98FFC416-C163-BFF9-A33D-5E1CF999E0CB}"/>
          </ac:spMkLst>
        </pc:spChg>
        <pc:spChg chg="del">
          <ac:chgData name="義章 谷口" userId="1aec43038f16d83c" providerId="LiveId" clId="{12088F07-8FE9-4FAA-9725-AFA2589A1C4F}" dt="2024-09-30T02:41:13.988" v="78" actId="478"/>
          <ac:spMkLst>
            <pc:docMk/>
            <pc:sldMk cId="3997223119" sldId="273"/>
            <ac:spMk id="3" creationId="{4EA44C94-22E0-476E-832E-C1989C9A92E8}"/>
          </ac:spMkLst>
        </pc:spChg>
        <pc:spChg chg="add mod">
          <ac:chgData name="義章 谷口" userId="1aec43038f16d83c" providerId="LiveId" clId="{12088F07-8FE9-4FAA-9725-AFA2589A1C4F}" dt="2024-09-30T04:09:27.606" v="226" actId="1076"/>
          <ac:spMkLst>
            <pc:docMk/>
            <pc:sldMk cId="3997223119" sldId="273"/>
            <ac:spMk id="4" creationId="{39024F59-115A-A900-2CBD-C1931D43633B}"/>
          </ac:spMkLst>
        </pc:spChg>
        <pc:spChg chg="add mod">
          <ac:chgData name="義章 谷口" userId="1aec43038f16d83c" providerId="LiveId" clId="{12088F07-8FE9-4FAA-9725-AFA2589A1C4F}" dt="2024-09-30T02:51:38.687" v="153" actId="1076"/>
          <ac:spMkLst>
            <pc:docMk/>
            <pc:sldMk cId="3997223119" sldId="273"/>
            <ac:spMk id="6" creationId="{727EBE08-111B-AF2A-06E1-BE872ABF1DA6}"/>
          </ac:spMkLst>
        </pc:spChg>
        <pc:spChg chg="add mod">
          <ac:chgData name="義章 谷口" userId="1aec43038f16d83c" providerId="LiveId" clId="{12088F07-8FE9-4FAA-9725-AFA2589A1C4F}" dt="2024-09-30T02:51:38.687" v="153" actId="1076"/>
          <ac:spMkLst>
            <pc:docMk/>
            <pc:sldMk cId="3997223119" sldId="273"/>
            <ac:spMk id="7" creationId="{ADC88319-3463-FFA2-35BD-06FF26E12877}"/>
          </ac:spMkLst>
        </pc:spChg>
        <pc:spChg chg="add mod">
          <ac:chgData name="義章 谷口" userId="1aec43038f16d83c" providerId="LiveId" clId="{12088F07-8FE9-4FAA-9725-AFA2589A1C4F}" dt="2024-09-30T02:51:38.687" v="153" actId="1076"/>
          <ac:spMkLst>
            <pc:docMk/>
            <pc:sldMk cId="3997223119" sldId="273"/>
            <ac:spMk id="8" creationId="{E8F4ACC4-075F-4504-C32F-5B0D11A80870}"/>
          </ac:spMkLst>
        </pc:spChg>
        <pc:spChg chg="add del mod">
          <ac:chgData name="義章 谷口" userId="1aec43038f16d83c" providerId="LiveId" clId="{12088F07-8FE9-4FAA-9725-AFA2589A1C4F}" dt="2024-10-02T06:35:40.752" v="878" actId="478"/>
          <ac:spMkLst>
            <pc:docMk/>
            <pc:sldMk cId="3997223119" sldId="273"/>
            <ac:spMk id="9" creationId="{D4460BAF-BF73-7F7F-F1B1-4C5D73C8589E}"/>
          </ac:spMkLst>
        </pc:spChg>
        <pc:spChg chg="add mod">
          <ac:chgData name="義章 谷口" userId="1aec43038f16d83c" providerId="LiveId" clId="{12088F07-8FE9-4FAA-9725-AFA2589A1C4F}" dt="2024-10-04T02:59:30.684" v="883" actId="20577"/>
          <ac:spMkLst>
            <pc:docMk/>
            <pc:sldMk cId="3997223119" sldId="273"/>
            <ac:spMk id="10" creationId="{3F5D6DE6-FD06-4B76-A3B5-197798C439D6}"/>
          </ac:spMkLst>
        </pc:spChg>
        <pc:spChg chg="add mod">
          <ac:chgData name="義章 谷口" userId="1aec43038f16d83c" providerId="LiveId" clId="{12088F07-8FE9-4FAA-9725-AFA2589A1C4F}" dt="2024-09-30T07:24:39.808" v="345" actId="20577"/>
          <ac:spMkLst>
            <pc:docMk/>
            <pc:sldMk cId="3997223119" sldId="273"/>
            <ac:spMk id="11" creationId="{C7B27A35-D15A-468A-9937-684B8F1BFB04}"/>
          </ac:spMkLst>
        </pc:spChg>
        <pc:spChg chg="add mod">
          <ac:chgData name="義章 谷口" userId="1aec43038f16d83c" providerId="LiveId" clId="{12088F07-8FE9-4FAA-9725-AFA2589A1C4F}" dt="2024-09-30T04:09:39.560" v="228" actId="1076"/>
          <ac:spMkLst>
            <pc:docMk/>
            <pc:sldMk cId="3997223119" sldId="273"/>
            <ac:spMk id="12" creationId="{604A39C2-D62C-D5E1-48FC-461067B57FD1}"/>
          </ac:spMkLst>
        </pc:spChg>
        <pc:spChg chg="add mod">
          <ac:chgData name="義章 谷口" userId="1aec43038f16d83c" providerId="LiveId" clId="{12088F07-8FE9-4FAA-9725-AFA2589A1C4F}" dt="2024-09-30T04:09:53.090" v="230" actId="1076"/>
          <ac:spMkLst>
            <pc:docMk/>
            <pc:sldMk cId="3997223119" sldId="273"/>
            <ac:spMk id="13" creationId="{A492F6A2-249B-0F60-1173-997330C2691B}"/>
          </ac:spMkLst>
        </pc:spChg>
        <pc:spChg chg="add mod">
          <ac:chgData name="義章 谷口" userId="1aec43038f16d83c" providerId="LiveId" clId="{12088F07-8FE9-4FAA-9725-AFA2589A1C4F}" dt="2024-09-30T07:24:33.025" v="342" actId="20577"/>
          <ac:spMkLst>
            <pc:docMk/>
            <pc:sldMk cId="3997223119" sldId="273"/>
            <ac:spMk id="14" creationId="{F4429F8A-270D-2E87-C12D-016FCBA1DECB}"/>
          </ac:spMkLst>
        </pc:spChg>
        <pc:picChg chg="add mod modCrop">
          <ac:chgData name="義章 谷口" userId="1aec43038f16d83c" providerId="LiveId" clId="{12088F07-8FE9-4FAA-9725-AFA2589A1C4F}" dt="2024-09-30T04:08:47.818" v="222" actId="1076"/>
          <ac:picMkLst>
            <pc:docMk/>
            <pc:sldMk cId="3997223119" sldId="273"/>
            <ac:picMk id="3" creationId="{5D0A1F44-E08A-EF27-4821-B7FC4A867950}"/>
          </ac:picMkLst>
        </pc:picChg>
        <pc:picChg chg="add mod modCrop">
          <ac:chgData name="義章 谷口" userId="1aec43038f16d83c" providerId="LiveId" clId="{12088F07-8FE9-4FAA-9725-AFA2589A1C4F}" dt="2024-09-30T02:54:23.728" v="204" actId="1076"/>
          <ac:picMkLst>
            <pc:docMk/>
            <pc:sldMk cId="3997223119" sldId="273"/>
            <ac:picMk id="5" creationId="{FF3F7CA1-3C7F-B342-025F-F4E8772D30E7}"/>
          </ac:picMkLst>
        </pc:picChg>
        <pc:picChg chg="add del mod">
          <ac:chgData name="義章 谷口" userId="1aec43038f16d83c" providerId="LiveId" clId="{12088F07-8FE9-4FAA-9725-AFA2589A1C4F}" dt="2024-09-30T07:21:12.769" v="256" actId="21"/>
          <ac:picMkLst>
            <pc:docMk/>
            <pc:sldMk cId="3997223119" sldId="273"/>
            <ac:picMk id="15" creationId="{AFC04D31-F049-4F01-9808-332973178E77}"/>
          </ac:picMkLst>
        </pc:picChg>
      </pc:sldChg>
      <pc:sldChg chg="addSp delSp modSp new add del mod">
        <pc:chgData name="義章 谷口" userId="1aec43038f16d83c" providerId="LiveId" clId="{12088F07-8FE9-4FAA-9725-AFA2589A1C4F}" dt="2024-10-09T13:01:42.819" v="959" actId="47"/>
        <pc:sldMkLst>
          <pc:docMk/>
          <pc:sldMk cId="2293877723" sldId="274"/>
        </pc:sldMkLst>
        <pc:spChg chg="del">
          <ac:chgData name="義章 谷口" userId="1aec43038f16d83c" providerId="LiveId" clId="{12088F07-8FE9-4FAA-9725-AFA2589A1C4F}" dt="2024-09-30T07:19:36.569" v="247" actId="478"/>
          <ac:spMkLst>
            <pc:docMk/>
            <pc:sldMk cId="2293877723" sldId="274"/>
            <ac:spMk id="2" creationId="{3152345D-8994-8FB9-FB8A-8727CA615D41}"/>
          </ac:spMkLst>
        </pc:spChg>
        <pc:spChg chg="del">
          <ac:chgData name="義章 谷口" userId="1aec43038f16d83c" providerId="LiveId" clId="{12088F07-8FE9-4FAA-9725-AFA2589A1C4F}" dt="2024-09-30T07:19:36.569" v="247" actId="478"/>
          <ac:spMkLst>
            <pc:docMk/>
            <pc:sldMk cId="2293877723" sldId="274"/>
            <ac:spMk id="3" creationId="{14633BC6-D683-1987-FC28-7E71432ABE2C}"/>
          </ac:spMkLst>
        </pc:spChg>
        <pc:spChg chg="add mod">
          <ac:chgData name="義章 谷口" userId="1aec43038f16d83c" providerId="LiveId" clId="{12088F07-8FE9-4FAA-9725-AFA2589A1C4F}" dt="2024-10-04T03:03:45.566" v="910" actId="1035"/>
          <ac:spMkLst>
            <pc:docMk/>
            <pc:sldMk cId="2293877723" sldId="274"/>
            <ac:spMk id="4" creationId="{4461E34E-4910-3EA2-0AC1-E69D4F4425C0}"/>
          </ac:spMkLst>
        </pc:spChg>
        <pc:spChg chg="add del mod">
          <ac:chgData name="義章 谷口" userId="1aec43038f16d83c" providerId="LiveId" clId="{12088F07-8FE9-4FAA-9725-AFA2589A1C4F}" dt="2024-10-02T06:35:36.037" v="876" actId="478"/>
          <ac:spMkLst>
            <pc:docMk/>
            <pc:sldMk cId="2293877723" sldId="274"/>
            <ac:spMk id="5" creationId="{69508C94-FBE1-13A2-3B5B-82804323C0E2}"/>
          </ac:spMkLst>
        </pc:spChg>
        <pc:spChg chg="add mod">
          <ac:chgData name="義章 谷口" userId="1aec43038f16d83c" providerId="LiveId" clId="{12088F07-8FE9-4FAA-9725-AFA2589A1C4F}" dt="2024-09-30T07:21:41.382" v="267" actId="1076"/>
          <ac:spMkLst>
            <pc:docMk/>
            <pc:sldMk cId="2293877723" sldId="274"/>
            <ac:spMk id="6" creationId="{C2789011-3C8E-8B5D-66CD-8FD17F6EA4C1}"/>
          </ac:spMkLst>
        </pc:spChg>
        <pc:spChg chg="add mod">
          <ac:chgData name="義章 谷口" userId="1aec43038f16d83c" providerId="LiveId" clId="{12088F07-8FE9-4FAA-9725-AFA2589A1C4F}" dt="2024-09-30T07:21:51.774" v="281" actId="20577"/>
          <ac:spMkLst>
            <pc:docMk/>
            <pc:sldMk cId="2293877723" sldId="274"/>
            <ac:spMk id="7" creationId="{2927179D-B983-FCC1-73A5-AAC975A745AE}"/>
          </ac:spMkLst>
        </pc:spChg>
        <pc:spChg chg="add mod">
          <ac:chgData name="義章 谷口" userId="1aec43038f16d83c" providerId="LiveId" clId="{12088F07-8FE9-4FAA-9725-AFA2589A1C4F}" dt="2024-09-30T07:23:56.880" v="341" actId="1076"/>
          <ac:spMkLst>
            <pc:docMk/>
            <pc:sldMk cId="2293877723" sldId="274"/>
            <ac:spMk id="8" creationId="{8F73B9B4-2F4E-D7AF-760E-95679F8EE759}"/>
          </ac:spMkLst>
        </pc:spChg>
        <pc:spChg chg="add mod">
          <ac:chgData name="義章 谷口" userId="1aec43038f16d83c" providerId="LiveId" clId="{12088F07-8FE9-4FAA-9725-AFA2589A1C4F}" dt="2024-10-04T02:59:54.806" v="886" actId="20577"/>
          <ac:spMkLst>
            <pc:docMk/>
            <pc:sldMk cId="2293877723" sldId="274"/>
            <ac:spMk id="9" creationId="{9B284E52-6549-90A5-1796-5C1065858106}"/>
          </ac:spMkLst>
        </pc:spChg>
        <pc:spChg chg="add mod">
          <ac:chgData name="義章 谷口" userId="1aec43038f16d83c" providerId="LiveId" clId="{12088F07-8FE9-4FAA-9725-AFA2589A1C4F}" dt="2024-10-02T06:27:09.339" v="599" actId="1038"/>
          <ac:spMkLst>
            <pc:docMk/>
            <pc:sldMk cId="2293877723" sldId="274"/>
            <ac:spMk id="10" creationId="{7AB7E352-A65D-40E6-9A29-B7BF489D5D8F}"/>
          </ac:spMkLst>
        </pc:spChg>
        <pc:spChg chg="add del mod">
          <ac:chgData name="義章 谷口" userId="1aec43038f16d83c" providerId="LiveId" clId="{12088F07-8FE9-4FAA-9725-AFA2589A1C4F}" dt="2024-10-02T06:35:38.368" v="877" actId="478"/>
          <ac:spMkLst>
            <pc:docMk/>
            <pc:sldMk cId="2293877723" sldId="274"/>
            <ac:spMk id="11" creationId="{446D7A52-045D-1929-48C5-509BA0222756}"/>
          </ac:spMkLst>
        </pc:spChg>
        <pc:picChg chg="add del mod">
          <ac:chgData name="義章 谷口" userId="1aec43038f16d83c" providerId="LiveId" clId="{12088F07-8FE9-4FAA-9725-AFA2589A1C4F}" dt="2024-10-02T06:20:24.437" v="393" actId="478"/>
          <ac:picMkLst>
            <pc:docMk/>
            <pc:sldMk cId="2293877723" sldId="274"/>
            <ac:picMk id="3" creationId="{2C39CFA4-989B-8102-0F68-8E9BAC3DC1C6}"/>
          </ac:picMkLst>
        </pc:picChg>
        <pc:picChg chg="add mod">
          <ac:chgData name="義章 谷口" userId="1aec43038f16d83c" providerId="LiveId" clId="{12088F07-8FE9-4FAA-9725-AFA2589A1C4F}" dt="2024-10-04T03:03:06.688" v="893" actId="14100"/>
          <ac:picMkLst>
            <pc:docMk/>
            <pc:sldMk cId="2293877723" sldId="274"/>
            <ac:picMk id="3" creationId="{B2D67136-2637-F9AF-AC35-14404FF1C391}"/>
          </ac:picMkLst>
        </pc:picChg>
        <pc:picChg chg="add del mod">
          <ac:chgData name="義章 谷口" userId="1aec43038f16d83c" providerId="LiveId" clId="{12088F07-8FE9-4FAA-9725-AFA2589A1C4F}" dt="2024-10-02T06:35:32.181" v="875" actId="478"/>
          <ac:picMkLst>
            <pc:docMk/>
            <pc:sldMk cId="2293877723" sldId="274"/>
            <ac:picMk id="4" creationId="{0BA4C76F-84C9-B81C-7EBC-8D384CB36611}"/>
          </ac:picMkLst>
        </pc:picChg>
        <pc:picChg chg="add del mod modCrop">
          <ac:chgData name="義章 谷口" userId="1aec43038f16d83c" providerId="LiveId" clId="{12088F07-8FE9-4FAA-9725-AFA2589A1C4F}" dt="2024-09-30T07:21:14.613" v="257" actId="478"/>
          <ac:picMkLst>
            <pc:docMk/>
            <pc:sldMk cId="2293877723" sldId="274"/>
            <ac:picMk id="5" creationId="{914D7134-F6B3-6DC0-7574-DB9CBFD12552}"/>
          </ac:picMkLst>
        </pc:picChg>
        <pc:picChg chg="add mod">
          <ac:chgData name="義章 谷口" userId="1aec43038f16d83c" providerId="LiveId" clId="{12088F07-8FE9-4FAA-9725-AFA2589A1C4F}" dt="2024-10-02T06:27:09.339" v="599" actId="1038"/>
          <ac:picMkLst>
            <pc:docMk/>
            <pc:sldMk cId="2293877723" sldId="274"/>
            <ac:picMk id="15" creationId="{AFC04D31-F049-4F01-9808-332973178E77}"/>
          </ac:picMkLst>
        </pc:picChg>
      </pc:sldChg>
      <pc:sldChg chg="addSp delSp modSp add del mod">
        <pc:chgData name="義章 谷口" userId="1aec43038f16d83c" providerId="LiveId" clId="{12088F07-8FE9-4FAA-9725-AFA2589A1C4F}" dt="2024-10-02T06:35:52.724" v="880" actId="47"/>
        <pc:sldMkLst>
          <pc:docMk/>
          <pc:sldMk cId="108652529" sldId="275"/>
        </pc:sldMkLst>
        <pc:spChg chg="del">
          <ac:chgData name="義章 谷口" userId="1aec43038f16d83c" providerId="LiveId" clId="{12088F07-8FE9-4FAA-9725-AFA2589A1C4F}" dt="2024-10-02T06:17:21.974" v="359" actId="478"/>
          <ac:spMkLst>
            <pc:docMk/>
            <pc:sldMk cId="108652529" sldId="275"/>
            <ac:spMk id="6" creationId="{C2789011-3C8E-8B5D-66CD-8FD17F6EA4C1}"/>
          </ac:spMkLst>
        </pc:spChg>
        <pc:spChg chg="del">
          <ac:chgData name="義章 谷口" userId="1aec43038f16d83c" providerId="LiveId" clId="{12088F07-8FE9-4FAA-9725-AFA2589A1C4F}" dt="2024-10-02T06:17:21.974" v="359" actId="478"/>
          <ac:spMkLst>
            <pc:docMk/>
            <pc:sldMk cId="108652529" sldId="275"/>
            <ac:spMk id="7" creationId="{2927179D-B983-FCC1-73A5-AAC975A745AE}"/>
          </ac:spMkLst>
        </pc:spChg>
        <pc:spChg chg="del">
          <ac:chgData name="義章 谷口" userId="1aec43038f16d83c" providerId="LiveId" clId="{12088F07-8FE9-4FAA-9725-AFA2589A1C4F}" dt="2024-10-02T06:17:21.974" v="359" actId="478"/>
          <ac:spMkLst>
            <pc:docMk/>
            <pc:sldMk cId="108652529" sldId="275"/>
            <ac:spMk id="8" creationId="{8F73B9B4-2F4E-D7AF-760E-95679F8EE759}"/>
          </ac:spMkLst>
        </pc:spChg>
        <pc:spChg chg="del">
          <ac:chgData name="義章 谷口" userId="1aec43038f16d83c" providerId="LiveId" clId="{12088F07-8FE9-4FAA-9725-AFA2589A1C4F}" dt="2024-10-02T06:17:21.974" v="359" actId="478"/>
          <ac:spMkLst>
            <pc:docMk/>
            <pc:sldMk cId="108652529" sldId="275"/>
            <ac:spMk id="9" creationId="{9B284E52-6549-90A5-1796-5C1065858106}"/>
          </ac:spMkLst>
        </pc:spChg>
        <pc:spChg chg="del">
          <ac:chgData name="義章 谷口" userId="1aec43038f16d83c" providerId="LiveId" clId="{12088F07-8FE9-4FAA-9725-AFA2589A1C4F}" dt="2024-10-02T06:17:21.974" v="359" actId="478"/>
          <ac:spMkLst>
            <pc:docMk/>
            <pc:sldMk cId="108652529" sldId="275"/>
            <ac:spMk id="10" creationId="{7AB7E352-A65D-40E6-9A29-B7BF489D5D8F}"/>
          </ac:spMkLst>
        </pc:spChg>
        <pc:picChg chg="mod">
          <ac:chgData name="義章 谷口" userId="1aec43038f16d83c" providerId="LiveId" clId="{12088F07-8FE9-4FAA-9725-AFA2589A1C4F}" dt="2024-10-02T06:19:21.696" v="386" actId="1035"/>
          <ac:picMkLst>
            <pc:docMk/>
            <pc:sldMk cId="108652529" sldId="275"/>
            <ac:picMk id="3" creationId="{2C39CFA4-989B-8102-0F68-8E9BAC3DC1C6}"/>
          </ac:picMkLst>
        </pc:picChg>
        <pc:picChg chg="add mod">
          <ac:chgData name="義章 谷口" userId="1aec43038f16d83c" providerId="LiveId" clId="{12088F07-8FE9-4FAA-9725-AFA2589A1C4F}" dt="2024-10-02T06:21:46.391" v="403" actId="14100"/>
          <ac:picMkLst>
            <pc:docMk/>
            <pc:sldMk cId="108652529" sldId="275"/>
            <ac:picMk id="4" creationId="{64FD0B9F-E834-2002-0CA2-FFE9B1432B36}"/>
          </ac:picMkLst>
        </pc:picChg>
        <pc:picChg chg="add mod">
          <ac:chgData name="義章 谷口" userId="1aec43038f16d83c" providerId="LiveId" clId="{12088F07-8FE9-4FAA-9725-AFA2589A1C4F}" dt="2024-10-02T06:19:17.425" v="383" actId="1036"/>
          <ac:picMkLst>
            <pc:docMk/>
            <pc:sldMk cId="108652529" sldId="275"/>
            <ac:picMk id="12" creationId="{C96C09E2-6409-CB97-BC33-7C79EB2F15F4}"/>
          </ac:picMkLst>
        </pc:picChg>
        <pc:picChg chg="del">
          <ac:chgData name="義章 谷口" userId="1aec43038f16d83c" providerId="LiveId" clId="{12088F07-8FE9-4FAA-9725-AFA2589A1C4F}" dt="2024-10-02T06:17:21.974" v="359" actId="478"/>
          <ac:picMkLst>
            <pc:docMk/>
            <pc:sldMk cId="108652529" sldId="275"/>
            <ac:picMk id="15" creationId="{AFC04D31-F049-4F01-9808-332973178E77}"/>
          </ac:picMkLst>
        </pc:picChg>
      </pc:sldChg>
      <pc:sldChg chg="addSp delSp modSp add del mod">
        <pc:chgData name="義章 谷口" userId="1aec43038f16d83c" providerId="LiveId" clId="{12088F07-8FE9-4FAA-9725-AFA2589A1C4F}" dt="2024-10-04T03:09:27.244" v="958" actId="1076"/>
        <pc:sldMkLst>
          <pc:docMk/>
          <pc:sldMk cId="2635950106" sldId="276"/>
        </pc:sldMkLst>
        <pc:spChg chg="add del mod">
          <ac:chgData name="義章 谷口" userId="1aec43038f16d83c" providerId="LiveId" clId="{12088F07-8FE9-4FAA-9725-AFA2589A1C4F}" dt="2024-10-02T06:23:35.503" v="414" actId="21"/>
          <ac:spMkLst>
            <pc:docMk/>
            <pc:sldMk cId="2635950106" sldId="276"/>
            <ac:spMk id="4" creationId="{69508C94-FBE1-13A2-3B5B-82804323C0E2}"/>
          </ac:spMkLst>
        </pc:spChg>
        <pc:spChg chg="del">
          <ac:chgData name="義章 谷口" userId="1aec43038f16d83c" providerId="LiveId" clId="{12088F07-8FE9-4FAA-9725-AFA2589A1C4F}" dt="2024-10-02T06:22:45.976" v="405" actId="478"/>
          <ac:spMkLst>
            <pc:docMk/>
            <pc:sldMk cId="2635950106" sldId="276"/>
            <ac:spMk id="7" creationId="{A0882C26-B928-3493-E48C-00D0FA8FA6E6}"/>
          </ac:spMkLst>
        </pc:spChg>
        <pc:spChg chg="del">
          <ac:chgData name="義章 谷口" userId="1aec43038f16d83c" providerId="LiveId" clId="{12088F07-8FE9-4FAA-9725-AFA2589A1C4F}" dt="2024-10-02T06:22:45.976" v="405" actId="478"/>
          <ac:spMkLst>
            <pc:docMk/>
            <pc:sldMk cId="2635950106" sldId="276"/>
            <ac:spMk id="8" creationId="{674A7F0F-0A17-F325-CFF3-A87B42430FE8}"/>
          </ac:spMkLst>
        </pc:spChg>
        <pc:spChg chg="del">
          <ac:chgData name="義章 谷口" userId="1aec43038f16d83c" providerId="LiveId" clId="{12088F07-8FE9-4FAA-9725-AFA2589A1C4F}" dt="2024-10-02T06:22:45.976" v="405" actId="478"/>
          <ac:spMkLst>
            <pc:docMk/>
            <pc:sldMk cId="2635950106" sldId="276"/>
            <ac:spMk id="9" creationId="{C3E33CAD-00AE-145B-ECD8-38DD05E6A66F}"/>
          </ac:spMkLst>
        </pc:spChg>
        <pc:spChg chg="del">
          <ac:chgData name="義章 谷口" userId="1aec43038f16d83c" providerId="LiveId" clId="{12088F07-8FE9-4FAA-9725-AFA2589A1C4F}" dt="2024-10-02T06:22:45.976" v="405" actId="478"/>
          <ac:spMkLst>
            <pc:docMk/>
            <pc:sldMk cId="2635950106" sldId="276"/>
            <ac:spMk id="10" creationId="{4503164E-8250-4717-3CC5-904154002B49}"/>
          </ac:spMkLst>
        </pc:spChg>
        <pc:spChg chg="del">
          <ac:chgData name="義章 谷口" userId="1aec43038f16d83c" providerId="LiveId" clId="{12088F07-8FE9-4FAA-9725-AFA2589A1C4F}" dt="2024-10-02T06:22:45.976" v="405" actId="478"/>
          <ac:spMkLst>
            <pc:docMk/>
            <pc:sldMk cId="2635950106" sldId="276"/>
            <ac:spMk id="11" creationId="{A933878E-80BF-5760-9140-E1A1C884C9C7}"/>
          </ac:spMkLst>
        </pc:spChg>
        <pc:picChg chg="add del mod">
          <ac:chgData name="義章 谷口" userId="1aec43038f16d83c" providerId="LiveId" clId="{12088F07-8FE9-4FAA-9725-AFA2589A1C4F}" dt="2024-10-02T06:23:35.503" v="414" actId="21"/>
          <ac:picMkLst>
            <pc:docMk/>
            <pc:sldMk cId="2635950106" sldId="276"/>
            <ac:picMk id="3" creationId="{0BA4C76F-84C9-B81C-7EBC-8D384CB36611}"/>
          </ac:picMkLst>
        </pc:picChg>
        <pc:picChg chg="add mod">
          <ac:chgData name="義章 谷口" userId="1aec43038f16d83c" providerId="LiveId" clId="{12088F07-8FE9-4FAA-9725-AFA2589A1C4F}" dt="2024-10-04T03:09:23.566" v="957" actId="14100"/>
          <ac:picMkLst>
            <pc:docMk/>
            <pc:sldMk cId="2635950106" sldId="276"/>
            <ac:picMk id="3" creationId="{84C77023-1714-1D20-A8B7-8539533DF88F}"/>
          </ac:picMkLst>
        </pc:picChg>
        <pc:picChg chg="add mod ord">
          <ac:chgData name="義章 谷口" userId="1aec43038f16d83c" providerId="LiveId" clId="{12088F07-8FE9-4FAA-9725-AFA2589A1C4F}" dt="2024-10-04T03:09:00.603" v="956" actId="1076"/>
          <ac:picMkLst>
            <pc:docMk/>
            <pc:sldMk cId="2635950106" sldId="276"/>
            <ac:picMk id="5" creationId="{A44F0F74-EA5F-D1B2-0669-FADC7265BA6E}"/>
          </ac:picMkLst>
        </pc:picChg>
        <pc:picChg chg="add mod">
          <ac:chgData name="義章 谷口" userId="1aec43038f16d83c" providerId="LiveId" clId="{12088F07-8FE9-4FAA-9725-AFA2589A1C4F}" dt="2024-10-04T03:09:27.244" v="958" actId="1076"/>
          <ac:picMkLst>
            <pc:docMk/>
            <pc:sldMk cId="2635950106" sldId="276"/>
            <ac:picMk id="8" creationId="{1C103DF1-5CDD-4CA5-91C0-8BCEB032C904}"/>
          </ac:picMkLst>
        </pc:picChg>
        <pc:picChg chg="add mod">
          <ac:chgData name="義章 谷口" userId="1aec43038f16d83c" providerId="LiveId" clId="{12088F07-8FE9-4FAA-9725-AFA2589A1C4F}" dt="2024-10-04T03:08:24.102" v="945" actId="1076"/>
          <ac:picMkLst>
            <pc:docMk/>
            <pc:sldMk cId="2635950106" sldId="276"/>
            <ac:picMk id="10" creationId="{C892FADD-D2F5-31B0-F149-9870161088BC}"/>
          </ac:picMkLst>
        </pc:picChg>
        <pc:picChg chg="add del mod">
          <ac:chgData name="義章 谷口" userId="1aec43038f16d83c" providerId="LiveId" clId="{12088F07-8FE9-4FAA-9725-AFA2589A1C4F}" dt="2024-10-04T03:06:46.343" v="916" actId="478"/>
          <ac:picMkLst>
            <pc:docMk/>
            <pc:sldMk cId="2635950106" sldId="276"/>
            <ac:picMk id="12" creationId="{184439B6-7E85-083F-CF6A-A488AD8EEE07}"/>
          </ac:picMkLst>
        </pc:picChg>
        <pc:picChg chg="add del mod">
          <ac:chgData name="義章 谷口" userId="1aec43038f16d83c" providerId="LiveId" clId="{12088F07-8FE9-4FAA-9725-AFA2589A1C4F}" dt="2024-10-04T03:06:45.797" v="915" actId="478"/>
          <ac:picMkLst>
            <pc:docMk/>
            <pc:sldMk cId="2635950106" sldId="276"/>
            <ac:picMk id="14" creationId="{34A987A7-930C-1BAB-B680-B6ECEC80DA89}"/>
          </ac:picMkLst>
        </pc:picChg>
        <pc:picChg chg="add del mod">
          <ac:chgData name="義章 谷口" userId="1aec43038f16d83c" providerId="LiveId" clId="{12088F07-8FE9-4FAA-9725-AFA2589A1C4F}" dt="2024-10-04T03:06:45.098" v="914" actId="478"/>
          <ac:picMkLst>
            <pc:docMk/>
            <pc:sldMk cId="2635950106" sldId="276"/>
            <ac:picMk id="16" creationId="{B04C2481-9EBF-7122-516D-BACE3E0EF4DB}"/>
          </ac:picMkLst>
        </pc:picChg>
        <pc:picChg chg="add del mod">
          <ac:chgData name="義章 谷口" userId="1aec43038f16d83c" providerId="LiveId" clId="{12088F07-8FE9-4FAA-9725-AFA2589A1C4F}" dt="2024-10-04T03:06:45.098" v="914" actId="478"/>
          <ac:picMkLst>
            <pc:docMk/>
            <pc:sldMk cId="2635950106" sldId="276"/>
            <ac:picMk id="18" creationId="{6A22276C-8905-C097-4E59-875FD6420C94}"/>
          </ac:picMkLst>
        </pc:picChg>
        <pc:picChg chg="del">
          <ac:chgData name="義章 谷口" userId="1aec43038f16d83c" providerId="LiveId" clId="{12088F07-8FE9-4FAA-9725-AFA2589A1C4F}" dt="2024-10-02T06:22:45.976" v="405" actId="478"/>
          <ac:picMkLst>
            <pc:docMk/>
            <pc:sldMk cId="2635950106" sldId="276"/>
            <ac:picMk id="20" creationId="{86E0AE4B-7D7C-49E6-B560-AAE2C5179530}"/>
          </ac:picMkLst>
        </pc:picChg>
      </pc:sldChg>
      <pc:sldChg chg="addSp delSp modSp new del mod">
        <pc:chgData name="義章 谷口" userId="1aec43038f16d83c" providerId="LiveId" clId="{12088F07-8FE9-4FAA-9725-AFA2589A1C4F}" dt="2024-10-09T13:01:44.652" v="962" actId="47"/>
        <pc:sldMkLst>
          <pc:docMk/>
          <pc:sldMk cId="1890526335" sldId="277"/>
        </pc:sldMkLst>
        <pc:spChg chg="del">
          <ac:chgData name="義章 谷口" userId="1aec43038f16d83c" providerId="LiveId" clId="{12088F07-8FE9-4FAA-9725-AFA2589A1C4F}" dt="2024-10-02T06:34:43.882" v="821" actId="478"/>
          <ac:spMkLst>
            <pc:docMk/>
            <pc:sldMk cId="1890526335" sldId="277"/>
            <ac:spMk id="2" creationId="{2A5C6A2C-E7F8-2D8C-0235-61452D22D470}"/>
          </ac:spMkLst>
        </pc:spChg>
        <pc:spChg chg="del">
          <ac:chgData name="義章 谷口" userId="1aec43038f16d83c" providerId="LiveId" clId="{12088F07-8FE9-4FAA-9725-AFA2589A1C4F}" dt="2024-10-02T06:34:43.882" v="821" actId="478"/>
          <ac:spMkLst>
            <pc:docMk/>
            <pc:sldMk cId="1890526335" sldId="277"/>
            <ac:spMk id="3" creationId="{9AAC7532-6556-E8B9-4AA6-A1AE33443666}"/>
          </ac:spMkLst>
        </pc:spChg>
        <pc:spChg chg="add mod">
          <ac:chgData name="義章 谷口" userId="1aec43038f16d83c" providerId="LiveId" clId="{12088F07-8FE9-4FAA-9725-AFA2589A1C4F}" dt="2024-10-02T06:35:23.307" v="874" actId="1076"/>
          <ac:spMkLst>
            <pc:docMk/>
            <pc:sldMk cId="1890526335" sldId="277"/>
            <ac:spMk id="4" creationId="{062B1C7C-B5A7-137D-1CE9-76146316448C}"/>
          </ac:spMkLst>
        </pc:spChg>
      </pc:sldChg>
      <pc:sldMasterChg chg="modSp modSldLayout">
        <pc:chgData name="義章 谷口" userId="1aec43038f16d83c" providerId="LiveId" clId="{12088F07-8FE9-4FAA-9725-AFA2589A1C4F}" dt="2024-09-30T02:26:23.826" v="11"/>
        <pc:sldMasterMkLst>
          <pc:docMk/>
          <pc:sldMasterMk cId="2119435020" sldId="2147483660"/>
        </pc:sldMasterMkLst>
        <pc:spChg chg="mod">
          <ac:chgData name="義章 谷口" userId="1aec43038f16d83c" providerId="LiveId" clId="{12088F07-8FE9-4FAA-9725-AFA2589A1C4F}" dt="2024-09-30T02:26:23.826" v="11"/>
          <ac:spMkLst>
            <pc:docMk/>
            <pc:sldMasterMk cId="2119435020" sldId="2147483660"/>
            <ac:spMk id="2" creationId="{00000000-0000-0000-0000-000000000000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asterMk cId="2119435020" sldId="2147483660"/>
            <ac:spMk id="3" creationId="{00000000-0000-0000-0000-000000000000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asterMk cId="2119435020" sldId="2147483660"/>
            <ac:spMk id="4" creationId="{00000000-0000-0000-0000-000000000000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asterMk cId="2119435020" sldId="2147483660"/>
            <ac:spMk id="5" creationId="{00000000-0000-0000-0000-000000000000}"/>
          </ac:spMkLst>
        </pc:spChg>
        <pc:spChg chg="mod">
          <ac:chgData name="義章 谷口" userId="1aec43038f16d83c" providerId="LiveId" clId="{12088F07-8FE9-4FAA-9725-AFA2589A1C4F}" dt="2024-09-30T02:26:23.826" v="11"/>
          <ac:spMkLst>
            <pc:docMk/>
            <pc:sldMasterMk cId="2119435020" sldId="2147483660"/>
            <ac:spMk id="6" creationId="{00000000-0000-0000-0000-000000000000}"/>
          </ac:spMkLst>
        </pc:spChg>
        <pc:sldLayoutChg chg="modSp">
          <pc:chgData name="義章 谷口" userId="1aec43038f16d83c" providerId="LiveId" clId="{12088F07-8FE9-4FAA-9725-AFA2589A1C4F}" dt="2024-09-30T02:26:23.826" v="11"/>
          <pc:sldLayoutMkLst>
            <pc:docMk/>
            <pc:sldMasterMk cId="2119435020" sldId="2147483660"/>
            <pc:sldLayoutMk cId="1406119903" sldId="2147483661"/>
          </pc:sldLayoutMkLst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1406119903" sldId="2147483661"/>
              <ac:spMk id="2" creationId="{00000000-0000-0000-0000-000000000000}"/>
            </ac:spMkLst>
          </pc:spChg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1406119903" sldId="2147483661"/>
              <ac:spMk id="3" creationId="{00000000-0000-0000-0000-000000000000}"/>
            </ac:spMkLst>
          </pc:spChg>
        </pc:sldLayoutChg>
        <pc:sldLayoutChg chg="modSp">
          <pc:chgData name="義章 谷口" userId="1aec43038f16d83c" providerId="LiveId" clId="{12088F07-8FE9-4FAA-9725-AFA2589A1C4F}" dt="2024-09-30T02:26:23.826" v="11"/>
          <pc:sldLayoutMkLst>
            <pc:docMk/>
            <pc:sldMasterMk cId="2119435020" sldId="2147483660"/>
            <pc:sldLayoutMk cId="4178129054" sldId="2147483663"/>
          </pc:sldLayoutMkLst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4178129054" sldId="2147483663"/>
              <ac:spMk id="2" creationId="{00000000-0000-0000-0000-000000000000}"/>
            </ac:spMkLst>
          </pc:spChg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4178129054" sldId="2147483663"/>
              <ac:spMk id="3" creationId="{00000000-0000-0000-0000-000000000000}"/>
            </ac:spMkLst>
          </pc:spChg>
        </pc:sldLayoutChg>
        <pc:sldLayoutChg chg="modSp">
          <pc:chgData name="義章 谷口" userId="1aec43038f16d83c" providerId="LiveId" clId="{12088F07-8FE9-4FAA-9725-AFA2589A1C4F}" dt="2024-09-30T02:26:23.826" v="11"/>
          <pc:sldLayoutMkLst>
            <pc:docMk/>
            <pc:sldMasterMk cId="2119435020" sldId="2147483660"/>
            <pc:sldLayoutMk cId="99431929" sldId="2147483664"/>
          </pc:sldLayoutMkLst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99431929" sldId="2147483664"/>
              <ac:spMk id="3" creationId="{00000000-0000-0000-0000-000000000000}"/>
            </ac:spMkLst>
          </pc:spChg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99431929" sldId="2147483664"/>
              <ac:spMk id="4" creationId="{00000000-0000-0000-0000-000000000000}"/>
            </ac:spMkLst>
          </pc:spChg>
        </pc:sldLayoutChg>
        <pc:sldLayoutChg chg="modSp">
          <pc:chgData name="義章 谷口" userId="1aec43038f16d83c" providerId="LiveId" clId="{12088F07-8FE9-4FAA-9725-AFA2589A1C4F}" dt="2024-09-30T02:26:23.826" v="11"/>
          <pc:sldLayoutMkLst>
            <pc:docMk/>
            <pc:sldMasterMk cId="2119435020" sldId="2147483660"/>
            <pc:sldLayoutMk cId="2614824820" sldId="2147483665"/>
          </pc:sldLayoutMkLst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2614824820" sldId="2147483665"/>
              <ac:spMk id="2" creationId="{00000000-0000-0000-0000-000000000000}"/>
            </ac:spMkLst>
          </pc:spChg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2614824820" sldId="2147483665"/>
              <ac:spMk id="3" creationId="{00000000-0000-0000-0000-000000000000}"/>
            </ac:spMkLst>
          </pc:spChg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2614824820" sldId="2147483665"/>
              <ac:spMk id="4" creationId="{00000000-0000-0000-0000-000000000000}"/>
            </ac:spMkLst>
          </pc:spChg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2614824820" sldId="2147483665"/>
              <ac:spMk id="5" creationId="{00000000-0000-0000-0000-000000000000}"/>
            </ac:spMkLst>
          </pc:spChg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2614824820" sldId="2147483665"/>
              <ac:spMk id="6" creationId="{00000000-0000-0000-0000-000000000000}"/>
            </ac:spMkLst>
          </pc:spChg>
        </pc:sldLayoutChg>
        <pc:sldLayoutChg chg="modSp">
          <pc:chgData name="義章 谷口" userId="1aec43038f16d83c" providerId="LiveId" clId="{12088F07-8FE9-4FAA-9725-AFA2589A1C4F}" dt="2024-09-30T02:26:23.826" v="11"/>
          <pc:sldLayoutMkLst>
            <pc:docMk/>
            <pc:sldMasterMk cId="2119435020" sldId="2147483660"/>
            <pc:sldLayoutMk cId="3717805293" sldId="2147483668"/>
          </pc:sldLayoutMkLst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3717805293" sldId="2147483668"/>
              <ac:spMk id="2" creationId="{00000000-0000-0000-0000-000000000000}"/>
            </ac:spMkLst>
          </pc:spChg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3717805293" sldId="2147483668"/>
              <ac:spMk id="3" creationId="{00000000-0000-0000-0000-000000000000}"/>
            </ac:spMkLst>
          </pc:spChg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3717805293" sldId="2147483668"/>
              <ac:spMk id="4" creationId="{00000000-0000-0000-0000-000000000000}"/>
            </ac:spMkLst>
          </pc:spChg>
        </pc:sldLayoutChg>
        <pc:sldLayoutChg chg="modSp">
          <pc:chgData name="義章 谷口" userId="1aec43038f16d83c" providerId="LiveId" clId="{12088F07-8FE9-4FAA-9725-AFA2589A1C4F}" dt="2024-09-30T02:26:23.826" v="11"/>
          <pc:sldLayoutMkLst>
            <pc:docMk/>
            <pc:sldMasterMk cId="2119435020" sldId="2147483660"/>
            <pc:sldLayoutMk cId="1340487666" sldId="2147483669"/>
          </pc:sldLayoutMkLst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1340487666" sldId="2147483669"/>
              <ac:spMk id="2" creationId="{00000000-0000-0000-0000-000000000000}"/>
            </ac:spMkLst>
          </pc:spChg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1340487666" sldId="2147483669"/>
              <ac:spMk id="3" creationId="{00000000-0000-0000-0000-000000000000}"/>
            </ac:spMkLst>
          </pc:spChg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1340487666" sldId="2147483669"/>
              <ac:spMk id="4" creationId="{00000000-0000-0000-0000-000000000000}"/>
            </ac:spMkLst>
          </pc:spChg>
        </pc:sldLayoutChg>
        <pc:sldLayoutChg chg="modSp">
          <pc:chgData name="義章 谷口" userId="1aec43038f16d83c" providerId="LiveId" clId="{12088F07-8FE9-4FAA-9725-AFA2589A1C4F}" dt="2024-09-30T02:26:23.826" v="11"/>
          <pc:sldLayoutMkLst>
            <pc:docMk/>
            <pc:sldMasterMk cId="2119435020" sldId="2147483660"/>
            <pc:sldLayoutMk cId="2834150510" sldId="2147483671"/>
          </pc:sldLayoutMkLst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2834150510" sldId="2147483671"/>
              <ac:spMk id="2" creationId="{00000000-0000-0000-0000-000000000000}"/>
            </ac:spMkLst>
          </pc:spChg>
          <pc:spChg chg="mod">
            <ac:chgData name="義章 谷口" userId="1aec43038f16d83c" providerId="LiveId" clId="{12088F07-8FE9-4FAA-9725-AFA2589A1C4F}" dt="2024-09-30T02:26:23.826" v="11"/>
            <ac:spMkLst>
              <pc:docMk/>
              <pc:sldMasterMk cId="2119435020" sldId="2147483660"/>
              <pc:sldLayoutMk cId="2834150510" sldId="2147483671"/>
              <ac:spMk id="3" creationId="{00000000-0000-0000-0000-000000000000}"/>
            </ac:spMkLst>
          </pc:spChg>
        </pc:sldLayoutChg>
      </pc:sldMasterChg>
    </pc:docChg>
  </pc:docChgLst>
  <pc:docChgLst>
    <pc:chgData name="義章 谷口" userId="1aec43038f16d83c" providerId="LiveId" clId="{D6A9376D-9D12-48CF-AAB9-E574FDE2BAEE}"/>
    <pc:docChg chg="undo custSel addSld delSld modSld delMainMaster modMainMaster">
      <pc:chgData name="義章 谷口" userId="1aec43038f16d83c" providerId="LiveId" clId="{D6A9376D-9D12-48CF-AAB9-E574FDE2BAEE}" dt="2024-05-01T06:15:16.426" v="754" actId="20577"/>
      <pc:docMkLst>
        <pc:docMk/>
      </pc:docMkLst>
      <pc:sldChg chg="delSp new del mod">
        <pc:chgData name="義章 谷口" userId="1aec43038f16d83c" providerId="LiveId" clId="{D6A9376D-9D12-48CF-AAB9-E574FDE2BAEE}" dt="2024-04-22T01:16:38.279" v="3" actId="47"/>
        <pc:sldMkLst>
          <pc:docMk/>
          <pc:sldMk cId="994203111" sldId="256"/>
        </pc:sldMkLst>
        <pc:spChg chg="del">
          <ac:chgData name="義章 谷口" userId="1aec43038f16d83c" providerId="LiveId" clId="{D6A9376D-9D12-48CF-AAB9-E574FDE2BAEE}" dt="2024-04-22T01:16:21.351" v="2" actId="478"/>
          <ac:spMkLst>
            <pc:docMk/>
            <pc:sldMk cId="994203111" sldId="256"/>
            <ac:spMk id="2" creationId="{ECABE237-E5C6-0043-4C5B-9BD2B5C47E0E}"/>
          </ac:spMkLst>
        </pc:spChg>
        <pc:spChg chg="del">
          <ac:chgData name="義章 谷口" userId="1aec43038f16d83c" providerId="LiveId" clId="{D6A9376D-9D12-48CF-AAB9-E574FDE2BAEE}" dt="2024-04-22T01:16:21.351" v="2" actId="478"/>
          <ac:spMkLst>
            <pc:docMk/>
            <pc:sldMk cId="994203111" sldId="256"/>
            <ac:spMk id="3" creationId="{05E907C8-AE75-6BF9-C2AE-982F5DD479B8}"/>
          </ac:spMkLst>
        </pc:spChg>
      </pc:sldChg>
      <pc:sldChg chg="addSp delSp modSp mod modNotesTx">
        <pc:chgData name="義章 谷口" userId="1aec43038f16d83c" providerId="LiveId" clId="{D6A9376D-9D12-48CF-AAB9-E574FDE2BAEE}" dt="2024-04-23T08:43:15.663" v="742" actId="1076"/>
        <pc:sldMkLst>
          <pc:docMk/>
          <pc:sldMk cId="2842446160" sldId="262"/>
        </pc:sldMkLst>
        <pc:picChg chg="add del mod modCrop">
          <ac:chgData name="義章 谷口" userId="1aec43038f16d83c" providerId="LiveId" clId="{D6A9376D-9D12-48CF-AAB9-E574FDE2BAEE}" dt="2024-04-22T09:37:44.387" v="557" actId="478"/>
          <ac:picMkLst>
            <pc:docMk/>
            <pc:sldMk cId="2842446160" sldId="262"/>
            <ac:picMk id="3" creationId="{1A3D4CE8-C88F-178E-D918-A3C765BC9669}"/>
          </ac:picMkLst>
        </pc:picChg>
        <pc:picChg chg="add mod modCrop">
          <ac:chgData name="義章 谷口" userId="1aec43038f16d83c" providerId="LiveId" clId="{D6A9376D-9D12-48CF-AAB9-E574FDE2BAEE}" dt="2024-04-22T09:42:07.677" v="642" actId="1076"/>
          <ac:picMkLst>
            <pc:docMk/>
            <pc:sldMk cId="2842446160" sldId="262"/>
            <ac:picMk id="4" creationId="{DE590EA8-E0EB-F4D7-F960-39403F135AAF}"/>
          </ac:picMkLst>
        </pc:picChg>
        <pc:picChg chg="add mod modCrop">
          <ac:chgData name="義章 谷口" userId="1aec43038f16d83c" providerId="LiveId" clId="{D6A9376D-9D12-48CF-AAB9-E574FDE2BAEE}" dt="2024-04-23T08:43:15.663" v="742" actId="1076"/>
          <ac:picMkLst>
            <pc:docMk/>
            <pc:sldMk cId="2842446160" sldId="262"/>
            <ac:picMk id="5" creationId="{1D2CF956-7462-D0C6-D011-723708AFCA72}"/>
          </ac:picMkLst>
        </pc:picChg>
        <pc:picChg chg="del">
          <ac:chgData name="義章 谷口" userId="1aec43038f16d83c" providerId="LiveId" clId="{D6A9376D-9D12-48CF-AAB9-E574FDE2BAEE}" dt="2024-04-22T01:17:11.907" v="4" actId="478"/>
          <ac:picMkLst>
            <pc:docMk/>
            <pc:sldMk cId="2842446160" sldId="262"/>
            <ac:picMk id="5" creationId="{8FE1ACA1-35BE-6EAB-F1B1-7C0336F8B3CB}"/>
          </ac:picMkLst>
        </pc:picChg>
        <pc:picChg chg="add mod ord">
          <ac:chgData name="義章 谷口" userId="1aec43038f16d83c" providerId="LiveId" clId="{D6A9376D-9D12-48CF-AAB9-E574FDE2BAEE}" dt="2024-04-23T08:43:06.811" v="741" actId="167"/>
          <ac:picMkLst>
            <pc:docMk/>
            <pc:sldMk cId="2842446160" sldId="262"/>
            <ac:picMk id="6" creationId="{8CE904EC-AA62-602B-AAFA-85201550FF21}"/>
          </ac:picMkLst>
        </pc:picChg>
        <pc:picChg chg="mod">
          <ac:chgData name="義章 谷口" userId="1aec43038f16d83c" providerId="LiveId" clId="{D6A9376D-9D12-48CF-AAB9-E574FDE2BAEE}" dt="2024-04-22T06:31:00.123" v="74" actId="1076"/>
          <ac:picMkLst>
            <pc:docMk/>
            <pc:sldMk cId="2842446160" sldId="262"/>
            <ac:picMk id="7" creationId="{45951C39-A25A-A5D2-7018-0FD72B3C7385}"/>
          </ac:picMkLst>
        </pc:picChg>
        <pc:picChg chg="del">
          <ac:chgData name="義章 谷口" userId="1aec43038f16d83c" providerId="LiveId" clId="{D6A9376D-9D12-48CF-AAB9-E574FDE2BAEE}" dt="2024-04-22T06:31:08.577" v="76" actId="478"/>
          <ac:picMkLst>
            <pc:docMk/>
            <pc:sldMk cId="2842446160" sldId="262"/>
            <ac:picMk id="9" creationId="{FAC063EC-CF06-5402-D956-C05A90411CF3}"/>
          </ac:picMkLst>
        </pc:picChg>
      </pc:sldChg>
      <pc:sldChg chg="addSp delSp modSp add mod modNotesTx">
        <pc:chgData name="義章 谷口" userId="1aec43038f16d83c" providerId="LiveId" clId="{D6A9376D-9D12-48CF-AAB9-E574FDE2BAEE}" dt="2024-05-01T06:15:16.426" v="754" actId="20577"/>
        <pc:sldMkLst>
          <pc:docMk/>
          <pc:sldMk cId="3232284875" sldId="263"/>
        </pc:sldMkLst>
        <pc:spChg chg="mod">
          <ac:chgData name="義章 谷口" userId="1aec43038f16d83c" providerId="LiveId" clId="{D6A9376D-9D12-48CF-AAB9-E574FDE2BAEE}" dt="2024-04-22T06:31:33.484" v="88" actId="20577"/>
          <ac:spMkLst>
            <pc:docMk/>
            <pc:sldMk cId="3232284875" sldId="263"/>
            <ac:spMk id="23" creationId="{57E6EE92-62BA-B75C-B079-F7D7BB941FBB}"/>
          </ac:spMkLst>
        </pc:spChg>
        <pc:spChg chg="mod">
          <ac:chgData name="義章 谷口" userId="1aec43038f16d83c" providerId="LiveId" clId="{D6A9376D-9D12-48CF-AAB9-E574FDE2BAEE}" dt="2024-04-22T06:31:36.028" v="90" actId="20577"/>
          <ac:spMkLst>
            <pc:docMk/>
            <pc:sldMk cId="3232284875" sldId="263"/>
            <ac:spMk id="26" creationId="{6E2C7D79-A425-E780-6BA5-BE2B5E30959E}"/>
          </ac:spMkLst>
        </pc:spChg>
        <pc:spChg chg="mod">
          <ac:chgData name="義章 谷口" userId="1aec43038f16d83c" providerId="LiveId" clId="{D6A9376D-9D12-48CF-AAB9-E574FDE2BAEE}" dt="2024-04-22T06:31:38.843" v="92" actId="20577"/>
          <ac:spMkLst>
            <pc:docMk/>
            <pc:sldMk cId="3232284875" sldId="263"/>
            <ac:spMk id="27" creationId="{9D786531-DD72-746A-3A95-97B38B4F97E2}"/>
          </ac:spMkLst>
        </pc:spChg>
        <pc:spChg chg="mod">
          <ac:chgData name="義章 谷口" userId="1aec43038f16d83c" providerId="LiveId" clId="{D6A9376D-9D12-48CF-AAB9-E574FDE2BAEE}" dt="2024-04-22T06:31:41.201" v="94" actId="20577"/>
          <ac:spMkLst>
            <pc:docMk/>
            <pc:sldMk cId="3232284875" sldId="263"/>
            <ac:spMk id="28" creationId="{55423702-8442-6043-F030-C53F3DC94135}"/>
          </ac:spMkLst>
        </pc:spChg>
        <pc:picChg chg="add mod modCrop">
          <ac:chgData name="義章 谷口" userId="1aec43038f16d83c" providerId="LiveId" clId="{D6A9376D-9D12-48CF-AAB9-E574FDE2BAEE}" dt="2024-04-22T09:12:48.939" v="289" actId="1076"/>
          <ac:picMkLst>
            <pc:docMk/>
            <pc:sldMk cId="3232284875" sldId="263"/>
            <ac:picMk id="3" creationId="{BBA8BE2B-C1B0-974F-0E30-C0BEF794D506}"/>
          </ac:picMkLst>
        </pc:picChg>
        <pc:picChg chg="add mod modCrop">
          <ac:chgData name="義章 谷口" userId="1aec43038f16d83c" providerId="LiveId" clId="{D6A9376D-9D12-48CF-AAB9-E574FDE2BAEE}" dt="2024-04-26T07:19:27.066" v="746" actId="1076"/>
          <ac:picMkLst>
            <pc:docMk/>
            <pc:sldMk cId="3232284875" sldId="263"/>
            <ac:picMk id="5" creationId="{E37AE6E5-E919-D978-8203-946EE2741423}"/>
          </ac:picMkLst>
        </pc:picChg>
        <pc:picChg chg="add del mod">
          <ac:chgData name="義章 谷口" userId="1aec43038f16d83c" providerId="LiveId" clId="{D6A9376D-9D12-48CF-AAB9-E574FDE2BAEE}" dt="2024-04-22T09:37:39.883" v="556" actId="21"/>
          <ac:picMkLst>
            <pc:docMk/>
            <pc:sldMk cId="3232284875" sldId="263"/>
            <ac:picMk id="6" creationId="{8CE904EC-AA62-602B-AAFA-85201550FF21}"/>
          </ac:picMkLst>
        </pc:picChg>
        <pc:picChg chg="del">
          <ac:chgData name="義章 谷口" userId="1aec43038f16d83c" providerId="LiveId" clId="{D6A9376D-9D12-48CF-AAB9-E574FDE2BAEE}" dt="2024-04-22T06:31:10.469" v="77" actId="478"/>
          <ac:picMkLst>
            <pc:docMk/>
            <pc:sldMk cId="3232284875" sldId="263"/>
            <ac:picMk id="7" creationId="{45951C39-A25A-A5D2-7018-0FD72B3C7385}"/>
          </ac:picMkLst>
        </pc:picChg>
        <pc:picChg chg="mod">
          <ac:chgData name="義章 谷口" userId="1aec43038f16d83c" providerId="LiveId" clId="{D6A9376D-9D12-48CF-AAB9-E574FDE2BAEE}" dt="2024-04-22T08:34:22.750" v="109" actId="1035"/>
          <ac:picMkLst>
            <pc:docMk/>
            <pc:sldMk cId="3232284875" sldId="263"/>
            <ac:picMk id="9" creationId="{FAC063EC-CF06-5402-D956-C05A90411CF3}"/>
          </ac:picMkLst>
        </pc:picChg>
        <pc:picChg chg="add mod modCrop">
          <ac:chgData name="義章 谷口" userId="1aec43038f16d83c" providerId="LiveId" clId="{D6A9376D-9D12-48CF-AAB9-E574FDE2BAEE}" dt="2024-04-26T07:19:12.906" v="745" actId="1076"/>
          <ac:picMkLst>
            <pc:docMk/>
            <pc:sldMk cId="3232284875" sldId="263"/>
            <ac:picMk id="14" creationId="{6F4FF591-58DC-D49A-346C-9F3B54D70680}"/>
          </ac:picMkLst>
        </pc:picChg>
      </pc:sldChg>
      <pc:sldChg chg="addSp delSp modSp new del mod">
        <pc:chgData name="義章 谷口" userId="1aec43038f16d83c" providerId="LiveId" clId="{D6A9376D-9D12-48CF-AAB9-E574FDE2BAEE}" dt="2024-05-01T05:11:04.249" v="752" actId="47"/>
        <pc:sldMkLst>
          <pc:docMk/>
          <pc:sldMk cId="961551407" sldId="264"/>
        </pc:sldMkLst>
        <pc:spChg chg="del">
          <ac:chgData name="義章 谷口" userId="1aec43038f16d83c" providerId="LiveId" clId="{D6A9376D-9D12-48CF-AAB9-E574FDE2BAEE}" dt="2024-04-22T09:01:26.716" v="111" actId="478"/>
          <ac:spMkLst>
            <pc:docMk/>
            <pc:sldMk cId="961551407" sldId="264"/>
            <ac:spMk id="2" creationId="{B591017E-F502-0888-67BA-7D0F8340D2AC}"/>
          </ac:spMkLst>
        </pc:spChg>
        <pc:spChg chg="del">
          <ac:chgData name="義章 谷口" userId="1aec43038f16d83c" providerId="LiveId" clId="{D6A9376D-9D12-48CF-AAB9-E574FDE2BAEE}" dt="2024-04-22T09:01:26.716" v="111" actId="478"/>
          <ac:spMkLst>
            <pc:docMk/>
            <pc:sldMk cId="961551407" sldId="264"/>
            <ac:spMk id="3" creationId="{FB14F777-796A-EF2B-F276-69E80F571B8F}"/>
          </ac:spMkLst>
        </pc:spChg>
        <pc:spChg chg="add mod">
          <ac:chgData name="義章 谷口" userId="1aec43038f16d83c" providerId="LiveId" clId="{D6A9376D-9D12-48CF-AAB9-E574FDE2BAEE}" dt="2024-04-22T09:44:07.387" v="686" actId="20577"/>
          <ac:spMkLst>
            <pc:docMk/>
            <pc:sldMk cId="961551407" sldId="264"/>
            <ac:spMk id="6" creationId="{1D5DA23C-F8E4-AE72-DF90-AAA21912C910}"/>
          </ac:spMkLst>
        </pc:spChg>
        <pc:spChg chg="add del mod">
          <ac:chgData name="義章 谷口" userId="1aec43038f16d83c" providerId="LiveId" clId="{D6A9376D-9D12-48CF-AAB9-E574FDE2BAEE}" dt="2024-04-22T09:32:36.615" v="504" actId="478"/>
          <ac:spMkLst>
            <pc:docMk/>
            <pc:sldMk cId="961551407" sldId="264"/>
            <ac:spMk id="7" creationId="{5937C74A-626F-506F-B14C-A24BD9AB8C00}"/>
          </ac:spMkLst>
        </pc:spChg>
        <pc:spChg chg="add mod">
          <ac:chgData name="義章 谷口" userId="1aec43038f16d83c" providerId="LiveId" clId="{D6A9376D-9D12-48CF-AAB9-E574FDE2BAEE}" dt="2024-04-22T09:44:34.096" v="693" actId="1076"/>
          <ac:spMkLst>
            <pc:docMk/>
            <pc:sldMk cId="961551407" sldId="264"/>
            <ac:spMk id="8" creationId="{7F2BCE38-45D8-F73E-379A-42D65B2129DC}"/>
          </ac:spMkLst>
        </pc:spChg>
        <pc:spChg chg="add mod">
          <ac:chgData name="義章 谷口" userId="1aec43038f16d83c" providerId="LiveId" clId="{D6A9376D-9D12-48CF-AAB9-E574FDE2BAEE}" dt="2024-04-22T09:15:53.515" v="319" actId="1076"/>
          <ac:spMkLst>
            <pc:docMk/>
            <pc:sldMk cId="961551407" sldId="264"/>
            <ac:spMk id="9" creationId="{45A00003-F3FE-26D5-8B4C-0F69139DA3A8}"/>
          </ac:spMkLst>
        </pc:spChg>
        <pc:spChg chg="add mod">
          <ac:chgData name="義章 谷口" userId="1aec43038f16d83c" providerId="LiveId" clId="{D6A9376D-9D12-48CF-AAB9-E574FDE2BAEE}" dt="2024-04-22T09:10:50.151" v="281" actId="14100"/>
          <ac:spMkLst>
            <pc:docMk/>
            <pc:sldMk cId="961551407" sldId="264"/>
            <ac:spMk id="10" creationId="{76E11226-F10C-412B-CF78-EBF1AF86B1DC}"/>
          </ac:spMkLst>
        </pc:spChg>
        <pc:spChg chg="add mod">
          <ac:chgData name="義章 谷口" userId="1aec43038f16d83c" providerId="LiveId" clId="{D6A9376D-9D12-48CF-AAB9-E574FDE2BAEE}" dt="2024-04-22T09:44:38.515" v="694" actId="1076"/>
          <ac:spMkLst>
            <pc:docMk/>
            <pc:sldMk cId="961551407" sldId="264"/>
            <ac:spMk id="17" creationId="{71DA0FEC-628F-33D5-5D4A-5F482D0FFAFF}"/>
          </ac:spMkLst>
        </pc:spChg>
        <pc:spChg chg="add del mod">
          <ac:chgData name="義章 谷口" userId="1aec43038f16d83c" providerId="LiveId" clId="{D6A9376D-9D12-48CF-AAB9-E574FDE2BAEE}" dt="2024-04-22T09:33:55.650" v="543" actId="478"/>
          <ac:spMkLst>
            <pc:docMk/>
            <pc:sldMk cId="961551407" sldId="264"/>
            <ac:spMk id="19" creationId="{F827020B-64E7-C3D8-A9A1-493CA943D9F9}"/>
          </ac:spMkLst>
        </pc:spChg>
        <pc:picChg chg="add del mod modCrop">
          <ac:chgData name="義章 谷口" userId="1aec43038f16d83c" providerId="LiveId" clId="{D6A9376D-9D12-48CF-AAB9-E574FDE2BAEE}" dt="2024-04-22T09:15:07.674" v="306" actId="478"/>
          <ac:picMkLst>
            <pc:docMk/>
            <pc:sldMk cId="961551407" sldId="264"/>
            <ac:picMk id="4" creationId="{34D1C290-9BCF-FF36-1D00-2D37C2F4C58C}"/>
          </ac:picMkLst>
        </pc:picChg>
        <pc:picChg chg="add del">
          <ac:chgData name="義章 谷口" userId="1aec43038f16d83c" providerId="LiveId" clId="{D6A9376D-9D12-48CF-AAB9-E574FDE2BAEE}" dt="2024-04-22T09:06:03.420" v="119" actId="478"/>
          <ac:picMkLst>
            <pc:docMk/>
            <pc:sldMk cId="961551407" sldId="264"/>
            <ac:picMk id="5" creationId="{7B7B6ECF-F020-D3DD-0CE0-E46BA76FECA5}"/>
          </ac:picMkLst>
        </pc:picChg>
        <pc:picChg chg="add del mod ord modCrop">
          <ac:chgData name="義章 谷口" userId="1aec43038f16d83c" providerId="LiveId" clId="{D6A9376D-9D12-48CF-AAB9-E574FDE2BAEE}" dt="2024-04-22T09:20:11.527" v="386" actId="478"/>
          <ac:picMkLst>
            <pc:docMk/>
            <pc:sldMk cId="961551407" sldId="264"/>
            <ac:picMk id="11" creationId="{A6C9F9F1-20A9-5E62-7130-18EFDE2B9427}"/>
          </ac:picMkLst>
        </pc:picChg>
        <pc:picChg chg="add del mod ord modCrop">
          <ac:chgData name="義章 谷口" userId="1aec43038f16d83c" providerId="LiveId" clId="{D6A9376D-9D12-48CF-AAB9-E574FDE2BAEE}" dt="2024-04-22T09:33:49.512" v="541" actId="478"/>
          <ac:picMkLst>
            <pc:docMk/>
            <pc:sldMk cId="961551407" sldId="264"/>
            <ac:picMk id="12" creationId="{E3C83949-B95E-40C4-E878-CD28BC50D466}"/>
          </ac:picMkLst>
        </pc:picChg>
        <pc:picChg chg="add del mod">
          <ac:chgData name="義章 谷口" userId="1aec43038f16d83c" providerId="LiveId" clId="{D6A9376D-9D12-48CF-AAB9-E574FDE2BAEE}" dt="2024-04-22T09:22:04.424" v="402" actId="21"/>
          <ac:picMkLst>
            <pc:docMk/>
            <pc:sldMk cId="961551407" sldId="264"/>
            <ac:picMk id="14" creationId="{6F4FF591-58DC-D49A-346C-9F3B54D70680}"/>
          </ac:picMkLst>
        </pc:picChg>
        <pc:picChg chg="add del mod ord modCrop">
          <ac:chgData name="義章 谷口" userId="1aec43038f16d83c" providerId="LiveId" clId="{D6A9376D-9D12-48CF-AAB9-E574FDE2BAEE}" dt="2024-04-22T09:39:50.722" v="593" actId="478"/>
          <ac:picMkLst>
            <pc:docMk/>
            <pc:sldMk cId="961551407" sldId="264"/>
            <ac:picMk id="16" creationId="{7BEB7483-2EBE-C725-08E8-0F56EDFA4B05}"/>
          </ac:picMkLst>
        </pc:picChg>
        <pc:picChg chg="add del mod ord modCrop">
          <ac:chgData name="義章 谷口" userId="1aec43038f16d83c" providerId="LiveId" clId="{D6A9376D-9D12-48CF-AAB9-E574FDE2BAEE}" dt="2024-04-22T09:43:51.954" v="677" actId="478"/>
          <ac:picMkLst>
            <pc:docMk/>
            <pc:sldMk cId="961551407" sldId="264"/>
            <ac:picMk id="21" creationId="{FF24996F-468D-1C37-E4A7-454CA2E549E3}"/>
          </ac:picMkLst>
        </pc:picChg>
        <pc:picChg chg="add del mod">
          <ac:chgData name="義章 谷口" userId="1aec43038f16d83c" providerId="LiveId" clId="{D6A9376D-9D12-48CF-AAB9-E574FDE2BAEE}" dt="2024-04-22T09:41:05.513" v="606" actId="21"/>
          <ac:picMkLst>
            <pc:docMk/>
            <pc:sldMk cId="961551407" sldId="264"/>
            <ac:picMk id="23" creationId="{DE590EA8-E0EB-F4D7-F960-39403F135AAF}"/>
          </ac:picMkLst>
        </pc:picChg>
        <pc:picChg chg="add mod ord modCrop">
          <ac:chgData name="義章 谷口" userId="1aec43038f16d83c" providerId="LiveId" clId="{D6A9376D-9D12-48CF-AAB9-E574FDE2BAEE}" dt="2024-04-22T09:43:50.243" v="676" actId="167"/>
          <ac:picMkLst>
            <pc:docMk/>
            <pc:sldMk cId="961551407" sldId="264"/>
            <ac:picMk id="25" creationId="{59F97D50-890E-D6B2-2FB0-51D8C08AE1D9}"/>
          </ac:picMkLst>
        </pc:picChg>
        <pc:picChg chg="add del mod">
          <ac:chgData name="義章 谷口" userId="1aec43038f16d83c" providerId="LiveId" clId="{D6A9376D-9D12-48CF-AAB9-E574FDE2BAEE}" dt="2024-04-22T09:45:03.978" v="696" actId="21"/>
          <ac:picMkLst>
            <pc:docMk/>
            <pc:sldMk cId="961551407" sldId="264"/>
            <ac:picMk id="27" creationId="{1D2CF956-7462-D0C6-D011-723708AFCA72}"/>
          </ac:picMkLst>
        </pc:picChg>
      </pc:sldChg>
      <pc:sldChg chg="new del">
        <pc:chgData name="義章 谷口" userId="1aec43038f16d83c" providerId="LiveId" clId="{D6A9376D-9D12-48CF-AAB9-E574FDE2BAEE}" dt="2024-05-01T05:11:02.278" v="751" actId="47"/>
        <pc:sldMkLst>
          <pc:docMk/>
          <pc:sldMk cId="4152289374" sldId="265"/>
        </pc:sldMkLst>
      </pc:sldChg>
      <pc:sldMasterChg chg="modSp del delSldLayout modSldLayout">
        <pc:chgData name="義章 谷口" userId="1aec43038f16d83c" providerId="LiveId" clId="{D6A9376D-9D12-48CF-AAB9-E574FDE2BAEE}" dt="2024-04-22T01:16:38.279" v="3" actId="47"/>
        <pc:sldMasterMkLst>
          <pc:docMk/>
          <pc:sldMasterMk cId="2004216926" sldId="2147483648"/>
        </pc:sldMasterMkLst>
        <pc:spChg chg="mod">
          <ac:chgData name="義章 谷口" userId="1aec43038f16d83c" providerId="LiveId" clId="{D6A9376D-9D12-48CF-AAB9-E574FDE2BAEE}" dt="2024-04-22T01:16:17.285" v="0"/>
          <ac:spMkLst>
            <pc:docMk/>
            <pc:sldMasterMk cId="2004216926" sldId="2147483648"/>
            <ac:spMk id="2" creationId="{B16974AE-0430-E775-7DBB-F5219F9A438F}"/>
          </ac:spMkLst>
        </pc:spChg>
        <pc:spChg chg="mod">
          <ac:chgData name="義章 谷口" userId="1aec43038f16d83c" providerId="LiveId" clId="{D6A9376D-9D12-48CF-AAB9-E574FDE2BAEE}" dt="2024-04-22T01:16:17.285" v="0"/>
          <ac:spMkLst>
            <pc:docMk/>
            <pc:sldMasterMk cId="2004216926" sldId="2147483648"/>
            <ac:spMk id="3" creationId="{5AB572D8-C6F3-B604-2ABE-5B5C3759E77E}"/>
          </ac:spMkLst>
        </pc:spChg>
        <pc:spChg chg="mod">
          <ac:chgData name="義章 谷口" userId="1aec43038f16d83c" providerId="LiveId" clId="{D6A9376D-9D12-48CF-AAB9-E574FDE2BAEE}" dt="2024-04-22T01:16:17.285" v="0"/>
          <ac:spMkLst>
            <pc:docMk/>
            <pc:sldMasterMk cId="2004216926" sldId="2147483648"/>
            <ac:spMk id="4" creationId="{1BF14B89-0A46-43FC-14D0-DE51A5C28840}"/>
          </ac:spMkLst>
        </pc:spChg>
        <pc:spChg chg="mod">
          <ac:chgData name="義章 谷口" userId="1aec43038f16d83c" providerId="LiveId" clId="{D6A9376D-9D12-48CF-AAB9-E574FDE2BAEE}" dt="2024-04-22T01:16:17.285" v="0"/>
          <ac:spMkLst>
            <pc:docMk/>
            <pc:sldMasterMk cId="2004216926" sldId="2147483648"/>
            <ac:spMk id="5" creationId="{E5772EF7-B361-7CFC-1D19-3A3B6DD9635C}"/>
          </ac:spMkLst>
        </pc:spChg>
        <pc:spChg chg="mod">
          <ac:chgData name="義章 谷口" userId="1aec43038f16d83c" providerId="LiveId" clId="{D6A9376D-9D12-48CF-AAB9-E574FDE2BAEE}" dt="2024-04-22T01:16:17.285" v="0"/>
          <ac:spMkLst>
            <pc:docMk/>
            <pc:sldMasterMk cId="2004216926" sldId="2147483648"/>
            <ac:spMk id="6" creationId="{D7EF6E3E-F874-EBF5-0D2F-5F511CE88D3E}"/>
          </ac:spMkLst>
        </pc:spChg>
        <pc:sldLayoutChg chg="modSp del">
          <pc:chgData name="義章 谷口" userId="1aec43038f16d83c" providerId="LiveId" clId="{D6A9376D-9D12-48CF-AAB9-E574FDE2BAEE}" dt="2024-04-22T01:16:38.279" v="3" actId="47"/>
          <pc:sldLayoutMkLst>
            <pc:docMk/>
            <pc:sldMasterMk cId="2004216926" sldId="2147483648"/>
            <pc:sldLayoutMk cId="874118127" sldId="2147483649"/>
          </pc:sldLayoutMkLst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874118127" sldId="2147483649"/>
              <ac:spMk id="2" creationId="{8B488B57-F228-8812-8AE2-2EB14863568A}"/>
            </ac:spMkLst>
          </pc:spChg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874118127" sldId="2147483649"/>
              <ac:spMk id="3" creationId="{A0426C35-7B2F-AA97-618E-3D730286A775}"/>
            </ac:spMkLst>
          </pc:spChg>
        </pc:sldLayoutChg>
        <pc:sldLayoutChg chg="del">
          <pc:chgData name="義章 谷口" userId="1aec43038f16d83c" providerId="LiveId" clId="{D6A9376D-9D12-48CF-AAB9-E574FDE2BAEE}" dt="2024-04-22T01:16:38.279" v="3" actId="47"/>
          <pc:sldLayoutMkLst>
            <pc:docMk/>
            <pc:sldMasterMk cId="2004216926" sldId="2147483648"/>
            <pc:sldLayoutMk cId="3841562799" sldId="2147483650"/>
          </pc:sldLayoutMkLst>
        </pc:sldLayoutChg>
        <pc:sldLayoutChg chg="modSp del">
          <pc:chgData name="義章 谷口" userId="1aec43038f16d83c" providerId="LiveId" clId="{D6A9376D-9D12-48CF-AAB9-E574FDE2BAEE}" dt="2024-04-22T01:16:38.279" v="3" actId="47"/>
          <pc:sldLayoutMkLst>
            <pc:docMk/>
            <pc:sldMasterMk cId="2004216926" sldId="2147483648"/>
            <pc:sldLayoutMk cId="3089328261" sldId="2147483651"/>
          </pc:sldLayoutMkLst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3089328261" sldId="2147483651"/>
              <ac:spMk id="2" creationId="{8FEA8C18-4C93-FE89-3FD7-2B1DF4691BA5}"/>
            </ac:spMkLst>
          </pc:spChg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3089328261" sldId="2147483651"/>
              <ac:spMk id="3" creationId="{5849770F-6F4D-6CAD-5A39-5844F3C57BF9}"/>
            </ac:spMkLst>
          </pc:spChg>
        </pc:sldLayoutChg>
        <pc:sldLayoutChg chg="modSp del">
          <pc:chgData name="義章 谷口" userId="1aec43038f16d83c" providerId="LiveId" clId="{D6A9376D-9D12-48CF-AAB9-E574FDE2BAEE}" dt="2024-04-22T01:16:38.279" v="3" actId="47"/>
          <pc:sldLayoutMkLst>
            <pc:docMk/>
            <pc:sldMasterMk cId="2004216926" sldId="2147483648"/>
            <pc:sldLayoutMk cId="1165768562" sldId="2147483652"/>
          </pc:sldLayoutMkLst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1165768562" sldId="2147483652"/>
              <ac:spMk id="3" creationId="{E5EBB37E-34DD-89BA-A54B-4AE76894F235}"/>
            </ac:spMkLst>
          </pc:spChg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1165768562" sldId="2147483652"/>
              <ac:spMk id="4" creationId="{B2B7437D-52AA-2D50-8D1F-C621A7076856}"/>
            </ac:spMkLst>
          </pc:spChg>
        </pc:sldLayoutChg>
        <pc:sldLayoutChg chg="modSp del">
          <pc:chgData name="義章 谷口" userId="1aec43038f16d83c" providerId="LiveId" clId="{D6A9376D-9D12-48CF-AAB9-E574FDE2BAEE}" dt="2024-04-22T01:16:38.279" v="3" actId="47"/>
          <pc:sldLayoutMkLst>
            <pc:docMk/>
            <pc:sldMasterMk cId="2004216926" sldId="2147483648"/>
            <pc:sldLayoutMk cId="2094409814" sldId="2147483653"/>
          </pc:sldLayoutMkLst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2094409814" sldId="2147483653"/>
              <ac:spMk id="2" creationId="{A8F52111-86B1-E088-7AC5-D3C4E0E85AE4}"/>
            </ac:spMkLst>
          </pc:spChg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2094409814" sldId="2147483653"/>
              <ac:spMk id="3" creationId="{76D90448-FF75-5058-1AAA-3AE9550C6501}"/>
            </ac:spMkLst>
          </pc:spChg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2094409814" sldId="2147483653"/>
              <ac:spMk id="4" creationId="{B8F7C14C-5468-E29C-F79D-C2B194158A36}"/>
            </ac:spMkLst>
          </pc:spChg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2094409814" sldId="2147483653"/>
              <ac:spMk id="5" creationId="{0C610F09-523E-94E9-9EE3-A7EF80E3705A}"/>
            </ac:spMkLst>
          </pc:spChg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2094409814" sldId="2147483653"/>
              <ac:spMk id="6" creationId="{0D05374B-30CE-A0FB-9985-B574C744BCB7}"/>
            </ac:spMkLst>
          </pc:spChg>
        </pc:sldLayoutChg>
        <pc:sldLayoutChg chg="del">
          <pc:chgData name="義章 谷口" userId="1aec43038f16d83c" providerId="LiveId" clId="{D6A9376D-9D12-48CF-AAB9-E574FDE2BAEE}" dt="2024-04-22T01:16:38.279" v="3" actId="47"/>
          <pc:sldLayoutMkLst>
            <pc:docMk/>
            <pc:sldMasterMk cId="2004216926" sldId="2147483648"/>
            <pc:sldLayoutMk cId="302309246" sldId="2147483654"/>
          </pc:sldLayoutMkLst>
        </pc:sldLayoutChg>
        <pc:sldLayoutChg chg="del">
          <pc:chgData name="義章 谷口" userId="1aec43038f16d83c" providerId="LiveId" clId="{D6A9376D-9D12-48CF-AAB9-E574FDE2BAEE}" dt="2024-04-22T01:16:38.279" v="3" actId="47"/>
          <pc:sldLayoutMkLst>
            <pc:docMk/>
            <pc:sldMasterMk cId="2004216926" sldId="2147483648"/>
            <pc:sldLayoutMk cId="4202077613" sldId="2147483655"/>
          </pc:sldLayoutMkLst>
        </pc:sldLayoutChg>
        <pc:sldLayoutChg chg="modSp del">
          <pc:chgData name="義章 谷口" userId="1aec43038f16d83c" providerId="LiveId" clId="{D6A9376D-9D12-48CF-AAB9-E574FDE2BAEE}" dt="2024-04-22T01:16:38.279" v="3" actId="47"/>
          <pc:sldLayoutMkLst>
            <pc:docMk/>
            <pc:sldMasterMk cId="2004216926" sldId="2147483648"/>
            <pc:sldLayoutMk cId="1727742640" sldId="2147483656"/>
          </pc:sldLayoutMkLst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1727742640" sldId="2147483656"/>
              <ac:spMk id="2" creationId="{819050C4-3944-9A5C-F73C-94BF9BD5B2A0}"/>
            </ac:spMkLst>
          </pc:spChg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1727742640" sldId="2147483656"/>
              <ac:spMk id="3" creationId="{59A4146B-7C0B-5D73-6273-3C3EC69A5345}"/>
            </ac:spMkLst>
          </pc:spChg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1727742640" sldId="2147483656"/>
              <ac:spMk id="4" creationId="{C78C350E-5E3F-EBA6-9133-29FF0202B707}"/>
            </ac:spMkLst>
          </pc:spChg>
        </pc:sldLayoutChg>
        <pc:sldLayoutChg chg="modSp del">
          <pc:chgData name="義章 谷口" userId="1aec43038f16d83c" providerId="LiveId" clId="{D6A9376D-9D12-48CF-AAB9-E574FDE2BAEE}" dt="2024-04-22T01:16:38.279" v="3" actId="47"/>
          <pc:sldLayoutMkLst>
            <pc:docMk/>
            <pc:sldMasterMk cId="2004216926" sldId="2147483648"/>
            <pc:sldLayoutMk cId="299959340" sldId="2147483657"/>
          </pc:sldLayoutMkLst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299959340" sldId="2147483657"/>
              <ac:spMk id="2" creationId="{2EE7244A-54D3-3E21-D5DB-56C31594FAE1}"/>
            </ac:spMkLst>
          </pc:spChg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299959340" sldId="2147483657"/>
              <ac:spMk id="3" creationId="{FCB3D15A-290D-D983-6A3D-5E7861B40C33}"/>
            </ac:spMkLst>
          </pc:spChg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299959340" sldId="2147483657"/>
              <ac:spMk id="4" creationId="{22D630D6-3560-3966-687A-7A8A6FDB9532}"/>
            </ac:spMkLst>
          </pc:spChg>
        </pc:sldLayoutChg>
        <pc:sldLayoutChg chg="del">
          <pc:chgData name="義章 谷口" userId="1aec43038f16d83c" providerId="LiveId" clId="{D6A9376D-9D12-48CF-AAB9-E574FDE2BAEE}" dt="2024-04-22T01:16:38.279" v="3" actId="47"/>
          <pc:sldLayoutMkLst>
            <pc:docMk/>
            <pc:sldMasterMk cId="2004216926" sldId="2147483648"/>
            <pc:sldLayoutMk cId="2887557944" sldId="2147483658"/>
          </pc:sldLayoutMkLst>
        </pc:sldLayoutChg>
        <pc:sldLayoutChg chg="modSp del">
          <pc:chgData name="義章 谷口" userId="1aec43038f16d83c" providerId="LiveId" clId="{D6A9376D-9D12-48CF-AAB9-E574FDE2BAEE}" dt="2024-04-22T01:16:38.279" v="3" actId="47"/>
          <pc:sldLayoutMkLst>
            <pc:docMk/>
            <pc:sldMasterMk cId="2004216926" sldId="2147483648"/>
            <pc:sldLayoutMk cId="57334252" sldId="2147483659"/>
          </pc:sldLayoutMkLst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57334252" sldId="2147483659"/>
              <ac:spMk id="2" creationId="{C1CB7638-D80E-2E55-C950-29ADC015AC4C}"/>
            </ac:spMkLst>
          </pc:spChg>
          <pc:spChg chg="mod">
            <ac:chgData name="義章 谷口" userId="1aec43038f16d83c" providerId="LiveId" clId="{D6A9376D-9D12-48CF-AAB9-E574FDE2BAEE}" dt="2024-04-22T01:16:17.285" v="0"/>
            <ac:spMkLst>
              <pc:docMk/>
              <pc:sldMasterMk cId="2004216926" sldId="2147483648"/>
              <pc:sldLayoutMk cId="57334252" sldId="2147483659"/>
              <ac:spMk id="3" creationId="{313C4C76-3AD1-2653-9992-7DF815F9E30E}"/>
            </ac:spMkLst>
          </pc:spChg>
        </pc:sldLayoutChg>
      </pc:sldMasterChg>
    </pc:docChg>
  </pc:docChgLst>
  <pc:docChgLst>
    <pc:chgData name="ytaniguti2@gmail.com" userId="1aec43038f16d83c" providerId="LiveId" clId="{F9419B5B-E985-4A2F-8F99-BCFE6C0CAAB4}"/>
    <pc:docChg chg="custSel addSld modSld">
      <pc:chgData name="ytaniguti2@gmail.com" userId="1aec43038f16d83c" providerId="LiveId" clId="{F9419B5B-E985-4A2F-8F99-BCFE6C0CAAB4}" dt="2024-06-18T08:09:20.833" v="351" actId="20577"/>
      <pc:docMkLst>
        <pc:docMk/>
      </pc:docMkLst>
      <pc:sldChg chg="modNotesTx">
        <pc:chgData name="ytaniguti2@gmail.com" userId="1aec43038f16d83c" providerId="LiveId" clId="{F9419B5B-E985-4A2F-8F99-BCFE6C0CAAB4}" dt="2024-05-29T03:33:34.556" v="205" actId="20577"/>
        <pc:sldMkLst>
          <pc:docMk/>
          <pc:sldMk cId="2842446160" sldId="262"/>
        </pc:sldMkLst>
      </pc:sldChg>
      <pc:sldChg chg="modNotesTx">
        <pc:chgData name="ytaniguti2@gmail.com" userId="1aec43038f16d83c" providerId="LiveId" clId="{F9419B5B-E985-4A2F-8F99-BCFE6C0CAAB4}" dt="2024-05-29T03:34:17.170" v="283" actId="20577"/>
        <pc:sldMkLst>
          <pc:docMk/>
          <pc:sldMk cId="3232284875" sldId="263"/>
        </pc:sldMkLst>
      </pc:sldChg>
      <pc:sldChg chg="delSp modSp mod modNotesTx">
        <pc:chgData name="ytaniguti2@gmail.com" userId="1aec43038f16d83c" providerId="LiveId" clId="{F9419B5B-E985-4A2F-8F99-BCFE6C0CAAB4}" dt="2024-05-29T03:33:18.049" v="167" actId="20577"/>
        <pc:sldMkLst>
          <pc:docMk/>
          <pc:sldMk cId="1955827665" sldId="264"/>
        </pc:sldMkLst>
        <pc:spChg chg="mod">
          <ac:chgData name="ytaniguti2@gmail.com" userId="1aec43038f16d83c" providerId="LiveId" clId="{F9419B5B-E985-4A2F-8F99-BCFE6C0CAAB4}" dt="2024-05-29T03:32:52.843" v="165" actId="1038"/>
          <ac:spMkLst>
            <pc:docMk/>
            <pc:sldMk cId="1955827665" sldId="264"/>
            <ac:spMk id="6" creationId="{7BF8408B-677F-26D1-8BB5-5A04332029D8}"/>
          </ac:spMkLst>
        </pc:spChg>
        <pc:spChg chg="mod">
          <ac:chgData name="ytaniguti2@gmail.com" userId="1aec43038f16d83c" providerId="LiveId" clId="{F9419B5B-E985-4A2F-8F99-BCFE6C0CAAB4}" dt="2024-05-29T03:33:01.269" v="166" actId="1076"/>
          <ac:spMkLst>
            <pc:docMk/>
            <pc:sldMk cId="1955827665" sldId="264"/>
            <ac:spMk id="7" creationId="{8A471277-2AFA-AF84-35DF-29144A542AEF}"/>
          </ac:spMkLst>
        </pc:spChg>
        <pc:spChg chg="del">
          <ac:chgData name="ytaniguti2@gmail.com" userId="1aec43038f16d83c" providerId="LiveId" clId="{F9419B5B-E985-4A2F-8F99-BCFE6C0CAAB4}" dt="2024-05-29T03:32:05.127" v="105" actId="478"/>
          <ac:spMkLst>
            <pc:docMk/>
            <pc:sldMk cId="1955827665" sldId="264"/>
            <ac:spMk id="8" creationId="{A7345696-C1AC-C4A8-DF97-6880A83D2814}"/>
          </ac:spMkLst>
        </pc:spChg>
        <pc:spChg chg="del">
          <ac:chgData name="ytaniguti2@gmail.com" userId="1aec43038f16d83c" providerId="LiveId" clId="{F9419B5B-E985-4A2F-8F99-BCFE6C0CAAB4}" dt="2024-05-29T03:32:07.482" v="106" actId="478"/>
          <ac:spMkLst>
            <pc:docMk/>
            <pc:sldMk cId="1955827665" sldId="264"/>
            <ac:spMk id="16" creationId="{E978E512-49B0-A3D1-E0C5-E1EB027AFC84}"/>
          </ac:spMkLst>
        </pc:spChg>
        <pc:picChg chg="del">
          <ac:chgData name="ytaniguti2@gmail.com" userId="1aec43038f16d83c" providerId="LiveId" clId="{F9419B5B-E985-4A2F-8F99-BCFE6C0CAAB4}" dt="2024-05-29T03:32:02.200" v="104" actId="478"/>
          <ac:picMkLst>
            <pc:docMk/>
            <pc:sldMk cId="1955827665" sldId="264"/>
            <ac:picMk id="4" creationId="{F163C655-8A29-7290-3608-FABA38851DE9}"/>
          </ac:picMkLst>
        </pc:picChg>
        <pc:picChg chg="mod">
          <ac:chgData name="ytaniguti2@gmail.com" userId="1aec43038f16d83c" providerId="LiveId" clId="{F9419B5B-E985-4A2F-8F99-BCFE6C0CAAB4}" dt="2024-05-29T03:32:43.328" v="155" actId="1038"/>
          <ac:picMkLst>
            <pc:docMk/>
            <pc:sldMk cId="1955827665" sldId="264"/>
            <ac:picMk id="5" creationId="{493F70BB-093E-67B2-D762-6F91C435685E}"/>
          </ac:picMkLst>
        </pc:picChg>
        <pc:picChg chg="del">
          <ac:chgData name="ytaniguti2@gmail.com" userId="1aec43038f16d83c" providerId="LiveId" clId="{F9419B5B-E985-4A2F-8F99-BCFE6C0CAAB4}" dt="2024-05-29T03:32:02.200" v="104" actId="478"/>
          <ac:picMkLst>
            <pc:docMk/>
            <pc:sldMk cId="1955827665" sldId="264"/>
            <ac:picMk id="9" creationId="{A52A6F3E-B53F-E32E-DABB-914113044652}"/>
          </ac:picMkLst>
        </pc:picChg>
        <pc:picChg chg="mod">
          <ac:chgData name="ytaniguti2@gmail.com" userId="1aec43038f16d83c" providerId="LiveId" clId="{F9419B5B-E985-4A2F-8F99-BCFE6C0CAAB4}" dt="2024-05-29T03:32:43.328" v="155" actId="1038"/>
          <ac:picMkLst>
            <pc:docMk/>
            <pc:sldMk cId="1955827665" sldId="264"/>
            <ac:picMk id="15" creationId="{8F232CF3-6729-05E8-6B52-0CDF01A37FCA}"/>
          </ac:picMkLst>
        </pc:picChg>
      </pc:sldChg>
      <pc:sldChg chg="delSp modSp add mod modNotesTx">
        <pc:chgData name="ytaniguti2@gmail.com" userId="1aec43038f16d83c" providerId="LiveId" clId="{F9419B5B-E985-4A2F-8F99-BCFE6C0CAAB4}" dt="2024-05-29T03:35:48.741" v="295" actId="20577"/>
        <pc:sldMkLst>
          <pc:docMk/>
          <pc:sldMk cId="1899141844" sldId="265"/>
        </pc:sldMkLst>
        <pc:spChg chg="del">
          <ac:chgData name="ytaniguti2@gmail.com" userId="1aec43038f16d83c" providerId="LiveId" clId="{F9419B5B-E985-4A2F-8F99-BCFE6C0CAAB4}" dt="2024-05-29T03:34:46.349" v="287" actId="478"/>
          <ac:spMkLst>
            <pc:docMk/>
            <pc:sldMk cId="1899141844" sldId="265"/>
            <ac:spMk id="6" creationId="{7BF8408B-677F-26D1-8BB5-5A04332029D8}"/>
          </ac:spMkLst>
        </pc:spChg>
        <pc:spChg chg="del">
          <ac:chgData name="ytaniguti2@gmail.com" userId="1aec43038f16d83c" providerId="LiveId" clId="{F9419B5B-E985-4A2F-8F99-BCFE6C0CAAB4}" dt="2024-05-29T03:34:44.009" v="286" actId="478"/>
          <ac:spMkLst>
            <pc:docMk/>
            <pc:sldMk cId="1899141844" sldId="265"/>
            <ac:spMk id="7" creationId="{8A471277-2AFA-AF84-35DF-29144A542AEF}"/>
          </ac:spMkLst>
        </pc:spChg>
        <pc:spChg chg="mod">
          <ac:chgData name="ytaniguti2@gmail.com" userId="1aec43038f16d83c" providerId="LiveId" clId="{F9419B5B-E985-4A2F-8F99-BCFE6C0CAAB4}" dt="2024-05-29T03:35:48.741" v="295" actId="20577"/>
          <ac:spMkLst>
            <pc:docMk/>
            <pc:sldMk cId="1899141844" sldId="265"/>
            <ac:spMk id="8" creationId="{A7345696-C1AC-C4A8-DF97-6880A83D2814}"/>
          </ac:spMkLst>
        </pc:spChg>
        <pc:spChg chg="mod">
          <ac:chgData name="ytaniguti2@gmail.com" userId="1aec43038f16d83c" providerId="LiveId" clId="{F9419B5B-E985-4A2F-8F99-BCFE6C0CAAB4}" dt="2024-05-29T03:35:45.650" v="293" actId="20577"/>
          <ac:spMkLst>
            <pc:docMk/>
            <pc:sldMk cId="1899141844" sldId="265"/>
            <ac:spMk id="16" creationId="{E978E512-49B0-A3D1-E0C5-E1EB027AFC84}"/>
          </ac:spMkLst>
        </pc:spChg>
        <pc:picChg chg="mod">
          <ac:chgData name="ytaniguti2@gmail.com" userId="1aec43038f16d83c" providerId="LiveId" clId="{F9419B5B-E985-4A2F-8F99-BCFE6C0CAAB4}" dt="2024-05-29T03:35:38.463" v="291" actId="1076"/>
          <ac:picMkLst>
            <pc:docMk/>
            <pc:sldMk cId="1899141844" sldId="265"/>
            <ac:picMk id="4" creationId="{F163C655-8A29-7290-3608-FABA38851DE9}"/>
          </ac:picMkLst>
        </pc:picChg>
        <pc:picChg chg="del">
          <ac:chgData name="ytaniguti2@gmail.com" userId="1aec43038f16d83c" providerId="LiveId" clId="{F9419B5B-E985-4A2F-8F99-BCFE6C0CAAB4}" dt="2024-05-29T03:34:42.334" v="285" actId="478"/>
          <ac:picMkLst>
            <pc:docMk/>
            <pc:sldMk cId="1899141844" sldId="265"/>
            <ac:picMk id="5" creationId="{493F70BB-093E-67B2-D762-6F91C435685E}"/>
          </ac:picMkLst>
        </pc:picChg>
        <pc:picChg chg="mod">
          <ac:chgData name="ytaniguti2@gmail.com" userId="1aec43038f16d83c" providerId="LiveId" clId="{F9419B5B-E985-4A2F-8F99-BCFE6C0CAAB4}" dt="2024-05-29T03:35:38.463" v="291" actId="1076"/>
          <ac:picMkLst>
            <pc:docMk/>
            <pc:sldMk cId="1899141844" sldId="265"/>
            <ac:picMk id="9" creationId="{A52A6F3E-B53F-E32E-DABB-914113044652}"/>
          </ac:picMkLst>
        </pc:picChg>
        <pc:picChg chg="del">
          <ac:chgData name="ytaniguti2@gmail.com" userId="1aec43038f16d83c" providerId="LiveId" clId="{F9419B5B-E985-4A2F-8F99-BCFE6C0CAAB4}" dt="2024-05-29T03:34:41.473" v="284" actId="478"/>
          <ac:picMkLst>
            <pc:docMk/>
            <pc:sldMk cId="1899141844" sldId="265"/>
            <ac:picMk id="15" creationId="{8F232CF3-6729-05E8-6B52-0CDF01A37FCA}"/>
          </ac:picMkLst>
        </pc:picChg>
      </pc:sldChg>
      <pc:sldChg chg="addSp modSp mod">
        <pc:chgData name="ytaniguti2@gmail.com" userId="1aec43038f16d83c" providerId="LiveId" clId="{F9419B5B-E985-4A2F-8F99-BCFE6C0CAAB4}" dt="2024-06-18T08:09:20.833" v="351" actId="20577"/>
        <pc:sldMkLst>
          <pc:docMk/>
          <pc:sldMk cId="2143561547" sldId="270"/>
        </pc:sldMkLst>
        <pc:spChg chg="add mod">
          <ac:chgData name="ytaniguti2@gmail.com" userId="1aec43038f16d83c" providerId="LiveId" clId="{F9419B5B-E985-4A2F-8F99-BCFE6C0CAAB4}" dt="2024-06-18T08:07:22.511" v="314" actId="1076"/>
          <ac:spMkLst>
            <pc:docMk/>
            <pc:sldMk cId="2143561547" sldId="270"/>
            <ac:spMk id="8" creationId="{430A4E4D-2A47-D028-6DCB-9CDD24A6C69B}"/>
          </ac:spMkLst>
        </pc:spChg>
        <pc:spChg chg="add mod">
          <ac:chgData name="ytaniguti2@gmail.com" userId="1aec43038f16d83c" providerId="LiveId" clId="{F9419B5B-E985-4A2F-8F99-BCFE6C0CAAB4}" dt="2024-06-18T08:08:04.444" v="335" actId="1037"/>
          <ac:spMkLst>
            <pc:docMk/>
            <pc:sldMk cId="2143561547" sldId="270"/>
            <ac:spMk id="9" creationId="{9319F6C4-5B69-4578-5469-6731EE2B64DC}"/>
          </ac:spMkLst>
        </pc:spChg>
        <pc:spChg chg="add mod">
          <ac:chgData name="ytaniguti2@gmail.com" userId="1aec43038f16d83c" providerId="LiveId" clId="{F9419B5B-E985-4A2F-8F99-BCFE6C0CAAB4}" dt="2024-06-18T08:09:13.416" v="343" actId="20577"/>
          <ac:spMkLst>
            <pc:docMk/>
            <pc:sldMk cId="2143561547" sldId="270"/>
            <ac:spMk id="10" creationId="{2C274409-BD68-9EF1-0490-375C58C601D2}"/>
          </ac:spMkLst>
        </pc:spChg>
        <pc:spChg chg="add mod">
          <ac:chgData name="ytaniguti2@gmail.com" userId="1aec43038f16d83c" providerId="LiveId" clId="{F9419B5B-E985-4A2F-8F99-BCFE6C0CAAB4}" dt="2024-06-18T08:09:20.833" v="351" actId="20577"/>
          <ac:spMkLst>
            <pc:docMk/>
            <pc:sldMk cId="2143561547" sldId="270"/>
            <ac:spMk id="11" creationId="{6BB842DC-006C-28A0-97BA-73EFAC2A6DF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9E0FA8-9ACB-4967-8F90-9BB208CCCC57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2EFD7C-5F00-46BA-92B4-1F3D6FE405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0672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Supplementary Figure 1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2EFD7C-5F00-46BA-92B4-1F3D6FE4057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59236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Supplementary Figure 2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3045022-0018-499C-9484-9AADA5B5F599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77172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Supplementary Figure 3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3045022-0018-499C-9484-9AADA5B5F599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9250033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Supplementary Figure 4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2EFD7C-5F00-46BA-92B4-1F3D6FE40575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30409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6D13-F7DF-493B-8692-3E995BFC0225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D8FCF-D5B5-4865-902E-3B3A6C353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614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6D13-F7DF-493B-8692-3E995BFC0225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D8FCF-D5B5-4865-902E-3B3A6C353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0426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6D13-F7DF-493B-8692-3E995BFC0225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D8FCF-D5B5-4865-902E-3B3A6C353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51357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6D13-F7DF-493B-8692-3E995BFC0225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D8FCF-D5B5-4865-902E-3B3A6C353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5072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6D13-F7DF-493B-8692-3E995BFC0225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D8FCF-D5B5-4865-902E-3B3A6C353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208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6D13-F7DF-493B-8692-3E995BFC0225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D8FCF-D5B5-4865-902E-3B3A6C353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538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6D13-F7DF-493B-8692-3E995BFC0225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D8FCF-D5B5-4865-902E-3B3A6C353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7999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6D13-F7DF-493B-8692-3E995BFC0225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D8FCF-D5B5-4865-902E-3B3A6C353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3900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6D13-F7DF-493B-8692-3E995BFC0225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D8FCF-D5B5-4865-902E-3B3A6C353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6991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6D13-F7DF-493B-8692-3E995BFC0225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D8FCF-D5B5-4865-902E-3B3A6C353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5851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6D13-F7DF-493B-8692-3E995BFC0225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D8FCF-D5B5-4865-902E-3B3A6C353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050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4FAFE5-A7C7-4FDC-AC8A-0A68208FDD34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415707-F0C9-4E89-BBB6-3C014B20EB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6871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sv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75973A64-A4BC-A614-6975-6BF24E9CAF9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138" t="9099" r="15096" b="55547"/>
          <a:stretch/>
        </p:blipFill>
        <p:spPr>
          <a:xfrm>
            <a:off x="4601520" y="111760"/>
            <a:ext cx="4440880" cy="3017521"/>
          </a:xfrm>
          <a:prstGeom prst="rect">
            <a:avLst/>
          </a:prstGeom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7176863B-AC9D-8C8B-F355-E85A4B8CF2AB}"/>
              </a:ext>
            </a:extLst>
          </p:cNvPr>
          <p:cNvSpPr/>
          <p:nvPr/>
        </p:nvSpPr>
        <p:spPr>
          <a:xfrm>
            <a:off x="3909434" y="1"/>
            <a:ext cx="196693" cy="3721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r>
              <a:rPr lang="en-US" altLang="ja-JP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</a:t>
            </a:r>
            <a:endParaRPr lang="ja-JP" altLang="en-US" dirty="0">
              <a:solidFill>
                <a:prstClr val="black"/>
              </a:solidFill>
              <a:latin typeface="Calibri" panose="020F0502020204030204"/>
              <a:ea typeface="游ゴシック" panose="020B0400000000000000" pitchFamily="50" charset="-128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73521C6C-792D-3F43-7E55-66833697CDDA}"/>
              </a:ext>
            </a:extLst>
          </p:cNvPr>
          <p:cNvSpPr/>
          <p:nvPr/>
        </p:nvSpPr>
        <p:spPr>
          <a:xfrm rot="16200000">
            <a:off x="3564791" y="1293658"/>
            <a:ext cx="1488826" cy="40615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Survival rate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1B213F52-94D3-08ED-CAFB-90259E733946}"/>
              </a:ext>
            </a:extLst>
          </p:cNvPr>
          <p:cNvSpPr/>
          <p:nvPr/>
        </p:nvSpPr>
        <p:spPr>
          <a:xfrm>
            <a:off x="5948832" y="3129280"/>
            <a:ext cx="2310999" cy="3609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Overall survival (days)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D58950D6-D6BE-49A1-262D-95A066901B27}"/>
              </a:ext>
            </a:extLst>
          </p:cNvPr>
          <p:cNvSpPr/>
          <p:nvPr/>
        </p:nvSpPr>
        <p:spPr>
          <a:xfrm>
            <a:off x="7572538" y="291203"/>
            <a:ext cx="1374585" cy="3234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000" i="1" dirty="0">
                <a:solidFill>
                  <a:schemeClr val="tx1"/>
                </a:solidFill>
              </a:rPr>
              <a:t>p</a:t>
            </a:r>
            <a:r>
              <a:rPr lang="en-US" altLang="ja-JP" sz="2000" dirty="0">
                <a:solidFill>
                  <a:schemeClr val="tx1"/>
                </a:solidFill>
              </a:rPr>
              <a:t>=0.224</a:t>
            </a:r>
            <a:endParaRPr lang="ja-JP" altLang="en-US" sz="2000" baseline="30000" dirty="0">
              <a:solidFill>
                <a:schemeClr val="tx1"/>
              </a:solidFill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8C6B6879-478D-4D90-E7EC-16DAC409FD1D}"/>
              </a:ext>
            </a:extLst>
          </p:cNvPr>
          <p:cNvSpPr/>
          <p:nvPr/>
        </p:nvSpPr>
        <p:spPr>
          <a:xfrm>
            <a:off x="6929121" y="1422810"/>
            <a:ext cx="1826455" cy="2531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M2 low</a:t>
            </a:r>
            <a:r>
              <a:rPr lang="ja-JP" altLang="en-US" sz="1600" dirty="0">
                <a:solidFill>
                  <a:schemeClr val="tx1"/>
                </a:solidFill>
              </a:rPr>
              <a:t> </a:t>
            </a:r>
            <a:r>
              <a:rPr lang="en-US" altLang="ja-JP" sz="1600" dirty="0">
                <a:solidFill>
                  <a:schemeClr val="tx1"/>
                </a:solidFill>
              </a:rPr>
              <a:t>in EC (n=8)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7FE27219-2862-8AC8-576B-4972C01535F5}"/>
              </a:ext>
            </a:extLst>
          </p:cNvPr>
          <p:cNvSpPr/>
          <p:nvPr/>
        </p:nvSpPr>
        <p:spPr>
          <a:xfrm>
            <a:off x="6753912" y="2484121"/>
            <a:ext cx="1826454" cy="2531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M2 high in EC (n=7)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8D822204-E180-80C4-3A0C-EA052EC2FE5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211" t="9081" r="14355" b="55519"/>
          <a:stretch/>
        </p:blipFill>
        <p:spPr>
          <a:xfrm>
            <a:off x="4601520" y="3505553"/>
            <a:ext cx="4476759" cy="3017520"/>
          </a:xfrm>
          <a:prstGeom prst="rect">
            <a:avLst/>
          </a:prstGeom>
        </p:spPr>
      </p:pic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4C4F0A78-20E1-E611-27AD-1C7B9D247398}"/>
              </a:ext>
            </a:extLst>
          </p:cNvPr>
          <p:cNvSpPr/>
          <p:nvPr/>
        </p:nvSpPr>
        <p:spPr>
          <a:xfrm>
            <a:off x="5948832" y="6491972"/>
            <a:ext cx="2310999" cy="3609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Overall survival (days)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517EDCE7-DA4E-1E96-02AB-10D12283B6E0}"/>
              </a:ext>
            </a:extLst>
          </p:cNvPr>
          <p:cNvSpPr/>
          <p:nvPr/>
        </p:nvSpPr>
        <p:spPr>
          <a:xfrm rot="16200000">
            <a:off x="3563829" y="4683473"/>
            <a:ext cx="1488826" cy="40615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Survival rate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A8951612-A8DA-45C5-7574-544E3626C707}"/>
              </a:ext>
            </a:extLst>
          </p:cNvPr>
          <p:cNvSpPr/>
          <p:nvPr/>
        </p:nvSpPr>
        <p:spPr>
          <a:xfrm>
            <a:off x="7572538" y="3686770"/>
            <a:ext cx="1374585" cy="3234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000" i="1" dirty="0">
                <a:solidFill>
                  <a:schemeClr val="tx1"/>
                </a:solidFill>
              </a:rPr>
              <a:t>p</a:t>
            </a:r>
            <a:r>
              <a:rPr lang="en-US" altLang="ja-JP" sz="2000" dirty="0">
                <a:solidFill>
                  <a:schemeClr val="tx1"/>
                </a:solidFill>
              </a:rPr>
              <a:t>=0.179</a:t>
            </a:r>
            <a:endParaRPr lang="ja-JP" altLang="en-US" sz="2000" baseline="30000" dirty="0">
              <a:solidFill>
                <a:schemeClr val="tx1"/>
              </a:solidFill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0E87DBDF-D460-19AB-4008-2AFBF4CBC2B4}"/>
              </a:ext>
            </a:extLst>
          </p:cNvPr>
          <p:cNvSpPr/>
          <p:nvPr/>
        </p:nvSpPr>
        <p:spPr>
          <a:xfrm>
            <a:off x="6906573" y="4281994"/>
            <a:ext cx="1882404" cy="2531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M2 low in TC (n=18)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9E15E36C-A6E9-00EC-5D66-867DFDD80B77}"/>
              </a:ext>
            </a:extLst>
          </p:cNvPr>
          <p:cNvSpPr/>
          <p:nvPr/>
        </p:nvSpPr>
        <p:spPr>
          <a:xfrm>
            <a:off x="6662421" y="5308600"/>
            <a:ext cx="1973897" cy="2531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M2 high in TC (n=17)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DFB904F4-4901-56B2-BCD0-CD7F602C0823}"/>
              </a:ext>
            </a:extLst>
          </p:cNvPr>
          <p:cNvSpPr/>
          <p:nvPr/>
        </p:nvSpPr>
        <p:spPr>
          <a:xfrm>
            <a:off x="3909434" y="3398111"/>
            <a:ext cx="194677" cy="3775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r>
              <a:rPr lang="en-US" altLang="ja-JP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b</a:t>
            </a:r>
            <a:endParaRPr lang="ja-JP" altLang="en-US" dirty="0">
              <a:solidFill>
                <a:prstClr val="black"/>
              </a:solidFill>
              <a:latin typeface="Calibri" panose="020F0502020204030204"/>
              <a:ea typeface="游ゴシック" panose="020B0400000000000000" pitchFamily="50" charset="-128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BD5D6C10-B013-993B-F6DC-15D3AB55D936}"/>
              </a:ext>
            </a:extLst>
          </p:cNvPr>
          <p:cNvSpPr/>
          <p:nvPr/>
        </p:nvSpPr>
        <p:spPr>
          <a:xfrm>
            <a:off x="1639165" y="-19500"/>
            <a:ext cx="1920240" cy="4724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Supplementary Fig. 1</a:t>
            </a:r>
            <a:endParaRPr lang="ja-JP" altLang="en-US" sz="16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363075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>
            <a:extLst>
              <a:ext uri="{FF2B5EF4-FFF2-40B4-BE49-F238E27FC236}">
                <a16:creationId xmlns:a16="http://schemas.microsoft.com/office/drawing/2014/main" id="{8068250C-05ED-F243-D0AA-EA2EE94A0EC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176" t="9100" r="15111" b="55444"/>
          <a:stretch/>
        </p:blipFill>
        <p:spPr>
          <a:xfrm>
            <a:off x="4607860" y="123159"/>
            <a:ext cx="4424380" cy="3017520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4407F1E2-D438-DE61-3686-154A0B2DC115}"/>
              </a:ext>
            </a:extLst>
          </p:cNvPr>
          <p:cNvSpPr/>
          <p:nvPr/>
        </p:nvSpPr>
        <p:spPr>
          <a:xfrm>
            <a:off x="3899274" y="1"/>
            <a:ext cx="196693" cy="3721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r>
              <a:rPr lang="en-US" altLang="ja-JP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</a:t>
            </a:r>
            <a:endParaRPr lang="ja-JP" altLang="en-US" dirty="0">
              <a:solidFill>
                <a:prstClr val="black"/>
              </a:solidFill>
              <a:latin typeface="Calibri" panose="020F0502020204030204"/>
              <a:ea typeface="游ゴシック" panose="020B0400000000000000" pitchFamily="50" charset="-128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461E3E1E-BDA3-7AAE-2D37-5194017B2505}"/>
              </a:ext>
            </a:extLst>
          </p:cNvPr>
          <p:cNvSpPr/>
          <p:nvPr/>
        </p:nvSpPr>
        <p:spPr>
          <a:xfrm rot="16200000">
            <a:off x="3554631" y="1293658"/>
            <a:ext cx="1488826" cy="40615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Survival rate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D97E9A28-B482-AEB2-92B7-D6774239B034}"/>
              </a:ext>
            </a:extLst>
          </p:cNvPr>
          <p:cNvSpPr/>
          <p:nvPr/>
        </p:nvSpPr>
        <p:spPr>
          <a:xfrm>
            <a:off x="5938672" y="3129280"/>
            <a:ext cx="2310999" cy="3609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Overall survival (days)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937706DF-EF0D-D8A5-6FDB-21F162142B6D}"/>
              </a:ext>
            </a:extLst>
          </p:cNvPr>
          <p:cNvSpPr/>
          <p:nvPr/>
        </p:nvSpPr>
        <p:spPr>
          <a:xfrm>
            <a:off x="7562378" y="291203"/>
            <a:ext cx="1374585" cy="3234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000" i="1" dirty="0">
                <a:solidFill>
                  <a:schemeClr val="tx1"/>
                </a:solidFill>
              </a:rPr>
              <a:t>p</a:t>
            </a:r>
            <a:r>
              <a:rPr lang="en-US" altLang="ja-JP" sz="2000" dirty="0">
                <a:solidFill>
                  <a:schemeClr val="tx1"/>
                </a:solidFill>
              </a:rPr>
              <a:t>=0.527</a:t>
            </a:r>
            <a:endParaRPr lang="ja-JP" altLang="en-US" sz="2000" baseline="30000" dirty="0">
              <a:solidFill>
                <a:schemeClr val="tx1"/>
              </a:solidFill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CAF5EBA7-B9B2-AE08-7D4D-AACA6FDCD616}"/>
              </a:ext>
            </a:extLst>
          </p:cNvPr>
          <p:cNvSpPr/>
          <p:nvPr/>
        </p:nvSpPr>
        <p:spPr>
          <a:xfrm>
            <a:off x="6918960" y="1118830"/>
            <a:ext cx="2018002" cy="2531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CSF-1 high in EC (n=2)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3134F92C-4A3F-F93E-0599-2051EBA350EC}"/>
              </a:ext>
            </a:extLst>
          </p:cNvPr>
          <p:cNvSpPr/>
          <p:nvPr/>
        </p:nvSpPr>
        <p:spPr>
          <a:xfrm>
            <a:off x="6390641" y="1977761"/>
            <a:ext cx="2118995" cy="2531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CSF-1 low in  EC (n=13)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DE958411-6F0F-B9FF-DF04-D484AC0DA13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300" t="9049" r="14350" b="55488"/>
          <a:stretch/>
        </p:blipFill>
        <p:spPr>
          <a:xfrm>
            <a:off x="4607861" y="3517662"/>
            <a:ext cx="4475525" cy="3025659"/>
          </a:xfrm>
          <a:prstGeom prst="rect">
            <a:avLst/>
          </a:prstGeom>
        </p:spPr>
      </p:pic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98045E09-6699-2804-DA2B-7A24431AA917}"/>
              </a:ext>
            </a:extLst>
          </p:cNvPr>
          <p:cNvSpPr/>
          <p:nvPr/>
        </p:nvSpPr>
        <p:spPr>
          <a:xfrm>
            <a:off x="5938672" y="6491972"/>
            <a:ext cx="2310999" cy="3609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Overall survival (days)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8EE5EFA4-2E68-9EBB-A55B-0ECF26FF3D1B}"/>
              </a:ext>
            </a:extLst>
          </p:cNvPr>
          <p:cNvSpPr/>
          <p:nvPr/>
        </p:nvSpPr>
        <p:spPr>
          <a:xfrm>
            <a:off x="5823723" y="4107970"/>
            <a:ext cx="2104239" cy="2531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CSF-1 high in TC (n=6)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6215D990-4FE5-407A-71D2-99AB29486582}"/>
              </a:ext>
            </a:extLst>
          </p:cNvPr>
          <p:cNvSpPr/>
          <p:nvPr/>
        </p:nvSpPr>
        <p:spPr>
          <a:xfrm>
            <a:off x="5015072" y="5018321"/>
            <a:ext cx="2033204" cy="2531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CSF-1 low in TC (n=29)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658D2D9A-63D4-B822-7C6F-A20E36D47FD6}"/>
              </a:ext>
            </a:extLst>
          </p:cNvPr>
          <p:cNvSpPr/>
          <p:nvPr/>
        </p:nvSpPr>
        <p:spPr>
          <a:xfrm>
            <a:off x="3899274" y="3398111"/>
            <a:ext cx="194677" cy="3775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r>
              <a:rPr lang="en-US" altLang="ja-JP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b</a:t>
            </a:r>
            <a:endParaRPr lang="ja-JP" altLang="en-US" dirty="0">
              <a:solidFill>
                <a:prstClr val="black"/>
              </a:solidFill>
              <a:latin typeface="Calibri" panose="020F0502020204030204"/>
              <a:ea typeface="游ゴシック" panose="020B0400000000000000" pitchFamily="50" charset="-128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3E2AC77E-63BC-4253-A074-F19C4F58708C}"/>
              </a:ext>
            </a:extLst>
          </p:cNvPr>
          <p:cNvSpPr/>
          <p:nvPr/>
        </p:nvSpPr>
        <p:spPr>
          <a:xfrm>
            <a:off x="7562378" y="3686770"/>
            <a:ext cx="1374585" cy="3234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000" i="1" dirty="0">
                <a:solidFill>
                  <a:schemeClr val="tx1"/>
                </a:solidFill>
              </a:rPr>
              <a:t>p</a:t>
            </a:r>
            <a:r>
              <a:rPr lang="en-US" altLang="ja-JP" sz="2000" dirty="0">
                <a:solidFill>
                  <a:schemeClr val="tx1"/>
                </a:solidFill>
              </a:rPr>
              <a:t>=0.827</a:t>
            </a:r>
            <a:endParaRPr lang="ja-JP" altLang="en-US" sz="2000" baseline="30000" dirty="0">
              <a:solidFill>
                <a:schemeClr val="tx1"/>
              </a:solidFill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62FF3F85-6450-EC63-7717-4B565FBDA0DF}"/>
              </a:ext>
            </a:extLst>
          </p:cNvPr>
          <p:cNvSpPr/>
          <p:nvPr/>
        </p:nvSpPr>
        <p:spPr>
          <a:xfrm rot="16200000">
            <a:off x="3553669" y="4683473"/>
            <a:ext cx="1488826" cy="40615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Survival rate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203063E-32AC-C1CA-52CD-B7B86DCD0F64}"/>
              </a:ext>
            </a:extLst>
          </p:cNvPr>
          <p:cNvSpPr/>
          <p:nvPr/>
        </p:nvSpPr>
        <p:spPr>
          <a:xfrm>
            <a:off x="1639165" y="-19500"/>
            <a:ext cx="1920240" cy="4724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Supplementary Fig. 2</a:t>
            </a:r>
            <a:endParaRPr lang="ja-JP" altLang="en-US" sz="16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368819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4407F1E2-D438-DE61-3686-154A0B2DC115}"/>
              </a:ext>
            </a:extLst>
          </p:cNvPr>
          <p:cNvSpPr/>
          <p:nvPr/>
        </p:nvSpPr>
        <p:spPr>
          <a:xfrm>
            <a:off x="3858634" y="1"/>
            <a:ext cx="196693" cy="3721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r>
              <a:rPr lang="en-US" altLang="ja-JP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</a:t>
            </a:r>
            <a:endParaRPr lang="ja-JP" altLang="en-US" dirty="0">
              <a:solidFill>
                <a:prstClr val="black"/>
              </a:solidFill>
              <a:latin typeface="Calibri" panose="020F0502020204030204"/>
              <a:ea typeface="游ゴシック" panose="020B0400000000000000" pitchFamily="50" charset="-128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461E3E1E-BDA3-7AAE-2D37-5194017B2505}"/>
              </a:ext>
            </a:extLst>
          </p:cNvPr>
          <p:cNvSpPr/>
          <p:nvPr/>
        </p:nvSpPr>
        <p:spPr>
          <a:xfrm rot="16200000">
            <a:off x="2760103" y="1356481"/>
            <a:ext cx="3017521" cy="40615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Numbers of M2 macrophage in EC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658D2D9A-63D4-B822-7C6F-A20E36D47FD6}"/>
              </a:ext>
            </a:extLst>
          </p:cNvPr>
          <p:cNvSpPr/>
          <p:nvPr/>
        </p:nvSpPr>
        <p:spPr>
          <a:xfrm>
            <a:off x="3858634" y="3398111"/>
            <a:ext cx="194677" cy="3775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r>
              <a:rPr lang="en-US" altLang="ja-JP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b</a:t>
            </a:r>
            <a:endParaRPr lang="ja-JP" altLang="en-US" dirty="0">
              <a:solidFill>
                <a:prstClr val="black"/>
              </a:solidFill>
              <a:latin typeface="Calibri" panose="020F0502020204030204"/>
              <a:ea typeface="游ゴシック" panose="020B0400000000000000" pitchFamily="50" charset="-128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FF5F6A21-B450-CFB4-E9E1-F5980A6A5D4F}"/>
              </a:ext>
            </a:extLst>
          </p:cNvPr>
          <p:cNvSpPr/>
          <p:nvPr/>
        </p:nvSpPr>
        <p:spPr>
          <a:xfrm rot="16200000">
            <a:off x="2760104" y="4784510"/>
            <a:ext cx="3017521" cy="40615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Numbers of M2 macrophage in TC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C531D652-50CB-1339-1B90-F2B07AE495B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185" t="3889" r="27946" b="66621"/>
          <a:stretch/>
        </p:blipFill>
        <p:spPr>
          <a:xfrm>
            <a:off x="4506783" y="50799"/>
            <a:ext cx="4236914" cy="3185949"/>
          </a:xfrm>
          <a:prstGeom prst="rect">
            <a:avLst/>
          </a:prstGeom>
        </p:spPr>
      </p:pic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D97E9A28-B482-AEB2-92B7-D6774239B034}"/>
              </a:ext>
            </a:extLst>
          </p:cNvPr>
          <p:cNvSpPr/>
          <p:nvPr/>
        </p:nvSpPr>
        <p:spPr>
          <a:xfrm>
            <a:off x="5666384" y="3141472"/>
            <a:ext cx="2310999" cy="3609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CSF-1 score in EC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5C84B219-43FC-DDC7-B154-72B8EF0D7C3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544" t="4028" r="20713" b="66907"/>
          <a:stretch/>
        </p:blipFill>
        <p:spPr>
          <a:xfrm>
            <a:off x="4531041" y="3537710"/>
            <a:ext cx="4200464" cy="3137089"/>
          </a:xfrm>
          <a:prstGeom prst="rect">
            <a:avLst/>
          </a:prstGeom>
        </p:spPr>
      </p:pic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98045E09-6699-2804-DA2B-7A24431AA917}"/>
              </a:ext>
            </a:extLst>
          </p:cNvPr>
          <p:cNvSpPr/>
          <p:nvPr/>
        </p:nvSpPr>
        <p:spPr>
          <a:xfrm>
            <a:off x="4955184" y="6555284"/>
            <a:ext cx="2310999" cy="3609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CSF-1 score in TC</a:t>
            </a:r>
            <a:endParaRPr lang="ja-JP" altLang="en-US" sz="1600" baseline="30000" dirty="0">
              <a:solidFill>
                <a:schemeClr val="tx1"/>
              </a:solidFill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430A4E4D-2A47-D028-6DCB-9CDD24A6C69B}"/>
              </a:ext>
            </a:extLst>
          </p:cNvPr>
          <p:cNvSpPr/>
          <p:nvPr/>
        </p:nvSpPr>
        <p:spPr>
          <a:xfrm>
            <a:off x="7084846" y="274320"/>
            <a:ext cx="1408915" cy="4978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i="1" dirty="0">
                <a:solidFill>
                  <a:schemeClr val="tx1"/>
                </a:solidFill>
              </a:rPr>
              <a:t>p</a:t>
            </a:r>
            <a:r>
              <a:rPr lang="ja-JP" altLang="en-US" i="1" dirty="0">
                <a:solidFill>
                  <a:schemeClr val="tx1"/>
                </a:solidFill>
              </a:rPr>
              <a:t> </a:t>
            </a:r>
            <a:r>
              <a:rPr lang="en-US" altLang="ja-JP" dirty="0">
                <a:solidFill>
                  <a:schemeClr val="tx1"/>
                </a:solidFill>
              </a:rPr>
              <a:t>= 0.156</a:t>
            </a:r>
            <a:endParaRPr lang="ja-JP" altLang="en-US" dirty="0">
              <a:solidFill>
                <a:schemeClr val="tx1"/>
              </a:solidFill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9319F6C4-5B69-4578-5469-6731EE2B64DC}"/>
              </a:ext>
            </a:extLst>
          </p:cNvPr>
          <p:cNvSpPr/>
          <p:nvPr/>
        </p:nvSpPr>
        <p:spPr>
          <a:xfrm>
            <a:off x="7129846" y="643957"/>
            <a:ext cx="1408915" cy="4978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</a:rPr>
              <a:t>r = -0.384</a:t>
            </a:r>
            <a:endParaRPr lang="ja-JP" altLang="en-US" dirty="0">
              <a:solidFill>
                <a:schemeClr val="tx1"/>
              </a:solidFill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2C274409-BD68-9EF1-0490-375C58C601D2}"/>
              </a:ext>
            </a:extLst>
          </p:cNvPr>
          <p:cNvSpPr/>
          <p:nvPr/>
        </p:nvSpPr>
        <p:spPr>
          <a:xfrm>
            <a:off x="7039846" y="3775705"/>
            <a:ext cx="1408915" cy="4978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i="1" dirty="0">
                <a:solidFill>
                  <a:schemeClr val="tx1"/>
                </a:solidFill>
              </a:rPr>
              <a:t>p </a:t>
            </a:r>
            <a:r>
              <a:rPr lang="en-US" altLang="ja-JP" dirty="0">
                <a:solidFill>
                  <a:schemeClr val="tx1"/>
                </a:solidFill>
              </a:rPr>
              <a:t>= 0.294</a:t>
            </a:r>
            <a:endParaRPr lang="ja-JP" altLang="en-US" dirty="0">
              <a:solidFill>
                <a:schemeClr val="tx1"/>
              </a:solidFill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6BB842DC-006C-28A0-97BA-73EFAC2A6DFA}"/>
              </a:ext>
            </a:extLst>
          </p:cNvPr>
          <p:cNvSpPr/>
          <p:nvPr/>
        </p:nvSpPr>
        <p:spPr>
          <a:xfrm>
            <a:off x="7084846" y="4145342"/>
            <a:ext cx="1408915" cy="4978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</a:rPr>
              <a:t>r = 0.201</a:t>
            </a:r>
            <a:endParaRPr lang="ja-JP" altLang="en-US" dirty="0">
              <a:solidFill>
                <a:schemeClr val="tx1"/>
              </a:solidFill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D3ABB375-9D96-19FF-D582-8A27CC27F326}"/>
              </a:ext>
            </a:extLst>
          </p:cNvPr>
          <p:cNvSpPr/>
          <p:nvPr/>
        </p:nvSpPr>
        <p:spPr>
          <a:xfrm>
            <a:off x="1639165" y="-19500"/>
            <a:ext cx="1920240" cy="4724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Supplementary Fig. 3</a:t>
            </a:r>
            <a:endParaRPr lang="ja-JP" altLang="en-US" sz="16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35615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グラフィックス 6">
            <a:extLst>
              <a:ext uri="{FF2B5EF4-FFF2-40B4-BE49-F238E27FC236}">
                <a16:creationId xmlns:a16="http://schemas.microsoft.com/office/drawing/2014/main" id="{EB4B961B-EC1C-F0C1-F8C8-F617718B974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821346" y="402040"/>
            <a:ext cx="8549308" cy="6455960"/>
          </a:xfrm>
          <a:prstGeom prst="rect">
            <a:avLst/>
          </a:prstGeom>
        </p:spPr>
      </p:pic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381393C5-459E-11E8-34C0-CD8318914C11}"/>
              </a:ext>
            </a:extLst>
          </p:cNvPr>
          <p:cNvSpPr/>
          <p:nvPr/>
        </p:nvSpPr>
        <p:spPr>
          <a:xfrm>
            <a:off x="1639165" y="-19500"/>
            <a:ext cx="1920240" cy="4724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Supplementary Fig. 4</a:t>
            </a:r>
            <a:endParaRPr lang="ja-JP" altLang="en-US" sz="16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945514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DD66483B-8578-6F93-8348-A9905BB11989}"/>
              </a:ext>
            </a:extLst>
          </p:cNvPr>
          <p:cNvSpPr/>
          <p:nvPr/>
        </p:nvSpPr>
        <p:spPr>
          <a:xfrm>
            <a:off x="1639165" y="-19500"/>
            <a:ext cx="1920240" cy="4724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Supplementary Fig. 5</a:t>
            </a:r>
            <a:endParaRPr lang="ja-JP" altLang="en-US" sz="1600" dirty="0">
              <a:solidFill>
                <a:schemeClr val="tx1"/>
              </a:solidFill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84C77023-1714-1D20-A8B7-8539533DF8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9165" y="452941"/>
            <a:ext cx="4037196" cy="3113219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1C103DF1-5CDD-4CA5-91C0-8BCEB032C90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2410" y="3703329"/>
            <a:ext cx="3522440" cy="3008437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C892FADD-D2F5-31B0-F149-9870161088B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6313" y="3703329"/>
            <a:ext cx="3796097" cy="3028757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A44F0F74-EA5F-D1B2-0669-FADC7265BA6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6313" y="452941"/>
            <a:ext cx="3581172" cy="30287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5950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937</TotalTime>
  <Words>187</Words>
  <Application>Microsoft Office PowerPoint</Application>
  <PresentationFormat>ワイド画面</PresentationFormat>
  <Paragraphs>47</Paragraphs>
  <Slides>5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義章 谷口</dc:creator>
  <cp:lastModifiedBy>義章 谷口</cp:lastModifiedBy>
  <cp:revision>1</cp:revision>
  <dcterms:created xsi:type="dcterms:W3CDTF">2024-04-22T01:16:04Z</dcterms:created>
  <dcterms:modified xsi:type="dcterms:W3CDTF">2024-10-09T13:01:47Z</dcterms:modified>
</cp:coreProperties>
</file>